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344" r:id="rId2"/>
    <p:sldId id="322" r:id="rId3"/>
    <p:sldId id="339" r:id="rId4"/>
    <p:sldId id="345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9384D12-CE36-448D-8392-1F96F3ABE408}" v="7" dt="2026-06-05T20:13:00.17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902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legg, James M" userId="18e55344-524b-4303-abb1-24d5e613fcaf" providerId="ADAL" clId="{DEF9CF50-13DB-4E02-B92B-C57937C0EB38}"/>
    <pc:docChg chg="undo custSel modSld">
      <pc:chgData name="Clegg, James M" userId="18e55344-524b-4303-abb1-24d5e613fcaf" providerId="ADAL" clId="{DEF9CF50-13DB-4E02-B92B-C57937C0EB38}" dt="2026-06-05T20:14:29.008" v="347" actId="1038"/>
      <pc:docMkLst>
        <pc:docMk/>
      </pc:docMkLst>
      <pc:sldChg chg="addSp delSp modSp mod">
        <pc:chgData name="Clegg, James M" userId="18e55344-524b-4303-abb1-24d5e613fcaf" providerId="ADAL" clId="{DEF9CF50-13DB-4E02-B92B-C57937C0EB38}" dt="2026-06-05T20:14:29.008" v="347" actId="1038"/>
        <pc:sldMkLst>
          <pc:docMk/>
          <pc:sldMk cId="2704481120" sldId="344"/>
        </pc:sldMkLst>
        <pc:spChg chg="mod">
          <ac:chgData name="Clegg, James M" userId="18e55344-524b-4303-abb1-24d5e613fcaf" providerId="ADAL" clId="{DEF9CF50-13DB-4E02-B92B-C57937C0EB38}" dt="2026-06-05T19:56:56.419" v="71" actId="1036"/>
          <ac:spMkLst>
            <pc:docMk/>
            <pc:sldMk cId="2704481120" sldId="344"/>
            <ac:spMk id="4" creationId="{498F8D9B-A6DF-7521-47D5-BE9E52E7B453}"/>
          </ac:spMkLst>
        </pc:spChg>
        <pc:spChg chg="mod">
          <ac:chgData name="Clegg, James M" userId="18e55344-524b-4303-abb1-24d5e613fcaf" providerId="ADAL" clId="{DEF9CF50-13DB-4E02-B92B-C57937C0EB38}" dt="2026-06-05T19:56:45.528" v="50" actId="1036"/>
          <ac:spMkLst>
            <pc:docMk/>
            <pc:sldMk cId="2704481120" sldId="344"/>
            <ac:spMk id="13" creationId="{2E70027A-53A7-CED2-C38B-069AD6D41618}"/>
          </ac:spMkLst>
        </pc:spChg>
        <pc:spChg chg="mod">
          <ac:chgData name="Clegg, James M" userId="18e55344-524b-4303-abb1-24d5e613fcaf" providerId="ADAL" clId="{DEF9CF50-13DB-4E02-B92B-C57937C0EB38}" dt="2026-06-05T19:56:32.847" v="39" actId="1036"/>
          <ac:spMkLst>
            <pc:docMk/>
            <pc:sldMk cId="2704481120" sldId="344"/>
            <ac:spMk id="15" creationId="{13520C40-2BC8-0D9A-4C1A-4BFB0A4922D7}"/>
          </ac:spMkLst>
        </pc:spChg>
        <pc:spChg chg="add mod">
          <ac:chgData name="Clegg, James M" userId="18e55344-524b-4303-abb1-24d5e613fcaf" providerId="ADAL" clId="{DEF9CF50-13DB-4E02-B92B-C57937C0EB38}" dt="2026-06-05T19:57:24.640" v="99" actId="20577"/>
          <ac:spMkLst>
            <pc:docMk/>
            <pc:sldMk cId="2704481120" sldId="344"/>
            <ac:spMk id="19" creationId="{C0D1A428-F4DE-220D-5485-0D13F71F21EF}"/>
          </ac:spMkLst>
        </pc:spChg>
        <pc:spChg chg="add mod">
          <ac:chgData name="Clegg, James M" userId="18e55344-524b-4303-abb1-24d5e613fcaf" providerId="ADAL" clId="{DEF9CF50-13DB-4E02-B92B-C57937C0EB38}" dt="2026-06-05T20:07:32.636" v="277" actId="1038"/>
          <ac:spMkLst>
            <pc:docMk/>
            <pc:sldMk cId="2704481120" sldId="344"/>
            <ac:spMk id="21" creationId="{FC8D5BDC-6C03-B0DD-0D58-966E7F611723}"/>
          </ac:spMkLst>
        </pc:spChg>
        <pc:spChg chg="add mod">
          <ac:chgData name="Clegg, James M" userId="18e55344-524b-4303-abb1-24d5e613fcaf" providerId="ADAL" clId="{DEF9CF50-13DB-4E02-B92B-C57937C0EB38}" dt="2026-06-05T20:07:32.636" v="277" actId="1038"/>
          <ac:spMkLst>
            <pc:docMk/>
            <pc:sldMk cId="2704481120" sldId="344"/>
            <ac:spMk id="22" creationId="{5256747E-7AAB-ADB6-C8EF-08E9F20FC71C}"/>
          </ac:spMkLst>
        </pc:spChg>
        <pc:spChg chg="add mod">
          <ac:chgData name="Clegg, James M" userId="18e55344-524b-4303-abb1-24d5e613fcaf" providerId="ADAL" clId="{DEF9CF50-13DB-4E02-B92B-C57937C0EB38}" dt="2026-06-05T20:07:32.636" v="277" actId="1038"/>
          <ac:spMkLst>
            <pc:docMk/>
            <pc:sldMk cId="2704481120" sldId="344"/>
            <ac:spMk id="23" creationId="{EE2C0887-9903-12C4-8D21-07F6D7F197FC}"/>
          </ac:spMkLst>
        </pc:spChg>
        <pc:spChg chg="add mod">
          <ac:chgData name="Clegg, James M" userId="18e55344-524b-4303-abb1-24d5e613fcaf" providerId="ADAL" clId="{DEF9CF50-13DB-4E02-B92B-C57937C0EB38}" dt="2026-06-05T20:08:02.224" v="285" actId="1038"/>
          <ac:spMkLst>
            <pc:docMk/>
            <pc:sldMk cId="2704481120" sldId="344"/>
            <ac:spMk id="24" creationId="{2B6829F3-F240-EC27-C814-46F834746E59}"/>
          </ac:spMkLst>
        </pc:spChg>
        <pc:spChg chg="add mod">
          <ac:chgData name="Clegg, James M" userId="18e55344-524b-4303-abb1-24d5e613fcaf" providerId="ADAL" clId="{DEF9CF50-13DB-4E02-B92B-C57937C0EB38}" dt="2026-06-05T20:07:50.889" v="284" actId="1038"/>
          <ac:spMkLst>
            <pc:docMk/>
            <pc:sldMk cId="2704481120" sldId="344"/>
            <ac:spMk id="25" creationId="{2FCAC6C3-681A-AEA8-8B66-BE7D8F8203D6}"/>
          </ac:spMkLst>
        </pc:spChg>
        <pc:spChg chg="add mod">
          <ac:chgData name="Clegg, James M" userId="18e55344-524b-4303-abb1-24d5e613fcaf" providerId="ADAL" clId="{DEF9CF50-13DB-4E02-B92B-C57937C0EB38}" dt="2026-06-05T20:07:32.636" v="277" actId="1038"/>
          <ac:spMkLst>
            <pc:docMk/>
            <pc:sldMk cId="2704481120" sldId="344"/>
            <ac:spMk id="26" creationId="{713815D5-5F5C-0DD9-7FC6-D0DB27F27650}"/>
          </ac:spMkLst>
        </pc:spChg>
        <pc:spChg chg="mod">
          <ac:chgData name="Clegg, James M" userId="18e55344-524b-4303-abb1-24d5e613fcaf" providerId="ADAL" clId="{DEF9CF50-13DB-4E02-B92B-C57937C0EB38}" dt="2026-06-05T19:56:15.541" v="31" actId="1036"/>
          <ac:spMkLst>
            <pc:docMk/>
            <pc:sldMk cId="2704481120" sldId="344"/>
            <ac:spMk id="27" creationId="{E0A11191-5AB3-7C3A-BD8E-D78505203429}"/>
          </ac:spMkLst>
        </pc:spChg>
        <pc:spChg chg="del">
          <ac:chgData name="Clegg, James M" userId="18e55344-524b-4303-abb1-24d5e613fcaf" providerId="ADAL" clId="{DEF9CF50-13DB-4E02-B92B-C57937C0EB38}" dt="2026-06-05T20:06:55.565" v="178" actId="478"/>
          <ac:spMkLst>
            <pc:docMk/>
            <pc:sldMk cId="2704481120" sldId="344"/>
            <ac:spMk id="29" creationId="{0DF8D95F-31C3-680B-D04F-B63E1A514050}"/>
          </ac:spMkLst>
        </pc:spChg>
        <pc:spChg chg="del">
          <ac:chgData name="Clegg, James M" userId="18e55344-524b-4303-abb1-24d5e613fcaf" providerId="ADAL" clId="{DEF9CF50-13DB-4E02-B92B-C57937C0EB38}" dt="2026-06-05T20:06:55.565" v="178" actId="478"/>
          <ac:spMkLst>
            <pc:docMk/>
            <pc:sldMk cId="2704481120" sldId="344"/>
            <ac:spMk id="30" creationId="{F5FB7537-962F-EF82-D946-F026AAC1CE91}"/>
          </ac:spMkLst>
        </pc:spChg>
        <pc:spChg chg="del">
          <ac:chgData name="Clegg, James M" userId="18e55344-524b-4303-abb1-24d5e613fcaf" providerId="ADAL" clId="{DEF9CF50-13DB-4E02-B92B-C57937C0EB38}" dt="2026-06-05T20:06:55.565" v="178" actId="478"/>
          <ac:spMkLst>
            <pc:docMk/>
            <pc:sldMk cId="2704481120" sldId="344"/>
            <ac:spMk id="31" creationId="{5173EF7C-5DBD-4B26-E610-5E67623C795C}"/>
          </ac:spMkLst>
        </pc:spChg>
        <pc:spChg chg="del">
          <ac:chgData name="Clegg, James M" userId="18e55344-524b-4303-abb1-24d5e613fcaf" providerId="ADAL" clId="{DEF9CF50-13DB-4E02-B92B-C57937C0EB38}" dt="2026-06-05T20:06:55.565" v="178" actId="478"/>
          <ac:spMkLst>
            <pc:docMk/>
            <pc:sldMk cId="2704481120" sldId="344"/>
            <ac:spMk id="32" creationId="{9ABCB3E1-4F1C-F3B4-442C-2E9756AAA8C5}"/>
          </ac:spMkLst>
        </pc:spChg>
        <pc:spChg chg="del">
          <ac:chgData name="Clegg, James M" userId="18e55344-524b-4303-abb1-24d5e613fcaf" providerId="ADAL" clId="{DEF9CF50-13DB-4E02-B92B-C57937C0EB38}" dt="2026-06-05T20:06:55.565" v="178" actId="478"/>
          <ac:spMkLst>
            <pc:docMk/>
            <pc:sldMk cId="2704481120" sldId="344"/>
            <ac:spMk id="33" creationId="{E33426E7-520D-285D-A21D-6192F0A3655E}"/>
          </ac:spMkLst>
        </pc:spChg>
        <pc:spChg chg="del">
          <ac:chgData name="Clegg, James M" userId="18e55344-524b-4303-abb1-24d5e613fcaf" providerId="ADAL" clId="{DEF9CF50-13DB-4E02-B92B-C57937C0EB38}" dt="2026-06-05T20:06:55.565" v="178" actId="478"/>
          <ac:spMkLst>
            <pc:docMk/>
            <pc:sldMk cId="2704481120" sldId="344"/>
            <ac:spMk id="34" creationId="{99541CC8-ABB6-551F-76CA-DBBB6B79A5FD}"/>
          </ac:spMkLst>
        </pc:spChg>
        <pc:spChg chg="mod">
          <ac:chgData name="Clegg, James M" userId="18e55344-524b-4303-abb1-24d5e613fcaf" providerId="ADAL" clId="{DEF9CF50-13DB-4E02-B92B-C57937C0EB38}" dt="2026-06-05T20:08:16.474" v="287" actId="1038"/>
          <ac:spMkLst>
            <pc:docMk/>
            <pc:sldMk cId="2704481120" sldId="344"/>
            <ac:spMk id="35" creationId="{FE4858F9-3BE9-4CEB-A9CC-985C01352C58}"/>
          </ac:spMkLst>
        </pc:spChg>
        <pc:spChg chg="mod">
          <ac:chgData name="Clegg, James M" userId="18e55344-524b-4303-abb1-24d5e613fcaf" providerId="ADAL" clId="{DEF9CF50-13DB-4E02-B92B-C57937C0EB38}" dt="2026-06-05T20:13:55.546" v="343" actId="1038"/>
          <ac:spMkLst>
            <pc:docMk/>
            <pc:sldMk cId="2704481120" sldId="344"/>
            <ac:spMk id="38" creationId="{024298EF-7B39-30A0-6841-495813549C23}"/>
          </ac:spMkLst>
        </pc:spChg>
        <pc:spChg chg="del">
          <ac:chgData name="Clegg, James M" userId="18e55344-524b-4303-abb1-24d5e613fcaf" providerId="ADAL" clId="{DEF9CF50-13DB-4E02-B92B-C57937C0EB38}" dt="2026-06-05T20:08:56.671" v="290" actId="478"/>
          <ac:spMkLst>
            <pc:docMk/>
            <pc:sldMk cId="2704481120" sldId="344"/>
            <ac:spMk id="39" creationId="{31964C33-745D-68DE-2D14-6235A134D32C}"/>
          </ac:spMkLst>
        </pc:spChg>
        <pc:spChg chg="del">
          <ac:chgData name="Clegg, James M" userId="18e55344-524b-4303-abb1-24d5e613fcaf" providerId="ADAL" clId="{DEF9CF50-13DB-4E02-B92B-C57937C0EB38}" dt="2026-06-05T20:08:56.671" v="290" actId="478"/>
          <ac:spMkLst>
            <pc:docMk/>
            <pc:sldMk cId="2704481120" sldId="344"/>
            <ac:spMk id="40" creationId="{33789B6B-31CC-76DB-CF57-9BDEB70D7517}"/>
          </ac:spMkLst>
        </pc:spChg>
        <pc:spChg chg="del">
          <ac:chgData name="Clegg, James M" userId="18e55344-524b-4303-abb1-24d5e613fcaf" providerId="ADAL" clId="{DEF9CF50-13DB-4E02-B92B-C57937C0EB38}" dt="2026-06-05T20:08:56.671" v="290" actId="478"/>
          <ac:spMkLst>
            <pc:docMk/>
            <pc:sldMk cId="2704481120" sldId="344"/>
            <ac:spMk id="41" creationId="{352C0893-4A54-AADA-BF15-C71E5F52C251}"/>
          </ac:spMkLst>
        </pc:spChg>
        <pc:spChg chg="del">
          <ac:chgData name="Clegg, James M" userId="18e55344-524b-4303-abb1-24d5e613fcaf" providerId="ADAL" clId="{DEF9CF50-13DB-4E02-B92B-C57937C0EB38}" dt="2026-06-05T20:08:59.308" v="291" actId="478"/>
          <ac:spMkLst>
            <pc:docMk/>
            <pc:sldMk cId="2704481120" sldId="344"/>
            <ac:spMk id="42" creationId="{1E540FA8-FC51-A310-2488-C28D77EA1E05}"/>
          </ac:spMkLst>
        </pc:spChg>
        <pc:spChg chg="del">
          <ac:chgData name="Clegg, James M" userId="18e55344-524b-4303-abb1-24d5e613fcaf" providerId="ADAL" clId="{DEF9CF50-13DB-4E02-B92B-C57937C0EB38}" dt="2026-06-05T20:09:01.586" v="292" actId="478"/>
          <ac:spMkLst>
            <pc:docMk/>
            <pc:sldMk cId="2704481120" sldId="344"/>
            <ac:spMk id="44" creationId="{815B9630-829A-3212-D3DE-F7EAF67DBF37}"/>
          </ac:spMkLst>
        </pc:spChg>
        <pc:spChg chg="mod">
          <ac:chgData name="Clegg, James M" userId="18e55344-524b-4303-abb1-24d5e613fcaf" providerId="ADAL" clId="{DEF9CF50-13DB-4E02-B92B-C57937C0EB38}" dt="2026-06-05T20:14:29.008" v="347" actId="1038"/>
          <ac:spMkLst>
            <pc:docMk/>
            <pc:sldMk cId="2704481120" sldId="344"/>
            <ac:spMk id="45" creationId="{E27A73B5-E456-3C77-0162-72D7C8F848F7}"/>
          </ac:spMkLst>
        </pc:spChg>
        <pc:spChg chg="mod">
          <ac:chgData name="Clegg, James M" userId="18e55344-524b-4303-abb1-24d5e613fcaf" providerId="ADAL" clId="{DEF9CF50-13DB-4E02-B92B-C57937C0EB38}" dt="2026-06-05T19:58:05.366" v="103" actId="1038"/>
          <ac:spMkLst>
            <pc:docMk/>
            <pc:sldMk cId="2704481120" sldId="344"/>
            <ac:spMk id="56" creationId="{6EE8A74C-7715-245F-0B8B-018109175310}"/>
          </ac:spMkLst>
        </pc:spChg>
        <pc:spChg chg="mod">
          <ac:chgData name="Clegg, James M" userId="18e55344-524b-4303-abb1-24d5e613fcaf" providerId="ADAL" clId="{DEF9CF50-13DB-4E02-B92B-C57937C0EB38}" dt="2026-06-05T20:08:16.474" v="287" actId="1038"/>
          <ac:spMkLst>
            <pc:docMk/>
            <pc:sldMk cId="2704481120" sldId="344"/>
            <ac:spMk id="57" creationId="{23533637-3C34-5409-3896-0804D9934CBD}"/>
          </ac:spMkLst>
        </pc:spChg>
        <pc:spChg chg="add mod">
          <ac:chgData name="Clegg, James M" userId="18e55344-524b-4303-abb1-24d5e613fcaf" providerId="ADAL" clId="{DEF9CF50-13DB-4E02-B92B-C57937C0EB38}" dt="2026-06-05T20:13:47.459" v="341" actId="1036"/>
          <ac:spMkLst>
            <pc:docMk/>
            <pc:sldMk cId="2704481120" sldId="344"/>
            <ac:spMk id="59" creationId="{C34224BD-3A25-B864-9202-131B1B7372EE}"/>
          </ac:spMkLst>
        </pc:spChg>
        <pc:spChg chg="add mod">
          <ac:chgData name="Clegg, James M" userId="18e55344-524b-4303-abb1-24d5e613fcaf" providerId="ADAL" clId="{DEF9CF50-13DB-4E02-B92B-C57937C0EB38}" dt="2026-06-05T20:13:42.553" v="340" actId="1036"/>
          <ac:spMkLst>
            <pc:docMk/>
            <pc:sldMk cId="2704481120" sldId="344"/>
            <ac:spMk id="60" creationId="{6CDB380E-11D0-DA84-3B50-1E85512BCDAA}"/>
          </ac:spMkLst>
        </pc:spChg>
        <pc:spChg chg="add mod">
          <ac:chgData name="Clegg, James M" userId="18e55344-524b-4303-abb1-24d5e613fcaf" providerId="ADAL" clId="{DEF9CF50-13DB-4E02-B92B-C57937C0EB38}" dt="2026-06-05T20:13:36.697" v="339" actId="1036"/>
          <ac:spMkLst>
            <pc:docMk/>
            <pc:sldMk cId="2704481120" sldId="344"/>
            <ac:spMk id="61" creationId="{CD0BE505-B5B8-E861-53BA-C12C9B17F593}"/>
          </ac:spMkLst>
        </pc:spChg>
        <pc:spChg chg="add mod">
          <ac:chgData name="Clegg, James M" userId="18e55344-524b-4303-abb1-24d5e613fcaf" providerId="ADAL" clId="{DEF9CF50-13DB-4E02-B92B-C57937C0EB38}" dt="2026-06-05T20:13:32.471" v="338" actId="1035"/>
          <ac:spMkLst>
            <pc:docMk/>
            <pc:sldMk cId="2704481120" sldId="344"/>
            <ac:spMk id="62" creationId="{BC92A7E3-5C18-A38A-8451-054D9A1F4A8C}"/>
          </ac:spMkLst>
        </pc:spChg>
        <pc:spChg chg="add mod">
          <ac:chgData name="Clegg, James M" userId="18e55344-524b-4303-abb1-24d5e613fcaf" providerId="ADAL" clId="{DEF9CF50-13DB-4E02-B92B-C57937C0EB38}" dt="2026-06-05T20:13:28.607" v="334" actId="1035"/>
          <ac:spMkLst>
            <pc:docMk/>
            <pc:sldMk cId="2704481120" sldId="344"/>
            <ac:spMk id="63" creationId="{2659A7DF-22F8-E033-529A-C90871464C58}"/>
          </ac:spMkLst>
        </pc:spChg>
        <pc:spChg chg="mod">
          <ac:chgData name="Clegg, James M" userId="18e55344-524b-4303-abb1-24d5e613fcaf" providerId="ADAL" clId="{DEF9CF50-13DB-4E02-B92B-C57937C0EB38}" dt="2026-06-05T19:58:05.366" v="103" actId="1038"/>
          <ac:spMkLst>
            <pc:docMk/>
            <pc:sldMk cId="2704481120" sldId="344"/>
            <ac:spMk id="166" creationId="{5A4B6807-6ACD-4D60-216D-7166353D3356}"/>
          </ac:spMkLst>
        </pc:spChg>
        <pc:spChg chg="mod">
          <ac:chgData name="Clegg, James M" userId="18e55344-524b-4303-abb1-24d5e613fcaf" providerId="ADAL" clId="{DEF9CF50-13DB-4E02-B92B-C57937C0EB38}" dt="2026-06-05T19:57:14.089" v="96" actId="1035"/>
          <ac:spMkLst>
            <pc:docMk/>
            <pc:sldMk cId="2704481120" sldId="344"/>
            <ac:spMk id="167" creationId="{F0549A9C-9A27-5CF1-57DC-E6BE67384466}"/>
          </ac:spMkLst>
        </pc:spChg>
        <pc:spChg chg="add mod">
          <ac:chgData name="Clegg, James M" userId="18e55344-524b-4303-abb1-24d5e613fcaf" providerId="ADAL" clId="{DEF9CF50-13DB-4E02-B92B-C57937C0EB38}" dt="2026-06-05T20:13:15.496" v="328" actId="1037"/>
          <ac:spMkLst>
            <pc:docMk/>
            <pc:sldMk cId="2704481120" sldId="344"/>
            <ac:spMk id="1025" creationId="{BED42A96-FB50-F48A-DFB0-D7596CA52FC5}"/>
          </ac:spMkLst>
        </pc:spChg>
        <pc:picChg chg="del">
          <ac:chgData name="Clegg, James M" userId="18e55344-524b-4303-abb1-24d5e613fcaf" providerId="ADAL" clId="{DEF9CF50-13DB-4E02-B92B-C57937C0EB38}" dt="2026-06-05T19:58:32.391" v="104" actId="478"/>
          <ac:picMkLst>
            <pc:docMk/>
            <pc:sldMk cId="2704481120" sldId="344"/>
            <ac:picMk id="2" creationId="{EE8F0748-FB64-266A-C24B-329872074217}"/>
          </ac:picMkLst>
        </pc:picChg>
        <pc:picChg chg="add mod ord modCrop">
          <ac:chgData name="Clegg, James M" userId="18e55344-524b-4303-abb1-24d5e613fcaf" providerId="ADAL" clId="{DEF9CF50-13DB-4E02-B92B-C57937C0EB38}" dt="2026-06-05T19:57:51.788" v="101" actId="732"/>
          <ac:picMkLst>
            <pc:docMk/>
            <pc:sldMk cId="2704481120" sldId="344"/>
            <ac:picMk id="18" creationId="{7AE96C4D-C3D2-9FC8-145B-55B88F6972D7}"/>
          </ac:picMkLst>
        </pc:picChg>
        <pc:picChg chg="add mod ord modCrop">
          <ac:chgData name="Clegg, James M" userId="18e55344-524b-4303-abb1-24d5e613fcaf" providerId="ADAL" clId="{DEF9CF50-13DB-4E02-B92B-C57937C0EB38}" dt="2026-06-05T20:08:29.452" v="288" actId="732"/>
          <ac:picMkLst>
            <pc:docMk/>
            <pc:sldMk cId="2704481120" sldId="344"/>
            <ac:picMk id="20" creationId="{BA41587C-7B52-E984-9DAC-FC2949820F43}"/>
          </ac:picMkLst>
        </pc:picChg>
        <pc:picChg chg="add mod ord modCrop">
          <ac:chgData name="Clegg, James M" userId="18e55344-524b-4303-abb1-24d5e613fcaf" providerId="ADAL" clId="{DEF9CF50-13DB-4E02-B92B-C57937C0EB38}" dt="2026-06-05T20:14:22.482" v="345" actId="732"/>
          <ac:picMkLst>
            <pc:docMk/>
            <pc:sldMk cId="2704481120" sldId="344"/>
            <ac:picMk id="28" creationId="{A53ECDAA-FDEB-0406-BDCF-5484F568D1BD}"/>
          </ac:picMkLst>
        </pc:picChg>
        <pc:picChg chg="del">
          <ac:chgData name="Clegg, James M" userId="18e55344-524b-4303-abb1-24d5e613fcaf" providerId="ADAL" clId="{DEF9CF50-13DB-4E02-B92B-C57937C0EB38}" dt="2026-06-05T20:08:44.628" v="289" actId="478"/>
          <ac:picMkLst>
            <pc:docMk/>
            <pc:sldMk cId="2704481120" sldId="344"/>
            <ac:picMk id="36" creationId="{41B6E56E-687D-6FAD-68F1-3D19E41E364A}"/>
          </ac:picMkLst>
        </pc:picChg>
        <pc:picChg chg="del">
          <ac:chgData name="Clegg, James M" userId="18e55344-524b-4303-abb1-24d5e613fcaf" providerId="ADAL" clId="{DEF9CF50-13DB-4E02-B92B-C57937C0EB38}" dt="2026-06-05T19:54:53.059" v="0" actId="478"/>
          <ac:picMkLst>
            <pc:docMk/>
            <pc:sldMk cId="2704481120" sldId="344"/>
            <ac:picMk id="1026" creationId="{1A7E1D7E-C6E8-2479-746D-CCB5DC19D672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A914D0-FE3D-4308-8408-8CE1FBD34BE0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29B955B-6AA0-4CE5-9D29-C96C4EE55F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06422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D27E058-E4CA-9392-61A0-6993FACC4AC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7AF85173-175D-8F30-02C2-E6BA0253A227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02F3C9BA-3E4C-196C-06BE-1496907C1B6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AF6EACC-4AB5-D0E9-66C8-8B3CDB44E11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1B0FDA-5A43-40E3-AEFA-B6E75C3E482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6082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1B0FDA-5A43-40E3-AEFA-B6E75C3E482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171750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8CC6244-ECDE-F0C7-C704-5E703C3D65B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43AFA227-5915-47F7-43B0-A8AD0F0C1AD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254B0482-10C1-E49E-D8B4-FE7C53D098F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4D3C2B7-CDFB-162F-5037-93E8E2DC03D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1B0FDA-5A43-40E3-AEFA-B6E75C3E482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5303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648A92A-21E8-D5E5-837E-4C3764359AD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E6E1C8C4-F8EC-502E-E11E-915A96232BB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5703566E-4049-F6D1-14CF-A8F4BE91A41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329D38A-156A-1997-2F48-A38F40BE9CA8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01B0FDA-5A43-40E3-AEFA-B6E75C3E482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3812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2FB1F4-FAE3-7186-A725-AA208AF15A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91E8B56-A519-882E-D6F5-DD0032A5606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B29258-1204-0550-CB95-3FACD00BBC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2E65-EB32-46FC-8BD9-E5DC5CAE975D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334F3A-2E93-DE82-AFAD-85253A7F61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C8304E-896E-9359-9108-1FE4DE6193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ECFEA-F7C3-4DE3-879C-42ADB311F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396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61B93D-7BBB-7C0B-5537-A3A703357D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9A5D9E-1AA5-7212-9A35-CCE86FFDCA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A27C33-E577-B2DA-042B-2074711FA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2E65-EB32-46FC-8BD9-E5DC5CAE975D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ECF804-8377-93B4-396A-F220D83E47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C7C4DE-6471-6C78-5553-D7175AD44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ECFEA-F7C3-4DE3-879C-42ADB311F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707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E64979-D03D-3A63-1A10-984F209556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E87D47-57D6-F3DA-B1A8-30032C800E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641E39-2A6F-5A33-8435-B72539C70F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2E65-EB32-46FC-8BD9-E5DC5CAE975D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8E6D5A-1B1F-56E9-B552-33437AEAAE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DA277C-CF58-E9D6-4473-DB997BFD81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ECFEA-F7C3-4DE3-879C-42ADB311F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8653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D5047A-4C08-CA13-CA2A-01BE6BC672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3B8A06-8245-16D3-CD9D-BB6D660CAB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CCD218-28B7-54D6-DCD0-F0FE7313FC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2E65-EB32-46FC-8BD9-E5DC5CAE975D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40525C-4156-B711-87AE-DAE35C6A0B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B8A17A-BEB8-5D16-3A42-146982A640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ECFEA-F7C3-4DE3-879C-42ADB311F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518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96C36-DFBF-66F5-A59C-F180E7A9E3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FBAFA6-1BBC-055B-35B6-4BE6382D0F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F2105A-D571-0844-D6CC-8CEF718990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2E65-EB32-46FC-8BD9-E5DC5CAE975D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C073B9-E0FD-DA57-08AA-82F6960A47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F79391-5EEE-B629-9542-39C82DBF5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ECFEA-F7C3-4DE3-879C-42ADB311F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636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FAD9DB-FAB6-A376-EC6C-9A2497A316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36C9B8-E51F-A843-D846-01267CFF57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70A0C5-BA73-EB79-E60E-7DA812ED25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06E790-A6AE-A42D-20E5-18B253D15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2E65-EB32-46FC-8BD9-E5DC5CAE975D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D0A9DB-9F68-FAFD-DCE7-A42AC8C42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651254-6830-0982-A240-77D17D909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ECFEA-F7C3-4DE3-879C-42ADB311F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466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723FBC-9FBC-258D-F4BF-F988534DB4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54C3F3-0C38-D344-F284-F20FA6EFA8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5DD380-F5C2-954C-DBA1-00A31F3191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5CBDEBA-B6F4-6FA5-3875-3996A3661F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11BC503-0F1C-9869-E1DE-76D3F43C445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6292ECF-44CA-059A-6804-DEFD5D7CBC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2E65-EB32-46FC-8BD9-E5DC5CAE975D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92B7D67-4E7D-ACF7-73B8-2A0AA5A658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0C6026C-09E7-77E6-8EDC-A71F06114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ECFEA-F7C3-4DE3-879C-42ADB311F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312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5F512A-F4A8-6EBB-0378-11D103FE20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86C29B8-5E5F-2BCA-DC39-C84CC186DB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2E65-EB32-46FC-8BD9-E5DC5CAE975D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4B21873-2C72-CBF6-DD03-BB97D5D61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271ED12-4793-7560-5922-94236083BE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ECFEA-F7C3-4DE3-879C-42ADB311F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475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8B8E91B-1F03-BF4C-2D36-48A13CD659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2E65-EB32-46FC-8BD9-E5DC5CAE975D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9250AED-9782-8511-1258-804613C79C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7F89589-5A1F-4468-75C0-5493B85A50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ECFEA-F7C3-4DE3-879C-42ADB311F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283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472A40-D52B-5895-AE65-44B654E013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FE96EF-964A-52DA-72F8-EB339FE32D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1110274-891D-51BD-147B-CC733B5DF4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12B092-9CD3-7706-9B52-999935B79E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2E65-EB32-46FC-8BD9-E5DC5CAE975D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EC91C8-13EE-2E3E-0ADA-BB5C52063B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EE3839-906C-2063-6DC0-C709B16D76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ECFEA-F7C3-4DE3-879C-42ADB311F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4334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B54B92-E1EF-7335-E6D7-0A789487EE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1FE1FD0-7F12-CFC3-C325-025938DF55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A513086-62CE-8A70-8289-44C47192EE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7C8490-81AB-BC57-B292-A7B9F5E7EC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92E65-EB32-46FC-8BD9-E5DC5CAE975D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040D71-B0FF-C832-D4A3-FBF7B5DCA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78A58F-A095-C026-0730-6413E843E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FECFEA-F7C3-4DE3-879C-42ADB311F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764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60528DA-BE01-C827-C7DF-22F357A7BC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892C2F-BE2F-C710-6CD7-A3E36A0549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9F41D3-8D07-BCC5-025D-91CE3A48AA3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B92E65-EB32-46FC-8BD9-E5DC5CAE975D}" type="datetimeFigureOut">
              <a:rPr lang="en-US" smtClean="0"/>
              <a:t>6/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3BD7AB-70C8-9570-0B18-61835C98CC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66FADF-B9A6-40A3-E286-DC6CFF92DD8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7FECFEA-F7C3-4DE3-879C-42ADB311F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108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3" Type="http://schemas.openxmlformats.org/officeDocument/2006/relationships/image" Target="../media/image4.emf"/><Relationship Id="rId7" Type="http://schemas.openxmlformats.org/officeDocument/2006/relationships/image" Target="../media/image11.emf"/><Relationship Id="rId12" Type="http://schemas.openxmlformats.org/officeDocument/2006/relationships/image" Target="../media/image16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emf"/><Relationship Id="rId11" Type="http://schemas.openxmlformats.org/officeDocument/2006/relationships/image" Target="../media/image15.emf"/><Relationship Id="rId5" Type="http://schemas.openxmlformats.org/officeDocument/2006/relationships/image" Target="../media/image9.emf"/><Relationship Id="rId10" Type="http://schemas.openxmlformats.org/officeDocument/2006/relationships/image" Target="../media/image14.emf"/><Relationship Id="rId4" Type="http://schemas.openxmlformats.org/officeDocument/2006/relationships/image" Target="../media/image8.emf"/><Relationship Id="rId9" Type="http://schemas.openxmlformats.org/officeDocument/2006/relationships/image" Target="../media/image1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10A7046-EEA5-17DC-8D31-726ECDAFBE2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>
            <a:extLst>
              <a:ext uri="{FF2B5EF4-FFF2-40B4-BE49-F238E27FC236}">
                <a16:creationId xmlns:a16="http://schemas.microsoft.com/office/drawing/2014/main" id="{A53ECDAA-FDEB-0406-BDCF-5484F568D1B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8146" b="21706"/>
          <a:stretch>
            <a:fillRect/>
          </a:stretch>
        </p:blipFill>
        <p:spPr>
          <a:xfrm>
            <a:off x="4181862" y="3631224"/>
            <a:ext cx="5144314" cy="2636389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BA41587C-7B52-E984-9DAC-FC2949820F43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7882" b="21601"/>
          <a:stretch>
            <a:fillRect/>
          </a:stretch>
        </p:blipFill>
        <p:spPr>
          <a:xfrm>
            <a:off x="6523026" y="558801"/>
            <a:ext cx="5134862" cy="2627511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AE96C4D-C3D2-9FC8-145B-55B88F6972D7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8035" b="21555"/>
          <a:stretch>
            <a:fillRect/>
          </a:stretch>
        </p:blipFill>
        <p:spPr>
          <a:xfrm>
            <a:off x="894388" y="575965"/>
            <a:ext cx="5089851" cy="2610347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B7976D93-2CFC-EF59-FF95-B385EF50CD4D}"/>
              </a:ext>
            </a:extLst>
          </p:cNvPr>
          <p:cNvSpPr txBox="1"/>
          <p:nvPr/>
        </p:nvSpPr>
        <p:spPr>
          <a:xfrm>
            <a:off x="-1" y="-28575"/>
            <a:ext cx="2790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-figure 1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F7FD79A6-6A3E-2599-71A3-CE46A385508A}"/>
              </a:ext>
            </a:extLst>
          </p:cNvPr>
          <p:cNvSpPr txBox="1"/>
          <p:nvPr/>
        </p:nvSpPr>
        <p:spPr>
          <a:xfrm>
            <a:off x="884226" y="3364903"/>
            <a:ext cx="497809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Time since infection (years)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5A4B6807-6ACD-4D60-216D-7166353D3356}"/>
              </a:ext>
            </a:extLst>
          </p:cNvPr>
          <p:cNvSpPr txBox="1"/>
          <p:nvPr/>
        </p:nvSpPr>
        <p:spPr>
          <a:xfrm rot="16200000">
            <a:off x="-632690" y="1757425"/>
            <a:ext cx="239529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TLC (z-score)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F0549A9C-9A27-5CF1-57DC-E6BE67384466}"/>
              </a:ext>
            </a:extLst>
          </p:cNvPr>
          <p:cNvSpPr txBox="1"/>
          <p:nvPr/>
        </p:nvSpPr>
        <p:spPr>
          <a:xfrm>
            <a:off x="554432" y="1076682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98F8D9B-A6DF-7521-47D5-BE9E52E7B453}"/>
              </a:ext>
            </a:extLst>
          </p:cNvPr>
          <p:cNvSpPr txBox="1"/>
          <p:nvPr/>
        </p:nvSpPr>
        <p:spPr>
          <a:xfrm>
            <a:off x="554432" y="1517439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E70027A-53A7-CED2-C38B-069AD6D41618}"/>
              </a:ext>
            </a:extLst>
          </p:cNvPr>
          <p:cNvSpPr txBox="1"/>
          <p:nvPr/>
        </p:nvSpPr>
        <p:spPr>
          <a:xfrm>
            <a:off x="554432" y="1974639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3520C40-2BC8-0D9A-4C1A-4BFB0A4922D7}"/>
              </a:ext>
            </a:extLst>
          </p:cNvPr>
          <p:cNvSpPr txBox="1"/>
          <p:nvPr/>
        </p:nvSpPr>
        <p:spPr>
          <a:xfrm>
            <a:off x="538915" y="2434899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0A11191-5AB3-7C3A-BD8E-D78505203429}"/>
              </a:ext>
            </a:extLst>
          </p:cNvPr>
          <p:cNvSpPr txBox="1"/>
          <p:nvPr/>
        </p:nvSpPr>
        <p:spPr>
          <a:xfrm>
            <a:off x="543718" y="2875656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E5BA655-AF35-10F0-C2A7-68160DE99D80}"/>
              </a:ext>
            </a:extLst>
          </p:cNvPr>
          <p:cNvSpPr txBox="1"/>
          <p:nvPr/>
        </p:nvSpPr>
        <p:spPr>
          <a:xfrm>
            <a:off x="2398783" y="3116657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5EEC66E-868B-63E5-3C87-4F291F03B3A8}"/>
              </a:ext>
            </a:extLst>
          </p:cNvPr>
          <p:cNvSpPr txBox="1"/>
          <p:nvPr/>
        </p:nvSpPr>
        <p:spPr>
          <a:xfrm>
            <a:off x="1880623" y="3110374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C742B876-4939-47E7-4BBC-A56E1375520A}"/>
              </a:ext>
            </a:extLst>
          </p:cNvPr>
          <p:cNvSpPr txBox="1"/>
          <p:nvPr/>
        </p:nvSpPr>
        <p:spPr>
          <a:xfrm>
            <a:off x="1353083" y="3112027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024" name="TextBox 1023">
            <a:extLst>
              <a:ext uri="{FF2B5EF4-FFF2-40B4-BE49-F238E27FC236}">
                <a16:creationId xmlns:a16="http://schemas.microsoft.com/office/drawing/2014/main" id="{3E41D123-C726-9AF5-FB55-5BD37AD006D0}"/>
              </a:ext>
            </a:extLst>
          </p:cNvPr>
          <p:cNvSpPr txBox="1"/>
          <p:nvPr/>
        </p:nvSpPr>
        <p:spPr>
          <a:xfrm>
            <a:off x="821789" y="3112027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027" name="TextBox 1026">
            <a:extLst>
              <a:ext uri="{FF2B5EF4-FFF2-40B4-BE49-F238E27FC236}">
                <a16:creationId xmlns:a16="http://schemas.microsoft.com/office/drawing/2014/main" id="{DE89AC18-87A9-4988-AA9A-C984CE792850}"/>
              </a:ext>
            </a:extLst>
          </p:cNvPr>
          <p:cNvSpPr txBox="1"/>
          <p:nvPr/>
        </p:nvSpPr>
        <p:spPr>
          <a:xfrm>
            <a:off x="2916943" y="3106497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028" name="TextBox 1027">
            <a:extLst>
              <a:ext uri="{FF2B5EF4-FFF2-40B4-BE49-F238E27FC236}">
                <a16:creationId xmlns:a16="http://schemas.microsoft.com/office/drawing/2014/main" id="{BD61C5FD-EDC1-262F-ED0A-9E231374A64B}"/>
              </a:ext>
            </a:extLst>
          </p:cNvPr>
          <p:cNvSpPr txBox="1"/>
          <p:nvPr/>
        </p:nvSpPr>
        <p:spPr>
          <a:xfrm>
            <a:off x="3391668" y="3116657"/>
            <a:ext cx="48510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029" name="TextBox 1028">
            <a:extLst>
              <a:ext uri="{FF2B5EF4-FFF2-40B4-BE49-F238E27FC236}">
                <a16:creationId xmlns:a16="http://schemas.microsoft.com/office/drawing/2014/main" id="{2C5E916C-C2E7-796D-4981-B0D021D77A04}"/>
              </a:ext>
            </a:extLst>
          </p:cNvPr>
          <p:cNvSpPr txBox="1"/>
          <p:nvPr/>
        </p:nvSpPr>
        <p:spPr>
          <a:xfrm>
            <a:off x="3960628" y="3116657"/>
            <a:ext cx="48510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030" name="TextBox 1029">
            <a:extLst>
              <a:ext uri="{FF2B5EF4-FFF2-40B4-BE49-F238E27FC236}">
                <a16:creationId xmlns:a16="http://schemas.microsoft.com/office/drawing/2014/main" id="{418D308E-217B-B115-C6F3-1917C77DF9EB}"/>
              </a:ext>
            </a:extLst>
          </p:cNvPr>
          <p:cNvSpPr txBox="1"/>
          <p:nvPr/>
        </p:nvSpPr>
        <p:spPr>
          <a:xfrm>
            <a:off x="4470729" y="3106497"/>
            <a:ext cx="48510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1031" name="TextBox 1030">
            <a:extLst>
              <a:ext uri="{FF2B5EF4-FFF2-40B4-BE49-F238E27FC236}">
                <a16:creationId xmlns:a16="http://schemas.microsoft.com/office/drawing/2014/main" id="{17ECC22A-4CD5-B318-4F84-9F00453C8A94}"/>
              </a:ext>
            </a:extLst>
          </p:cNvPr>
          <p:cNvSpPr txBox="1"/>
          <p:nvPr/>
        </p:nvSpPr>
        <p:spPr>
          <a:xfrm>
            <a:off x="5009209" y="3106497"/>
            <a:ext cx="48510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032" name="TextBox 1031">
            <a:extLst>
              <a:ext uri="{FF2B5EF4-FFF2-40B4-BE49-F238E27FC236}">
                <a16:creationId xmlns:a16="http://schemas.microsoft.com/office/drawing/2014/main" id="{A215E9FA-5143-2E1D-A2B7-E7B64E89CD60}"/>
              </a:ext>
            </a:extLst>
          </p:cNvPr>
          <p:cNvSpPr txBox="1"/>
          <p:nvPr/>
        </p:nvSpPr>
        <p:spPr>
          <a:xfrm>
            <a:off x="5535789" y="3111049"/>
            <a:ext cx="48510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F555302-26A5-F7FF-9B1E-857579AE9386}"/>
              </a:ext>
            </a:extLst>
          </p:cNvPr>
          <p:cNvSpPr txBox="1"/>
          <p:nvPr/>
        </p:nvSpPr>
        <p:spPr>
          <a:xfrm>
            <a:off x="6523026" y="3364903"/>
            <a:ext cx="497809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Time since infection (years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96BF8E2-E5BF-0C73-3BF6-DDDEF4F2F52F}"/>
              </a:ext>
            </a:extLst>
          </p:cNvPr>
          <p:cNvSpPr txBox="1"/>
          <p:nvPr/>
        </p:nvSpPr>
        <p:spPr>
          <a:xfrm>
            <a:off x="8057903" y="3116657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921B7BA-70FB-E426-A15F-232BC3484908}"/>
              </a:ext>
            </a:extLst>
          </p:cNvPr>
          <p:cNvSpPr txBox="1"/>
          <p:nvPr/>
        </p:nvSpPr>
        <p:spPr>
          <a:xfrm>
            <a:off x="7519423" y="3110374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C91DCB3-01FE-D071-CF9B-C3ECE8ABA1E5}"/>
              </a:ext>
            </a:extLst>
          </p:cNvPr>
          <p:cNvSpPr txBox="1"/>
          <p:nvPr/>
        </p:nvSpPr>
        <p:spPr>
          <a:xfrm>
            <a:off x="6991883" y="3112027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BFAF47C-7A14-F79F-04DC-104FB8EEBFE6}"/>
              </a:ext>
            </a:extLst>
          </p:cNvPr>
          <p:cNvSpPr txBox="1"/>
          <p:nvPr/>
        </p:nvSpPr>
        <p:spPr>
          <a:xfrm>
            <a:off x="6460589" y="3112027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67BC865-6C30-B382-5C23-563E91ADDFF3}"/>
              </a:ext>
            </a:extLst>
          </p:cNvPr>
          <p:cNvSpPr txBox="1"/>
          <p:nvPr/>
        </p:nvSpPr>
        <p:spPr>
          <a:xfrm>
            <a:off x="8576063" y="3106497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6DCF24E-2ADB-4E94-8B4A-4DBE199202F8}"/>
              </a:ext>
            </a:extLst>
          </p:cNvPr>
          <p:cNvSpPr txBox="1"/>
          <p:nvPr/>
        </p:nvSpPr>
        <p:spPr>
          <a:xfrm>
            <a:off x="9060948" y="3116657"/>
            <a:ext cx="48510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3716555-AD00-9A5E-A272-34893A1BF41D}"/>
              </a:ext>
            </a:extLst>
          </p:cNvPr>
          <p:cNvSpPr txBox="1"/>
          <p:nvPr/>
        </p:nvSpPr>
        <p:spPr>
          <a:xfrm>
            <a:off x="9599428" y="3116657"/>
            <a:ext cx="48510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8376E90-C49C-0642-FD9A-3E3970ED1832}"/>
              </a:ext>
            </a:extLst>
          </p:cNvPr>
          <p:cNvSpPr txBox="1"/>
          <p:nvPr/>
        </p:nvSpPr>
        <p:spPr>
          <a:xfrm>
            <a:off x="10109529" y="3106497"/>
            <a:ext cx="48510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CB4AD80-00D6-FA87-C280-508E9D0B0B33}"/>
              </a:ext>
            </a:extLst>
          </p:cNvPr>
          <p:cNvSpPr txBox="1"/>
          <p:nvPr/>
        </p:nvSpPr>
        <p:spPr>
          <a:xfrm>
            <a:off x="10648009" y="3106497"/>
            <a:ext cx="48510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B0FABD0-DF7B-1DDD-582C-FF25F04D9DEA}"/>
              </a:ext>
            </a:extLst>
          </p:cNvPr>
          <p:cNvSpPr txBox="1"/>
          <p:nvPr/>
        </p:nvSpPr>
        <p:spPr>
          <a:xfrm>
            <a:off x="11174589" y="3111049"/>
            <a:ext cx="48510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E4858F9-3BE9-4CEB-A9CC-985C01352C58}"/>
              </a:ext>
            </a:extLst>
          </p:cNvPr>
          <p:cNvSpPr txBox="1"/>
          <p:nvPr/>
        </p:nvSpPr>
        <p:spPr>
          <a:xfrm rot="16200000">
            <a:off x="4995079" y="1757426"/>
            <a:ext cx="239529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RV (z-score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3C74F7C-84B9-C93E-6E22-F134A8ECACF9}"/>
              </a:ext>
            </a:extLst>
          </p:cNvPr>
          <p:cNvSpPr txBox="1"/>
          <p:nvPr/>
        </p:nvSpPr>
        <p:spPr>
          <a:xfrm>
            <a:off x="4163429" y="6446205"/>
            <a:ext cx="497809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Time since infection (years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24298EF-7B39-30A0-6841-495813549C23}"/>
              </a:ext>
            </a:extLst>
          </p:cNvPr>
          <p:cNvSpPr txBox="1"/>
          <p:nvPr/>
        </p:nvSpPr>
        <p:spPr>
          <a:xfrm rot="16200000">
            <a:off x="2646513" y="4838727"/>
            <a:ext cx="239529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RV/TLC (z-score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27A73B5-E456-3C77-0162-72D7C8F848F7}"/>
              </a:ext>
            </a:extLst>
          </p:cNvPr>
          <p:cNvSpPr txBox="1"/>
          <p:nvPr/>
        </p:nvSpPr>
        <p:spPr>
          <a:xfrm>
            <a:off x="5718626" y="6197959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2FA985A-8F76-5B1B-BA9A-9C9F5B8EC74C}"/>
              </a:ext>
            </a:extLst>
          </p:cNvPr>
          <p:cNvSpPr txBox="1"/>
          <p:nvPr/>
        </p:nvSpPr>
        <p:spPr>
          <a:xfrm>
            <a:off x="5180146" y="6191676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AC83A58-00FE-BBA3-1736-C06197921B95}"/>
              </a:ext>
            </a:extLst>
          </p:cNvPr>
          <p:cNvSpPr txBox="1"/>
          <p:nvPr/>
        </p:nvSpPr>
        <p:spPr>
          <a:xfrm>
            <a:off x="4632286" y="6193329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6272D25-A89D-318E-B9BA-933325DC1A8F}"/>
              </a:ext>
            </a:extLst>
          </p:cNvPr>
          <p:cNvSpPr txBox="1"/>
          <p:nvPr/>
        </p:nvSpPr>
        <p:spPr>
          <a:xfrm>
            <a:off x="4100992" y="6193329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8BE753B-7B64-2B7A-28BE-244188C81DE8}"/>
              </a:ext>
            </a:extLst>
          </p:cNvPr>
          <p:cNvSpPr txBox="1"/>
          <p:nvPr/>
        </p:nvSpPr>
        <p:spPr>
          <a:xfrm>
            <a:off x="6246946" y="6187799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B6367EA-13B8-7B11-52DC-685FE43C08AB}"/>
              </a:ext>
            </a:extLst>
          </p:cNvPr>
          <p:cNvSpPr txBox="1"/>
          <p:nvPr/>
        </p:nvSpPr>
        <p:spPr>
          <a:xfrm>
            <a:off x="6731831" y="6197959"/>
            <a:ext cx="48510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DEAD5978-E54F-F770-9D96-C08041B9969F}"/>
              </a:ext>
            </a:extLst>
          </p:cNvPr>
          <p:cNvSpPr txBox="1"/>
          <p:nvPr/>
        </p:nvSpPr>
        <p:spPr>
          <a:xfrm>
            <a:off x="7270311" y="6197959"/>
            <a:ext cx="48510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26EC11B-1DDA-46D5-1DE0-F4BCC8EAD047}"/>
              </a:ext>
            </a:extLst>
          </p:cNvPr>
          <p:cNvSpPr txBox="1"/>
          <p:nvPr/>
        </p:nvSpPr>
        <p:spPr>
          <a:xfrm>
            <a:off x="7810892" y="6187799"/>
            <a:ext cx="48510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3E8087F-8AC8-FFFC-694F-5F8893F003E1}"/>
              </a:ext>
            </a:extLst>
          </p:cNvPr>
          <p:cNvSpPr txBox="1"/>
          <p:nvPr/>
        </p:nvSpPr>
        <p:spPr>
          <a:xfrm>
            <a:off x="8349372" y="6187799"/>
            <a:ext cx="48510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29FB67FF-2D5D-B835-FA31-93E68F4D830A}"/>
              </a:ext>
            </a:extLst>
          </p:cNvPr>
          <p:cNvSpPr txBox="1"/>
          <p:nvPr/>
        </p:nvSpPr>
        <p:spPr>
          <a:xfrm>
            <a:off x="8896272" y="6192351"/>
            <a:ext cx="485103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EE8A74C-7715-245F-0B8B-018109175310}"/>
              </a:ext>
            </a:extLst>
          </p:cNvPr>
          <p:cNvSpPr txBox="1"/>
          <p:nvPr/>
        </p:nvSpPr>
        <p:spPr>
          <a:xfrm>
            <a:off x="340688" y="623825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3533637-3C34-5409-3896-0804D9934CBD}"/>
              </a:ext>
            </a:extLst>
          </p:cNvPr>
          <p:cNvSpPr txBox="1"/>
          <p:nvPr/>
        </p:nvSpPr>
        <p:spPr>
          <a:xfrm>
            <a:off x="5974080" y="623315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739FB31-4FA1-2FAF-6989-AB41064DCA6B}"/>
              </a:ext>
            </a:extLst>
          </p:cNvPr>
          <p:cNvSpPr txBox="1"/>
          <p:nvPr/>
        </p:nvSpPr>
        <p:spPr>
          <a:xfrm>
            <a:off x="3662259" y="3713063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0D1A428-F4DE-220D-5485-0D13F71F21EF}"/>
              </a:ext>
            </a:extLst>
          </p:cNvPr>
          <p:cNvSpPr txBox="1"/>
          <p:nvPr/>
        </p:nvSpPr>
        <p:spPr>
          <a:xfrm>
            <a:off x="547904" y="619482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C8D5BDC-6C03-B0DD-0D58-966E7F611723}"/>
              </a:ext>
            </a:extLst>
          </p:cNvPr>
          <p:cNvSpPr txBox="1"/>
          <p:nvPr/>
        </p:nvSpPr>
        <p:spPr>
          <a:xfrm>
            <a:off x="6203392" y="1066522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256747E-7AAB-ADB6-C8EF-08E9F20FC71C}"/>
              </a:ext>
            </a:extLst>
          </p:cNvPr>
          <p:cNvSpPr txBox="1"/>
          <p:nvPr/>
        </p:nvSpPr>
        <p:spPr>
          <a:xfrm>
            <a:off x="6203392" y="1507279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E2C0887-9903-12C4-8D21-07F6D7F197FC}"/>
              </a:ext>
            </a:extLst>
          </p:cNvPr>
          <p:cNvSpPr txBox="1"/>
          <p:nvPr/>
        </p:nvSpPr>
        <p:spPr>
          <a:xfrm>
            <a:off x="6203392" y="1964479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B6829F3-F240-EC27-C814-46F834746E59}"/>
              </a:ext>
            </a:extLst>
          </p:cNvPr>
          <p:cNvSpPr txBox="1"/>
          <p:nvPr/>
        </p:nvSpPr>
        <p:spPr>
          <a:xfrm>
            <a:off x="6198035" y="2445059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FCAC6C3-681A-AEA8-8B66-BE7D8F8203D6}"/>
              </a:ext>
            </a:extLst>
          </p:cNvPr>
          <p:cNvSpPr txBox="1"/>
          <p:nvPr/>
        </p:nvSpPr>
        <p:spPr>
          <a:xfrm>
            <a:off x="6192678" y="2875656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13815D5-5F5C-0DD9-7FC6-D0DB27F27650}"/>
              </a:ext>
            </a:extLst>
          </p:cNvPr>
          <p:cNvSpPr txBox="1"/>
          <p:nvPr/>
        </p:nvSpPr>
        <p:spPr>
          <a:xfrm>
            <a:off x="6196864" y="609322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34224BD-3A25-B864-9202-131B1B7372EE}"/>
              </a:ext>
            </a:extLst>
          </p:cNvPr>
          <p:cNvSpPr txBox="1"/>
          <p:nvPr/>
        </p:nvSpPr>
        <p:spPr>
          <a:xfrm>
            <a:off x="3844904" y="4143024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6CDB380E-11D0-DA84-3B50-1E85512BCDAA}"/>
              </a:ext>
            </a:extLst>
          </p:cNvPr>
          <p:cNvSpPr txBox="1"/>
          <p:nvPr/>
        </p:nvSpPr>
        <p:spPr>
          <a:xfrm>
            <a:off x="3844904" y="4583781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D0BE505-B5B8-E861-53BA-C12C9B17F593}"/>
              </a:ext>
            </a:extLst>
          </p:cNvPr>
          <p:cNvSpPr txBox="1"/>
          <p:nvPr/>
        </p:nvSpPr>
        <p:spPr>
          <a:xfrm>
            <a:off x="3844904" y="5040981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BC92A7E3-5C18-A38A-8451-054D9A1F4A8C}"/>
              </a:ext>
            </a:extLst>
          </p:cNvPr>
          <p:cNvSpPr txBox="1"/>
          <p:nvPr/>
        </p:nvSpPr>
        <p:spPr>
          <a:xfrm>
            <a:off x="3829387" y="5511401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2659A7DF-22F8-E033-529A-C90871464C58}"/>
              </a:ext>
            </a:extLst>
          </p:cNvPr>
          <p:cNvSpPr txBox="1"/>
          <p:nvPr/>
        </p:nvSpPr>
        <p:spPr>
          <a:xfrm>
            <a:off x="3834190" y="5972478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</p:txBody>
      </p:sp>
      <p:sp>
        <p:nvSpPr>
          <p:cNvPr id="1025" name="TextBox 1024">
            <a:extLst>
              <a:ext uri="{FF2B5EF4-FFF2-40B4-BE49-F238E27FC236}">
                <a16:creationId xmlns:a16="http://schemas.microsoft.com/office/drawing/2014/main" id="{BED42A96-FB50-F48A-DFB0-D7596CA52FC5}"/>
              </a:ext>
            </a:extLst>
          </p:cNvPr>
          <p:cNvSpPr txBox="1"/>
          <p:nvPr/>
        </p:nvSpPr>
        <p:spPr>
          <a:xfrm>
            <a:off x="3838376" y="3675664"/>
            <a:ext cx="419247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</p:spTree>
    <p:extLst>
      <p:ext uri="{BB962C8B-B14F-4D97-AF65-F5344CB8AC3E}">
        <p14:creationId xmlns:p14="http://schemas.microsoft.com/office/powerpoint/2010/main" val="27044811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F0DCBFE-663D-CA25-9A85-93A7CD8E16F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Content Placeholder 8">
            <a:extLst>
              <a:ext uri="{FF2B5EF4-FFF2-40B4-BE49-F238E27FC236}">
                <a16:creationId xmlns:a16="http://schemas.microsoft.com/office/drawing/2014/main" id="{34738A45-8457-B68A-E0B0-D2CE79D718BF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7349" t="43200" r="25903" b="49315"/>
          <a:stretch>
            <a:fillRect/>
          </a:stretch>
        </p:blipFill>
        <p:spPr>
          <a:xfrm>
            <a:off x="5661897" y="4745122"/>
            <a:ext cx="700337" cy="466236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9C7F170B-4ABE-A7D1-9C7B-3A9C41C5FE3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7649" t="7315" b="14892"/>
          <a:stretch>
            <a:fillRect/>
          </a:stretch>
        </p:blipFill>
        <p:spPr>
          <a:xfrm>
            <a:off x="8509875" y="2056738"/>
            <a:ext cx="2722161" cy="2338039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4027CE18-5C2F-D987-7D22-A7116EE19B20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3393" t="2284" b="14973"/>
          <a:stretch>
            <a:fillRect/>
          </a:stretch>
        </p:blipFill>
        <p:spPr>
          <a:xfrm>
            <a:off x="4425648" y="2042449"/>
            <a:ext cx="2860721" cy="2358758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E11D286E-AAEF-44C4-6104-A50D5BCD3921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5932" b="13583"/>
          <a:stretch>
            <a:fillRect/>
          </a:stretch>
        </p:blipFill>
        <p:spPr>
          <a:xfrm>
            <a:off x="536403" y="2055123"/>
            <a:ext cx="2719569" cy="2375569"/>
          </a:xfrm>
          <a:prstGeom prst="rect">
            <a:avLst/>
          </a:prstGeom>
        </p:spPr>
      </p:pic>
      <p:pic>
        <p:nvPicPr>
          <p:cNvPr id="6" name="Content Placeholder 8">
            <a:extLst>
              <a:ext uri="{FF2B5EF4-FFF2-40B4-BE49-F238E27FC236}">
                <a16:creationId xmlns:a16="http://schemas.microsoft.com/office/drawing/2014/main" id="{DE543F1D-6914-BAFE-A619-7C9ED47559B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7349" t="37859" r="25903" b="53985"/>
          <a:stretch>
            <a:fillRect/>
          </a:stretch>
        </p:blipFill>
        <p:spPr>
          <a:xfrm>
            <a:off x="3593993" y="4678605"/>
            <a:ext cx="700337" cy="50805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AF194A9-EE7D-52B8-45BA-03E4A72FAAB3}"/>
              </a:ext>
            </a:extLst>
          </p:cNvPr>
          <p:cNvSpPr txBox="1"/>
          <p:nvPr/>
        </p:nvSpPr>
        <p:spPr>
          <a:xfrm>
            <a:off x="4308867" y="4753803"/>
            <a:ext cx="137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denoviru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BB70109-5F09-A762-7815-62B8686B484C}"/>
              </a:ext>
            </a:extLst>
          </p:cNvPr>
          <p:cNvSpPr txBox="1"/>
          <p:nvPr/>
        </p:nvSpPr>
        <p:spPr>
          <a:xfrm>
            <a:off x="6352482" y="4767468"/>
            <a:ext cx="2214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ther pathogen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7EA116D-3C48-E202-33C3-D793D2CE07D4}"/>
              </a:ext>
            </a:extLst>
          </p:cNvPr>
          <p:cNvSpPr txBox="1"/>
          <p:nvPr/>
        </p:nvSpPr>
        <p:spPr>
          <a:xfrm>
            <a:off x="56380" y="204559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3BD14D0-A67B-B4C8-C9AC-1B7B6F02A5BA}"/>
              </a:ext>
            </a:extLst>
          </p:cNvPr>
          <p:cNvSpPr txBox="1"/>
          <p:nvPr/>
        </p:nvSpPr>
        <p:spPr>
          <a:xfrm>
            <a:off x="3967024" y="2045598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031E08B-59B2-2CB0-A2D1-6DBD5538C889}"/>
              </a:ext>
            </a:extLst>
          </p:cNvPr>
          <p:cNvSpPr txBox="1"/>
          <p:nvPr/>
        </p:nvSpPr>
        <p:spPr>
          <a:xfrm>
            <a:off x="8042153" y="2056737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D6828D4-FA36-CD77-0C35-777E958343FE}"/>
              </a:ext>
            </a:extLst>
          </p:cNvPr>
          <p:cNvSpPr/>
          <p:nvPr/>
        </p:nvSpPr>
        <p:spPr>
          <a:xfrm>
            <a:off x="3678890" y="4798193"/>
            <a:ext cx="533400" cy="280553"/>
          </a:xfrm>
          <a:prstGeom prst="rect">
            <a:avLst/>
          </a:prstGeom>
          <a:solidFill>
            <a:srgbClr val="DAD6A2">
              <a:alpha val="48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11E77BC-D8A5-E4A9-290C-85E1DD794721}"/>
              </a:ext>
            </a:extLst>
          </p:cNvPr>
          <p:cNvSpPr/>
          <p:nvPr/>
        </p:nvSpPr>
        <p:spPr>
          <a:xfrm>
            <a:off x="5737043" y="4827914"/>
            <a:ext cx="533400" cy="280553"/>
          </a:xfrm>
          <a:prstGeom prst="rect">
            <a:avLst/>
          </a:prstGeom>
          <a:solidFill>
            <a:srgbClr val="D7E8F1">
              <a:alpha val="47843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25171FF-4825-DA72-A59B-15414138C6BE}"/>
              </a:ext>
            </a:extLst>
          </p:cNvPr>
          <p:cNvSpPr txBox="1"/>
          <p:nvPr/>
        </p:nvSpPr>
        <p:spPr>
          <a:xfrm>
            <a:off x="0" y="0"/>
            <a:ext cx="2609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-figure 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B8C50FA-EC19-7BFD-2C55-73D463B54704}"/>
              </a:ext>
            </a:extLst>
          </p:cNvPr>
          <p:cNvSpPr txBox="1"/>
          <p:nvPr/>
        </p:nvSpPr>
        <p:spPr>
          <a:xfrm>
            <a:off x="10754063" y="2056737"/>
            <a:ext cx="4666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2EE66F9-998B-3B23-17CB-DD6F2C6B44A4}"/>
              </a:ext>
            </a:extLst>
          </p:cNvPr>
          <p:cNvSpPr txBox="1"/>
          <p:nvPr/>
        </p:nvSpPr>
        <p:spPr>
          <a:xfrm>
            <a:off x="6771701" y="2042448"/>
            <a:ext cx="6803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AA24B86-7563-6E95-5EBD-91FDCDF6519F}"/>
              </a:ext>
            </a:extLst>
          </p:cNvPr>
          <p:cNvSpPr txBox="1"/>
          <p:nvPr/>
        </p:nvSpPr>
        <p:spPr>
          <a:xfrm>
            <a:off x="253006" y="2258689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10F62CB-1B73-BBB5-DD11-862964DEF05B}"/>
              </a:ext>
            </a:extLst>
          </p:cNvPr>
          <p:cNvSpPr txBox="1"/>
          <p:nvPr/>
        </p:nvSpPr>
        <p:spPr>
          <a:xfrm>
            <a:off x="256148" y="2752891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3072592-9078-CC36-9E00-782523261179}"/>
              </a:ext>
            </a:extLst>
          </p:cNvPr>
          <p:cNvSpPr txBox="1"/>
          <p:nvPr/>
        </p:nvSpPr>
        <p:spPr>
          <a:xfrm>
            <a:off x="257718" y="3246930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3DA4005-28E2-FEAF-6BBC-E38E592C379E}"/>
              </a:ext>
            </a:extLst>
          </p:cNvPr>
          <p:cNvSpPr txBox="1"/>
          <p:nvPr/>
        </p:nvSpPr>
        <p:spPr>
          <a:xfrm>
            <a:off x="254576" y="3744274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5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882AB58D-890E-8C20-0EE4-09E2B37C1BBF}"/>
              </a:ext>
            </a:extLst>
          </p:cNvPr>
          <p:cNvSpPr txBox="1"/>
          <p:nvPr/>
        </p:nvSpPr>
        <p:spPr>
          <a:xfrm>
            <a:off x="896313" y="4574346"/>
            <a:ext cx="194003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ime since infection (years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923D193-1CC2-3E59-70AF-E674D40EDEB4}"/>
              </a:ext>
            </a:extLst>
          </p:cNvPr>
          <p:cNvSpPr txBox="1"/>
          <p:nvPr/>
        </p:nvSpPr>
        <p:spPr>
          <a:xfrm>
            <a:off x="253008" y="4239184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EC2BFB9-A4D4-514F-9227-70A2FED851A6}"/>
              </a:ext>
            </a:extLst>
          </p:cNvPr>
          <p:cNvSpPr txBox="1"/>
          <p:nvPr/>
        </p:nvSpPr>
        <p:spPr>
          <a:xfrm>
            <a:off x="449295" y="4461174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462A925-65FE-87D6-A6C0-FB99514C2A24}"/>
              </a:ext>
            </a:extLst>
          </p:cNvPr>
          <p:cNvSpPr txBox="1"/>
          <p:nvPr/>
        </p:nvSpPr>
        <p:spPr>
          <a:xfrm>
            <a:off x="735529" y="4461173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4084815-8D67-F650-612F-F614253F9636}"/>
              </a:ext>
            </a:extLst>
          </p:cNvPr>
          <p:cNvSpPr txBox="1"/>
          <p:nvPr/>
        </p:nvSpPr>
        <p:spPr>
          <a:xfrm>
            <a:off x="1015052" y="4458030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15B491E-0FBF-62B9-08B9-36D8549E3B58}"/>
              </a:ext>
            </a:extLst>
          </p:cNvPr>
          <p:cNvSpPr txBox="1"/>
          <p:nvPr/>
        </p:nvSpPr>
        <p:spPr>
          <a:xfrm>
            <a:off x="1304884" y="4455178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8A4FA2DC-084B-A849-6251-BB8EB85D5733}"/>
              </a:ext>
            </a:extLst>
          </p:cNvPr>
          <p:cNvSpPr txBox="1"/>
          <p:nvPr/>
        </p:nvSpPr>
        <p:spPr>
          <a:xfrm>
            <a:off x="1588678" y="4455177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D40CB72-8861-A99D-5339-616522E1189C}"/>
              </a:ext>
            </a:extLst>
          </p:cNvPr>
          <p:cNvSpPr txBox="1"/>
          <p:nvPr/>
        </p:nvSpPr>
        <p:spPr>
          <a:xfrm>
            <a:off x="1837502" y="4456750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0B6D3BD-DEF9-EC97-2D09-7E1D46D3416E}"/>
              </a:ext>
            </a:extLst>
          </p:cNvPr>
          <p:cNvSpPr txBox="1"/>
          <p:nvPr/>
        </p:nvSpPr>
        <p:spPr>
          <a:xfrm>
            <a:off x="2115012" y="4455176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EA138D2-2485-D0AA-FAAE-439395FFE7F5}"/>
              </a:ext>
            </a:extLst>
          </p:cNvPr>
          <p:cNvSpPr txBox="1"/>
          <p:nvPr/>
        </p:nvSpPr>
        <p:spPr>
          <a:xfrm>
            <a:off x="2394535" y="4456750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399D429-AAEA-635A-1F8F-A5F3531D295C}"/>
              </a:ext>
            </a:extLst>
          </p:cNvPr>
          <p:cNvSpPr txBox="1"/>
          <p:nvPr/>
        </p:nvSpPr>
        <p:spPr>
          <a:xfrm>
            <a:off x="2680769" y="4455176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D5A1BE8-8E0B-EE5D-C4DC-DFA75416FD87}"/>
              </a:ext>
            </a:extLst>
          </p:cNvPr>
          <p:cNvSpPr txBox="1"/>
          <p:nvPr/>
        </p:nvSpPr>
        <p:spPr>
          <a:xfrm>
            <a:off x="2968161" y="4456750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8FA2A94-FD9E-B8EA-1067-38B111981BFE}"/>
              </a:ext>
            </a:extLst>
          </p:cNvPr>
          <p:cNvSpPr txBox="1"/>
          <p:nvPr/>
        </p:nvSpPr>
        <p:spPr>
          <a:xfrm rot="16200000">
            <a:off x="-293552" y="3128289"/>
            <a:ext cx="10421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EV1 (z-score)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22FB6E4-A830-6AC4-85A8-90D88AD5D80D}"/>
              </a:ext>
            </a:extLst>
          </p:cNvPr>
          <p:cNvSpPr txBox="1"/>
          <p:nvPr/>
        </p:nvSpPr>
        <p:spPr>
          <a:xfrm>
            <a:off x="4105207" y="2215389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EACBA06-D510-4045-CAA2-2FC8548027C7}"/>
              </a:ext>
            </a:extLst>
          </p:cNvPr>
          <p:cNvSpPr txBox="1"/>
          <p:nvPr/>
        </p:nvSpPr>
        <p:spPr>
          <a:xfrm>
            <a:off x="4105174" y="2719116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958DDD3-D5E5-C970-A317-C55FEC217FC3}"/>
              </a:ext>
            </a:extLst>
          </p:cNvPr>
          <p:cNvSpPr txBox="1"/>
          <p:nvPr/>
        </p:nvSpPr>
        <p:spPr>
          <a:xfrm>
            <a:off x="4110079" y="3222843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C583866-CDC1-979D-1EE5-F3142D724DDB}"/>
              </a:ext>
            </a:extLst>
          </p:cNvPr>
          <p:cNvSpPr txBox="1"/>
          <p:nvPr/>
        </p:nvSpPr>
        <p:spPr>
          <a:xfrm>
            <a:off x="4107225" y="3728672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89EACB07-413C-CD3A-34E1-9DF2969A9253}"/>
              </a:ext>
            </a:extLst>
          </p:cNvPr>
          <p:cNvSpPr txBox="1"/>
          <p:nvPr/>
        </p:nvSpPr>
        <p:spPr>
          <a:xfrm>
            <a:off x="4862814" y="4591371"/>
            <a:ext cx="194003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ime since infection (years)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CF31B7A-6DE8-23AD-1542-F7091F37D6A6}"/>
              </a:ext>
            </a:extLst>
          </p:cNvPr>
          <p:cNvSpPr txBox="1"/>
          <p:nvPr/>
        </p:nvSpPr>
        <p:spPr>
          <a:xfrm>
            <a:off x="4105174" y="4236016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20E4F794-84D0-F8C9-22E5-8B30D2F1735B}"/>
              </a:ext>
            </a:extLst>
          </p:cNvPr>
          <p:cNvSpPr txBox="1"/>
          <p:nvPr/>
        </p:nvSpPr>
        <p:spPr>
          <a:xfrm>
            <a:off x="4342771" y="4436924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7FA6FE9-6526-90F2-A8D8-E9B9D03C5931}"/>
              </a:ext>
            </a:extLst>
          </p:cNvPr>
          <p:cNvSpPr txBox="1"/>
          <p:nvPr/>
        </p:nvSpPr>
        <p:spPr>
          <a:xfrm>
            <a:off x="4638530" y="4436923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F38023AB-C443-F143-5C73-5046A81F9793}"/>
              </a:ext>
            </a:extLst>
          </p:cNvPr>
          <p:cNvSpPr txBox="1"/>
          <p:nvPr/>
        </p:nvSpPr>
        <p:spPr>
          <a:xfrm>
            <a:off x="4937103" y="4436955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17D39A26-BF25-3B34-18BF-F930B19BF51D}"/>
              </a:ext>
            </a:extLst>
          </p:cNvPr>
          <p:cNvSpPr txBox="1"/>
          <p:nvPr/>
        </p:nvSpPr>
        <p:spPr>
          <a:xfrm>
            <a:off x="5236460" y="4437278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B6E3463-A44F-8756-B721-01ED0A1916B3}"/>
              </a:ext>
            </a:extLst>
          </p:cNvPr>
          <p:cNvSpPr txBox="1"/>
          <p:nvPr/>
        </p:nvSpPr>
        <p:spPr>
          <a:xfrm>
            <a:off x="5532954" y="4440452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A2C321A5-D1AC-8F3A-67F1-01FA891BDF49}"/>
              </a:ext>
            </a:extLst>
          </p:cNvPr>
          <p:cNvSpPr txBox="1"/>
          <p:nvPr/>
        </p:nvSpPr>
        <p:spPr>
          <a:xfrm>
            <a:off x="5797653" y="4438850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F043B008-AD39-9C35-3CDF-DF8658538252}"/>
              </a:ext>
            </a:extLst>
          </p:cNvPr>
          <p:cNvSpPr txBox="1"/>
          <p:nvPr/>
        </p:nvSpPr>
        <p:spPr>
          <a:xfrm>
            <a:off x="6094213" y="4437276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921C8E9F-AAC9-4BD7-9D52-127ECBE9FC7B}"/>
              </a:ext>
            </a:extLst>
          </p:cNvPr>
          <p:cNvSpPr txBox="1"/>
          <p:nvPr/>
        </p:nvSpPr>
        <p:spPr>
          <a:xfrm>
            <a:off x="6392786" y="4438850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2573B157-7F46-517F-B16C-54DA82F88439}"/>
              </a:ext>
            </a:extLst>
          </p:cNvPr>
          <p:cNvSpPr txBox="1"/>
          <p:nvPr/>
        </p:nvSpPr>
        <p:spPr>
          <a:xfrm>
            <a:off x="6688545" y="4437276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7883008F-8AE8-04E5-234B-65EF7476265A}"/>
              </a:ext>
            </a:extLst>
          </p:cNvPr>
          <p:cNvSpPr txBox="1"/>
          <p:nvPr/>
        </p:nvSpPr>
        <p:spPr>
          <a:xfrm>
            <a:off x="6988637" y="4438850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CB9A244-F0BB-1914-3093-8B799BCBB0FD}"/>
              </a:ext>
            </a:extLst>
          </p:cNvPr>
          <p:cNvSpPr txBox="1"/>
          <p:nvPr/>
        </p:nvSpPr>
        <p:spPr>
          <a:xfrm rot="16200000">
            <a:off x="3615799" y="3088164"/>
            <a:ext cx="10421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VC (z-score)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F2CF5E39-5063-4359-F7CD-55EAFAE31379}"/>
              </a:ext>
            </a:extLst>
          </p:cNvPr>
          <p:cNvSpPr txBox="1"/>
          <p:nvPr/>
        </p:nvSpPr>
        <p:spPr>
          <a:xfrm>
            <a:off x="8205214" y="2462796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7CD86074-7AE0-9EF1-4DFA-16F407550DC8}"/>
              </a:ext>
            </a:extLst>
          </p:cNvPr>
          <p:cNvSpPr txBox="1"/>
          <p:nvPr/>
        </p:nvSpPr>
        <p:spPr>
          <a:xfrm>
            <a:off x="8205072" y="3048599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097A99AA-40B1-7846-81BE-E6B01EC5FE18}"/>
              </a:ext>
            </a:extLst>
          </p:cNvPr>
          <p:cNvSpPr txBox="1"/>
          <p:nvPr/>
        </p:nvSpPr>
        <p:spPr>
          <a:xfrm>
            <a:off x="8971321" y="4579112"/>
            <a:ext cx="194003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ime since infection (years)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E551B70-413D-185C-1B84-FDF35A5E43EF}"/>
              </a:ext>
            </a:extLst>
          </p:cNvPr>
          <p:cNvSpPr txBox="1"/>
          <p:nvPr/>
        </p:nvSpPr>
        <p:spPr>
          <a:xfrm>
            <a:off x="8208435" y="3639165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FCEC5FA-2180-366A-F700-23F44BC543C3}"/>
              </a:ext>
            </a:extLst>
          </p:cNvPr>
          <p:cNvSpPr txBox="1"/>
          <p:nvPr/>
        </p:nvSpPr>
        <p:spPr>
          <a:xfrm>
            <a:off x="8452195" y="4434133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762167FA-E80F-586F-2FF7-CA665E07C87F}"/>
              </a:ext>
            </a:extLst>
          </p:cNvPr>
          <p:cNvSpPr txBox="1"/>
          <p:nvPr/>
        </p:nvSpPr>
        <p:spPr>
          <a:xfrm>
            <a:off x="8733517" y="4438850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A5C7D3C3-E83D-1D2F-C100-152172CBECE6}"/>
              </a:ext>
            </a:extLst>
          </p:cNvPr>
          <p:cNvSpPr txBox="1"/>
          <p:nvPr/>
        </p:nvSpPr>
        <p:spPr>
          <a:xfrm>
            <a:off x="9013409" y="4440534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B73535A9-F0D9-1A2F-0AE2-6C0FD59050A6}"/>
              </a:ext>
            </a:extLst>
          </p:cNvPr>
          <p:cNvSpPr txBox="1"/>
          <p:nvPr/>
        </p:nvSpPr>
        <p:spPr>
          <a:xfrm>
            <a:off x="9293301" y="4438978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F84A70C2-10D2-A8EB-54C6-B35D54D148D3}"/>
              </a:ext>
            </a:extLst>
          </p:cNvPr>
          <p:cNvSpPr txBox="1"/>
          <p:nvPr/>
        </p:nvSpPr>
        <p:spPr>
          <a:xfrm>
            <a:off x="9573193" y="4440534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4E6CAC6F-F495-9C64-5B37-311F466DF496}"/>
              </a:ext>
            </a:extLst>
          </p:cNvPr>
          <p:cNvSpPr txBox="1"/>
          <p:nvPr/>
        </p:nvSpPr>
        <p:spPr>
          <a:xfrm>
            <a:off x="9817060" y="4436111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7CF134AE-7248-8495-D3BA-FB1F4D13F61D}"/>
              </a:ext>
            </a:extLst>
          </p:cNvPr>
          <p:cNvSpPr txBox="1"/>
          <p:nvPr/>
        </p:nvSpPr>
        <p:spPr>
          <a:xfrm>
            <a:off x="10096434" y="4431688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678C9D4A-A85E-3C78-B356-9EA55BB582C2}"/>
              </a:ext>
            </a:extLst>
          </p:cNvPr>
          <p:cNvSpPr txBox="1"/>
          <p:nvPr/>
        </p:nvSpPr>
        <p:spPr>
          <a:xfrm>
            <a:off x="10372426" y="4440462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13612393-2530-0C47-8968-B9A1F68E9790}"/>
              </a:ext>
            </a:extLst>
          </p:cNvPr>
          <p:cNvSpPr txBox="1"/>
          <p:nvPr/>
        </p:nvSpPr>
        <p:spPr>
          <a:xfrm>
            <a:off x="10656363" y="4434630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CC930B95-CEAC-32E9-DDF4-84AAAA1B679A}"/>
              </a:ext>
            </a:extLst>
          </p:cNvPr>
          <p:cNvSpPr txBox="1"/>
          <p:nvPr/>
        </p:nvSpPr>
        <p:spPr>
          <a:xfrm>
            <a:off x="10934674" y="4431687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5F8C118F-76DC-DCDA-60AF-56BDE3B6BC2C}"/>
              </a:ext>
            </a:extLst>
          </p:cNvPr>
          <p:cNvSpPr txBox="1"/>
          <p:nvPr/>
        </p:nvSpPr>
        <p:spPr>
          <a:xfrm rot="16200000">
            <a:off x="7514273" y="3200504"/>
            <a:ext cx="13815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EV1/FVC (z-score)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2409A288-EBAA-1153-072D-284F3C18C801}"/>
              </a:ext>
            </a:extLst>
          </p:cNvPr>
          <p:cNvSpPr txBox="1"/>
          <p:nvPr/>
        </p:nvSpPr>
        <p:spPr>
          <a:xfrm>
            <a:off x="8203838" y="4224968"/>
            <a:ext cx="3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8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BB8734B5-1E5D-CD0D-445D-5DAE56C613A9}"/>
              </a:ext>
            </a:extLst>
          </p:cNvPr>
          <p:cNvCxnSpPr>
            <a:cxnSpLocks/>
          </p:cNvCxnSpPr>
          <p:nvPr/>
        </p:nvCxnSpPr>
        <p:spPr>
          <a:xfrm flipV="1">
            <a:off x="519567" y="2162810"/>
            <a:ext cx="0" cy="2261534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7775C379-E43C-BA2A-D412-8B834AB96887}"/>
              </a:ext>
            </a:extLst>
          </p:cNvPr>
          <p:cNvCxnSpPr>
            <a:cxnSpLocks/>
          </p:cNvCxnSpPr>
          <p:nvPr/>
        </p:nvCxnSpPr>
        <p:spPr>
          <a:xfrm>
            <a:off x="519145" y="4426805"/>
            <a:ext cx="2736828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B9871654-23A4-524A-C080-B0866EEAD8E1}"/>
              </a:ext>
            </a:extLst>
          </p:cNvPr>
          <p:cNvCxnSpPr>
            <a:cxnSpLocks/>
          </p:cNvCxnSpPr>
          <p:nvPr/>
        </p:nvCxnSpPr>
        <p:spPr>
          <a:xfrm flipH="1">
            <a:off x="484622" y="2391673"/>
            <a:ext cx="2972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id="{D23389EB-9928-D8BC-CE52-54CCB6DBE08E}"/>
              </a:ext>
            </a:extLst>
          </p:cNvPr>
          <p:cNvCxnSpPr>
            <a:cxnSpLocks/>
          </p:cNvCxnSpPr>
          <p:nvPr/>
        </p:nvCxnSpPr>
        <p:spPr>
          <a:xfrm flipH="1">
            <a:off x="484622" y="2880623"/>
            <a:ext cx="2972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id="{7707845A-6747-220A-CFB2-FF53A040393A}"/>
              </a:ext>
            </a:extLst>
          </p:cNvPr>
          <p:cNvCxnSpPr>
            <a:cxnSpLocks/>
          </p:cNvCxnSpPr>
          <p:nvPr/>
        </p:nvCxnSpPr>
        <p:spPr>
          <a:xfrm flipH="1">
            <a:off x="484622" y="3375923"/>
            <a:ext cx="2972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id="{1F4CFBD0-623F-5E65-37E1-5C1171E45C0E}"/>
              </a:ext>
            </a:extLst>
          </p:cNvPr>
          <p:cNvCxnSpPr>
            <a:cxnSpLocks/>
          </p:cNvCxnSpPr>
          <p:nvPr/>
        </p:nvCxnSpPr>
        <p:spPr>
          <a:xfrm flipH="1">
            <a:off x="484622" y="3871223"/>
            <a:ext cx="2972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id="{985DAC12-6E7B-F136-21B5-3AF4CD222D84}"/>
              </a:ext>
            </a:extLst>
          </p:cNvPr>
          <p:cNvCxnSpPr>
            <a:cxnSpLocks/>
          </p:cNvCxnSpPr>
          <p:nvPr/>
        </p:nvCxnSpPr>
        <p:spPr>
          <a:xfrm flipH="1">
            <a:off x="484622" y="4366523"/>
            <a:ext cx="2972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id="{3E8D6F76-99A8-AD10-8DAC-7F5545955DC4}"/>
              </a:ext>
            </a:extLst>
          </p:cNvPr>
          <p:cNvCxnSpPr>
            <a:cxnSpLocks/>
          </p:cNvCxnSpPr>
          <p:nvPr/>
        </p:nvCxnSpPr>
        <p:spPr>
          <a:xfrm flipV="1">
            <a:off x="577848" y="4430023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id="{9B89A8E3-10E3-16A7-085E-2B7A638A1398}"/>
              </a:ext>
            </a:extLst>
          </p:cNvPr>
          <p:cNvCxnSpPr>
            <a:cxnSpLocks/>
          </p:cNvCxnSpPr>
          <p:nvPr/>
        </p:nvCxnSpPr>
        <p:spPr>
          <a:xfrm flipV="1">
            <a:off x="863598" y="4436373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0" name="Straight Connector 159">
            <a:extLst>
              <a:ext uri="{FF2B5EF4-FFF2-40B4-BE49-F238E27FC236}">
                <a16:creationId xmlns:a16="http://schemas.microsoft.com/office/drawing/2014/main" id="{17268434-5346-C4A3-EF0F-338E70C339F4}"/>
              </a:ext>
            </a:extLst>
          </p:cNvPr>
          <p:cNvCxnSpPr>
            <a:cxnSpLocks/>
          </p:cNvCxnSpPr>
          <p:nvPr/>
        </p:nvCxnSpPr>
        <p:spPr>
          <a:xfrm flipV="1">
            <a:off x="1142998" y="4436373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1" name="Straight Connector 160">
            <a:extLst>
              <a:ext uri="{FF2B5EF4-FFF2-40B4-BE49-F238E27FC236}">
                <a16:creationId xmlns:a16="http://schemas.microsoft.com/office/drawing/2014/main" id="{BB1C690A-7415-29AE-332B-C8BD7A6803C3}"/>
              </a:ext>
            </a:extLst>
          </p:cNvPr>
          <p:cNvCxnSpPr>
            <a:cxnSpLocks/>
          </p:cNvCxnSpPr>
          <p:nvPr/>
        </p:nvCxnSpPr>
        <p:spPr>
          <a:xfrm flipV="1">
            <a:off x="1428748" y="4430023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2" name="Straight Connector 161">
            <a:extLst>
              <a:ext uri="{FF2B5EF4-FFF2-40B4-BE49-F238E27FC236}">
                <a16:creationId xmlns:a16="http://schemas.microsoft.com/office/drawing/2014/main" id="{F77F7361-4319-E58A-FE1A-3160EEAA53FC}"/>
              </a:ext>
            </a:extLst>
          </p:cNvPr>
          <p:cNvCxnSpPr>
            <a:cxnSpLocks/>
          </p:cNvCxnSpPr>
          <p:nvPr/>
        </p:nvCxnSpPr>
        <p:spPr>
          <a:xfrm flipV="1">
            <a:off x="1714498" y="4430023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3" name="Straight Connector 162">
            <a:extLst>
              <a:ext uri="{FF2B5EF4-FFF2-40B4-BE49-F238E27FC236}">
                <a16:creationId xmlns:a16="http://schemas.microsoft.com/office/drawing/2014/main" id="{8F561ED2-98FB-ADAE-8524-6CD67DA94B7A}"/>
              </a:ext>
            </a:extLst>
          </p:cNvPr>
          <p:cNvCxnSpPr>
            <a:cxnSpLocks/>
          </p:cNvCxnSpPr>
          <p:nvPr/>
        </p:nvCxnSpPr>
        <p:spPr>
          <a:xfrm flipV="1">
            <a:off x="1993898" y="4430023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4" name="Straight Connector 163">
            <a:extLst>
              <a:ext uri="{FF2B5EF4-FFF2-40B4-BE49-F238E27FC236}">
                <a16:creationId xmlns:a16="http://schemas.microsoft.com/office/drawing/2014/main" id="{CF71143B-2066-D50D-0EA4-6BED8D02CAF5}"/>
              </a:ext>
            </a:extLst>
          </p:cNvPr>
          <p:cNvCxnSpPr>
            <a:cxnSpLocks/>
          </p:cNvCxnSpPr>
          <p:nvPr/>
        </p:nvCxnSpPr>
        <p:spPr>
          <a:xfrm flipV="1">
            <a:off x="2279648" y="4430023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id="{DEDA451F-EB0E-4EEF-039E-17384DA6E552}"/>
              </a:ext>
            </a:extLst>
          </p:cNvPr>
          <p:cNvCxnSpPr>
            <a:cxnSpLocks/>
          </p:cNvCxnSpPr>
          <p:nvPr/>
        </p:nvCxnSpPr>
        <p:spPr>
          <a:xfrm flipV="1">
            <a:off x="2565398" y="4430023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6" name="Straight Connector 165">
            <a:extLst>
              <a:ext uri="{FF2B5EF4-FFF2-40B4-BE49-F238E27FC236}">
                <a16:creationId xmlns:a16="http://schemas.microsoft.com/office/drawing/2014/main" id="{C02F15D4-B8D3-F938-15BC-5AFB42BF234D}"/>
              </a:ext>
            </a:extLst>
          </p:cNvPr>
          <p:cNvCxnSpPr>
            <a:cxnSpLocks/>
          </p:cNvCxnSpPr>
          <p:nvPr/>
        </p:nvCxnSpPr>
        <p:spPr>
          <a:xfrm flipV="1">
            <a:off x="2844798" y="4430023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7" name="Straight Connector 166">
            <a:extLst>
              <a:ext uri="{FF2B5EF4-FFF2-40B4-BE49-F238E27FC236}">
                <a16:creationId xmlns:a16="http://schemas.microsoft.com/office/drawing/2014/main" id="{8B6F1D8D-A22B-107D-11F8-7D8DDE0196DE}"/>
              </a:ext>
            </a:extLst>
          </p:cNvPr>
          <p:cNvCxnSpPr>
            <a:cxnSpLocks/>
          </p:cNvCxnSpPr>
          <p:nvPr/>
        </p:nvCxnSpPr>
        <p:spPr>
          <a:xfrm flipV="1">
            <a:off x="3130548" y="4430023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8" name="Straight Connector 167">
            <a:extLst>
              <a:ext uri="{FF2B5EF4-FFF2-40B4-BE49-F238E27FC236}">
                <a16:creationId xmlns:a16="http://schemas.microsoft.com/office/drawing/2014/main" id="{216A0FFE-1304-8556-6BAC-17F6A422C518}"/>
              </a:ext>
            </a:extLst>
          </p:cNvPr>
          <p:cNvCxnSpPr>
            <a:cxnSpLocks/>
          </p:cNvCxnSpPr>
          <p:nvPr/>
        </p:nvCxnSpPr>
        <p:spPr>
          <a:xfrm flipV="1">
            <a:off x="4413863" y="2106692"/>
            <a:ext cx="0" cy="2307216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9" name="Straight Connector 168">
            <a:extLst>
              <a:ext uri="{FF2B5EF4-FFF2-40B4-BE49-F238E27FC236}">
                <a16:creationId xmlns:a16="http://schemas.microsoft.com/office/drawing/2014/main" id="{E364C791-E9D6-6142-12DE-DE6394ACE027}"/>
              </a:ext>
            </a:extLst>
          </p:cNvPr>
          <p:cNvCxnSpPr>
            <a:cxnSpLocks/>
          </p:cNvCxnSpPr>
          <p:nvPr/>
        </p:nvCxnSpPr>
        <p:spPr>
          <a:xfrm>
            <a:off x="4413441" y="4416369"/>
            <a:ext cx="290624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70" name="Straight Connector 169">
            <a:extLst>
              <a:ext uri="{FF2B5EF4-FFF2-40B4-BE49-F238E27FC236}">
                <a16:creationId xmlns:a16="http://schemas.microsoft.com/office/drawing/2014/main" id="{4D064362-FC98-30FE-112D-37930F1A226D}"/>
              </a:ext>
            </a:extLst>
          </p:cNvPr>
          <p:cNvCxnSpPr>
            <a:cxnSpLocks/>
          </p:cNvCxnSpPr>
          <p:nvPr/>
        </p:nvCxnSpPr>
        <p:spPr>
          <a:xfrm flipH="1">
            <a:off x="4378918" y="2336787"/>
            <a:ext cx="2972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1" name="Straight Connector 170">
            <a:extLst>
              <a:ext uri="{FF2B5EF4-FFF2-40B4-BE49-F238E27FC236}">
                <a16:creationId xmlns:a16="http://schemas.microsoft.com/office/drawing/2014/main" id="{76B4C82C-BF4B-D895-D2C5-8B2B549DFB9A}"/>
              </a:ext>
            </a:extLst>
          </p:cNvPr>
          <p:cNvCxnSpPr>
            <a:cxnSpLocks/>
          </p:cNvCxnSpPr>
          <p:nvPr/>
        </p:nvCxnSpPr>
        <p:spPr>
          <a:xfrm flipH="1">
            <a:off x="4378918" y="2838437"/>
            <a:ext cx="2972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2" name="Straight Connector 171">
            <a:extLst>
              <a:ext uri="{FF2B5EF4-FFF2-40B4-BE49-F238E27FC236}">
                <a16:creationId xmlns:a16="http://schemas.microsoft.com/office/drawing/2014/main" id="{AE2C6C35-1442-70D1-57F0-18C4BFEFF7F7}"/>
              </a:ext>
            </a:extLst>
          </p:cNvPr>
          <p:cNvCxnSpPr>
            <a:cxnSpLocks/>
          </p:cNvCxnSpPr>
          <p:nvPr/>
        </p:nvCxnSpPr>
        <p:spPr>
          <a:xfrm flipH="1">
            <a:off x="4378918" y="3352787"/>
            <a:ext cx="2972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3" name="Straight Connector 172">
            <a:extLst>
              <a:ext uri="{FF2B5EF4-FFF2-40B4-BE49-F238E27FC236}">
                <a16:creationId xmlns:a16="http://schemas.microsoft.com/office/drawing/2014/main" id="{AD29278D-5642-8496-D7C9-EAF0B25D98FF}"/>
              </a:ext>
            </a:extLst>
          </p:cNvPr>
          <p:cNvCxnSpPr>
            <a:cxnSpLocks/>
          </p:cNvCxnSpPr>
          <p:nvPr/>
        </p:nvCxnSpPr>
        <p:spPr>
          <a:xfrm flipH="1">
            <a:off x="4378918" y="3854437"/>
            <a:ext cx="2972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4" name="Straight Connector 173">
            <a:extLst>
              <a:ext uri="{FF2B5EF4-FFF2-40B4-BE49-F238E27FC236}">
                <a16:creationId xmlns:a16="http://schemas.microsoft.com/office/drawing/2014/main" id="{4227BF08-D2C6-2A93-B041-6BA911211EF8}"/>
              </a:ext>
            </a:extLst>
          </p:cNvPr>
          <p:cNvCxnSpPr>
            <a:cxnSpLocks/>
          </p:cNvCxnSpPr>
          <p:nvPr/>
        </p:nvCxnSpPr>
        <p:spPr>
          <a:xfrm flipH="1">
            <a:off x="4378918" y="4356087"/>
            <a:ext cx="2972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5" name="Straight Connector 174">
            <a:extLst>
              <a:ext uri="{FF2B5EF4-FFF2-40B4-BE49-F238E27FC236}">
                <a16:creationId xmlns:a16="http://schemas.microsoft.com/office/drawing/2014/main" id="{11AB3261-36AC-CE47-20A3-104F34CF4A5A}"/>
              </a:ext>
            </a:extLst>
          </p:cNvPr>
          <p:cNvCxnSpPr>
            <a:cxnSpLocks/>
          </p:cNvCxnSpPr>
          <p:nvPr/>
        </p:nvCxnSpPr>
        <p:spPr>
          <a:xfrm flipV="1">
            <a:off x="4472144" y="4419587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9B3B6537-E063-053F-A03D-69F2F847E34D}"/>
              </a:ext>
            </a:extLst>
          </p:cNvPr>
          <p:cNvCxnSpPr>
            <a:cxnSpLocks/>
          </p:cNvCxnSpPr>
          <p:nvPr/>
        </p:nvCxnSpPr>
        <p:spPr>
          <a:xfrm flipV="1">
            <a:off x="4770594" y="4425937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7" name="Straight Connector 176">
            <a:extLst>
              <a:ext uri="{FF2B5EF4-FFF2-40B4-BE49-F238E27FC236}">
                <a16:creationId xmlns:a16="http://schemas.microsoft.com/office/drawing/2014/main" id="{42F38722-C4D5-2665-80B2-88185561FF8D}"/>
              </a:ext>
            </a:extLst>
          </p:cNvPr>
          <p:cNvCxnSpPr>
            <a:cxnSpLocks/>
          </p:cNvCxnSpPr>
          <p:nvPr/>
        </p:nvCxnSpPr>
        <p:spPr>
          <a:xfrm flipV="1">
            <a:off x="5062694" y="4425937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8" name="Straight Connector 177">
            <a:extLst>
              <a:ext uri="{FF2B5EF4-FFF2-40B4-BE49-F238E27FC236}">
                <a16:creationId xmlns:a16="http://schemas.microsoft.com/office/drawing/2014/main" id="{B2AEA4C2-539E-C78C-419F-E07FD86291CA}"/>
              </a:ext>
            </a:extLst>
          </p:cNvPr>
          <p:cNvCxnSpPr>
            <a:cxnSpLocks/>
          </p:cNvCxnSpPr>
          <p:nvPr/>
        </p:nvCxnSpPr>
        <p:spPr>
          <a:xfrm flipV="1">
            <a:off x="5361144" y="4419587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9" name="Straight Connector 178">
            <a:extLst>
              <a:ext uri="{FF2B5EF4-FFF2-40B4-BE49-F238E27FC236}">
                <a16:creationId xmlns:a16="http://schemas.microsoft.com/office/drawing/2014/main" id="{4945AA16-69C4-E885-B637-A228C73BFED2}"/>
              </a:ext>
            </a:extLst>
          </p:cNvPr>
          <p:cNvCxnSpPr>
            <a:cxnSpLocks/>
          </p:cNvCxnSpPr>
          <p:nvPr/>
        </p:nvCxnSpPr>
        <p:spPr>
          <a:xfrm flipV="1">
            <a:off x="5659594" y="4419587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0" name="Straight Connector 179">
            <a:extLst>
              <a:ext uri="{FF2B5EF4-FFF2-40B4-BE49-F238E27FC236}">
                <a16:creationId xmlns:a16="http://schemas.microsoft.com/office/drawing/2014/main" id="{3D69BBD5-2F3D-5D54-3EBE-C2CDC7296638}"/>
              </a:ext>
            </a:extLst>
          </p:cNvPr>
          <p:cNvCxnSpPr>
            <a:cxnSpLocks/>
          </p:cNvCxnSpPr>
          <p:nvPr/>
        </p:nvCxnSpPr>
        <p:spPr>
          <a:xfrm flipV="1">
            <a:off x="5958044" y="4419587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1" name="Straight Connector 180">
            <a:extLst>
              <a:ext uri="{FF2B5EF4-FFF2-40B4-BE49-F238E27FC236}">
                <a16:creationId xmlns:a16="http://schemas.microsoft.com/office/drawing/2014/main" id="{C07C1118-F70C-CCA0-FC6A-0DFF3A0217D2}"/>
              </a:ext>
            </a:extLst>
          </p:cNvPr>
          <p:cNvCxnSpPr>
            <a:cxnSpLocks/>
          </p:cNvCxnSpPr>
          <p:nvPr/>
        </p:nvCxnSpPr>
        <p:spPr>
          <a:xfrm flipV="1">
            <a:off x="6256494" y="4419587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2" name="Straight Connector 181">
            <a:extLst>
              <a:ext uri="{FF2B5EF4-FFF2-40B4-BE49-F238E27FC236}">
                <a16:creationId xmlns:a16="http://schemas.microsoft.com/office/drawing/2014/main" id="{A74BD84D-45E4-8565-30A7-B95AE507B6E3}"/>
              </a:ext>
            </a:extLst>
          </p:cNvPr>
          <p:cNvCxnSpPr>
            <a:cxnSpLocks/>
          </p:cNvCxnSpPr>
          <p:nvPr/>
        </p:nvCxnSpPr>
        <p:spPr>
          <a:xfrm flipV="1">
            <a:off x="6554944" y="4419587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3" name="Straight Connector 182">
            <a:extLst>
              <a:ext uri="{FF2B5EF4-FFF2-40B4-BE49-F238E27FC236}">
                <a16:creationId xmlns:a16="http://schemas.microsoft.com/office/drawing/2014/main" id="{FA11DC5B-F4E0-D38B-0FE6-0437CE32E493}"/>
              </a:ext>
            </a:extLst>
          </p:cNvPr>
          <p:cNvCxnSpPr>
            <a:cxnSpLocks/>
          </p:cNvCxnSpPr>
          <p:nvPr/>
        </p:nvCxnSpPr>
        <p:spPr>
          <a:xfrm flipV="1">
            <a:off x="6847044" y="4419587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4" name="Straight Connector 183">
            <a:extLst>
              <a:ext uri="{FF2B5EF4-FFF2-40B4-BE49-F238E27FC236}">
                <a16:creationId xmlns:a16="http://schemas.microsoft.com/office/drawing/2014/main" id="{C697BFBE-46D0-39B0-7A7E-5DD99244E2EE}"/>
              </a:ext>
            </a:extLst>
          </p:cNvPr>
          <p:cNvCxnSpPr>
            <a:cxnSpLocks/>
          </p:cNvCxnSpPr>
          <p:nvPr/>
        </p:nvCxnSpPr>
        <p:spPr>
          <a:xfrm flipV="1">
            <a:off x="7158194" y="4419587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8" name="Straight Connector 187">
            <a:extLst>
              <a:ext uri="{FF2B5EF4-FFF2-40B4-BE49-F238E27FC236}">
                <a16:creationId xmlns:a16="http://schemas.microsoft.com/office/drawing/2014/main" id="{73DFDA06-B69D-2AEA-1901-9CAC0840F1B5}"/>
              </a:ext>
            </a:extLst>
          </p:cNvPr>
          <p:cNvCxnSpPr>
            <a:cxnSpLocks/>
          </p:cNvCxnSpPr>
          <p:nvPr/>
        </p:nvCxnSpPr>
        <p:spPr>
          <a:xfrm flipV="1">
            <a:off x="8512787" y="2101154"/>
            <a:ext cx="0" cy="2307216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D73011B5-603F-D9D3-6D55-57F0DCD524EA}"/>
              </a:ext>
            </a:extLst>
          </p:cNvPr>
          <p:cNvCxnSpPr>
            <a:cxnSpLocks/>
          </p:cNvCxnSpPr>
          <p:nvPr/>
        </p:nvCxnSpPr>
        <p:spPr>
          <a:xfrm>
            <a:off x="8512365" y="4410831"/>
            <a:ext cx="2719671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1" name="Straight Connector 190">
            <a:extLst>
              <a:ext uri="{FF2B5EF4-FFF2-40B4-BE49-F238E27FC236}">
                <a16:creationId xmlns:a16="http://schemas.microsoft.com/office/drawing/2014/main" id="{9319DD63-D98C-8A45-310F-0912567EE93B}"/>
              </a:ext>
            </a:extLst>
          </p:cNvPr>
          <p:cNvCxnSpPr>
            <a:cxnSpLocks/>
          </p:cNvCxnSpPr>
          <p:nvPr/>
        </p:nvCxnSpPr>
        <p:spPr>
          <a:xfrm flipH="1">
            <a:off x="8477842" y="2578899"/>
            <a:ext cx="2972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2" name="Straight Connector 191">
            <a:extLst>
              <a:ext uri="{FF2B5EF4-FFF2-40B4-BE49-F238E27FC236}">
                <a16:creationId xmlns:a16="http://schemas.microsoft.com/office/drawing/2014/main" id="{0FD91F03-0940-729A-FF5A-534F3C7BEC3A}"/>
              </a:ext>
            </a:extLst>
          </p:cNvPr>
          <p:cNvCxnSpPr>
            <a:cxnSpLocks/>
          </p:cNvCxnSpPr>
          <p:nvPr/>
        </p:nvCxnSpPr>
        <p:spPr>
          <a:xfrm flipH="1">
            <a:off x="8477842" y="3169449"/>
            <a:ext cx="2972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3" name="Straight Connector 192">
            <a:extLst>
              <a:ext uri="{FF2B5EF4-FFF2-40B4-BE49-F238E27FC236}">
                <a16:creationId xmlns:a16="http://schemas.microsoft.com/office/drawing/2014/main" id="{0265E0C9-722E-2DFF-6426-05940F318083}"/>
              </a:ext>
            </a:extLst>
          </p:cNvPr>
          <p:cNvCxnSpPr>
            <a:cxnSpLocks/>
          </p:cNvCxnSpPr>
          <p:nvPr/>
        </p:nvCxnSpPr>
        <p:spPr>
          <a:xfrm flipH="1">
            <a:off x="8477842" y="3759999"/>
            <a:ext cx="2972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4" name="Straight Connector 193">
            <a:extLst>
              <a:ext uri="{FF2B5EF4-FFF2-40B4-BE49-F238E27FC236}">
                <a16:creationId xmlns:a16="http://schemas.microsoft.com/office/drawing/2014/main" id="{430D2164-30CC-2B6A-B66E-696CB0F876D1}"/>
              </a:ext>
            </a:extLst>
          </p:cNvPr>
          <p:cNvCxnSpPr>
            <a:cxnSpLocks/>
          </p:cNvCxnSpPr>
          <p:nvPr/>
        </p:nvCxnSpPr>
        <p:spPr>
          <a:xfrm flipH="1">
            <a:off x="8477842" y="4344199"/>
            <a:ext cx="29726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5" name="Straight Connector 194">
            <a:extLst>
              <a:ext uri="{FF2B5EF4-FFF2-40B4-BE49-F238E27FC236}">
                <a16:creationId xmlns:a16="http://schemas.microsoft.com/office/drawing/2014/main" id="{DBB67322-DDFF-8224-FE33-9532F09E0CB0}"/>
              </a:ext>
            </a:extLst>
          </p:cNvPr>
          <p:cNvCxnSpPr>
            <a:cxnSpLocks/>
          </p:cNvCxnSpPr>
          <p:nvPr/>
        </p:nvCxnSpPr>
        <p:spPr>
          <a:xfrm flipV="1">
            <a:off x="8571068" y="4414049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6" name="Straight Connector 195">
            <a:extLst>
              <a:ext uri="{FF2B5EF4-FFF2-40B4-BE49-F238E27FC236}">
                <a16:creationId xmlns:a16="http://schemas.microsoft.com/office/drawing/2014/main" id="{8CE2E6D8-6CA5-8D47-8DA7-48297A3D1AAC}"/>
              </a:ext>
            </a:extLst>
          </p:cNvPr>
          <p:cNvCxnSpPr>
            <a:cxnSpLocks/>
          </p:cNvCxnSpPr>
          <p:nvPr/>
        </p:nvCxnSpPr>
        <p:spPr>
          <a:xfrm flipV="1">
            <a:off x="8856818" y="4414049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7" name="Straight Connector 196">
            <a:extLst>
              <a:ext uri="{FF2B5EF4-FFF2-40B4-BE49-F238E27FC236}">
                <a16:creationId xmlns:a16="http://schemas.microsoft.com/office/drawing/2014/main" id="{BB0A6096-FB4E-3240-385D-EA1DA7A3D055}"/>
              </a:ext>
            </a:extLst>
          </p:cNvPr>
          <p:cNvCxnSpPr>
            <a:cxnSpLocks/>
          </p:cNvCxnSpPr>
          <p:nvPr/>
        </p:nvCxnSpPr>
        <p:spPr>
          <a:xfrm flipV="1">
            <a:off x="9136218" y="4420399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8" name="Straight Connector 197">
            <a:extLst>
              <a:ext uri="{FF2B5EF4-FFF2-40B4-BE49-F238E27FC236}">
                <a16:creationId xmlns:a16="http://schemas.microsoft.com/office/drawing/2014/main" id="{51CCEFD7-B282-6071-91BC-2D19384A1CDB}"/>
              </a:ext>
            </a:extLst>
          </p:cNvPr>
          <p:cNvCxnSpPr>
            <a:cxnSpLocks/>
          </p:cNvCxnSpPr>
          <p:nvPr/>
        </p:nvCxnSpPr>
        <p:spPr>
          <a:xfrm flipV="1">
            <a:off x="9415618" y="4414049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0D21317C-2369-DE15-DD4E-A58856ABDB60}"/>
              </a:ext>
            </a:extLst>
          </p:cNvPr>
          <p:cNvCxnSpPr>
            <a:cxnSpLocks/>
          </p:cNvCxnSpPr>
          <p:nvPr/>
        </p:nvCxnSpPr>
        <p:spPr>
          <a:xfrm flipV="1">
            <a:off x="9695018" y="4414049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0" name="Straight Connector 199">
            <a:extLst>
              <a:ext uri="{FF2B5EF4-FFF2-40B4-BE49-F238E27FC236}">
                <a16:creationId xmlns:a16="http://schemas.microsoft.com/office/drawing/2014/main" id="{82DD8C03-E3D2-69C7-390F-52E7C94CD5D0}"/>
              </a:ext>
            </a:extLst>
          </p:cNvPr>
          <p:cNvCxnSpPr>
            <a:cxnSpLocks/>
          </p:cNvCxnSpPr>
          <p:nvPr/>
        </p:nvCxnSpPr>
        <p:spPr>
          <a:xfrm flipV="1">
            <a:off x="9974418" y="4414049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1" name="Straight Connector 200">
            <a:extLst>
              <a:ext uri="{FF2B5EF4-FFF2-40B4-BE49-F238E27FC236}">
                <a16:creationId xmlns:a16="http://schemas.microsoft.com/office/drawing/2014/main" id="{5D9A7DAD-2549-C75A-EE88-DF027486CB38}"/>
              </a:ext>
            </a:extLst>
          </p:cNvPr>
          <p:cNvCxnSpPr>
            <a:cxnSpLocks/>
          </p:cNvCxnSpPr>
          <p:nvPr/>
        </p:nvCxnSpPr>
        <p:spPr>
          <a:xfrm flipV="1">
            <a:off x="10253818" y="4414049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2" name="Straight Connector 201">
            <a:extLst>
              <a:ext uri="{FF2B5EF4-FFF2-40B4-BE49-F238E27FC236}">
                <a16:creationId xmlns:a16="http://schemas.microsoft.com/office/drawing/2014/main" id="{00277023-5D63-458C-C20F-9CE28ACD1567}"/>
              </a:ext>
            </a:extLst>
          </p:cNvPr>
          <p:cNvCxnSpPr>
            <a:cxnSpLocks/>
          </p:cNvCxnSpPr>
          <p:nvPr/>
        </p:nvCxnSpPr>
        <p:spPr>
          <a:xfrm flipV="1">
            <a:off x="10539568" y="4414049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3" name="Straight Connector 202">
            <a:extLst>
              <a:ext uri="{FF2B5EF4-FFF2-40B4-BE49-F238E27FC236}">
                <a16:creationId xmlns:a16="http://schemas.microsoft.com/office/drawing/2014/main" id="{025E2AAC-CED2-01F3-39D4-9DD7CE2CBB54}"/>
              </a:ext>
            </a:extLst>
          </p:cNvPr>
          <p:cNvCxnSpPr>
            <a:cxnSpLocks/>
          </p:cNvCxnSpPr>
          <p:nvPr/>
        </p:nvCxnSpPr>
        <p:spPr>
          <a:xfrm flipV="1">
            <a:off x="10818968" y="4414049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4" name="Straight Connector 203">
            <a:extLst>
              <a:ext uri="{FF2B5EF4-FFF2-40B4-BE49-F238E27FC236}">
                <a16:creationId xmlns:a16="http://schemas.microsoft.com/office/drawing/2014/main" id="{FA43CEA3-1A26-E6D5-DC24-88E3EBE99787}"/>
              </a:ext>
            </a:extLst>
          </p:cNvPr>
          <p:cNvCxnSpPr>
            <a:cxnSpLocks/>
          </p:cNvCxnSpPr>
          <p:nvPr/>
        </p:nvCxnSpPr>
        <p:spPr>
          <a:xfrm flipV="1">
            <a:off x="11098368" y="4414049"/>
            <a:ext cx="0" cy="505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800634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AFAFCD1-853C-8228-2781-FA5A872DEB6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Content Placeholder 8">
            <a:extLst>
              <a:ext uri="{FF2B5EF4-FFF2-40B4-BE49-F238E27FC236}">
                <a16:creationId xmlns:a16="http://schemas.microsoft.com/office/drawing/2014/main" id="{BD62B032-FE7D-9CBE-DD5E-E4A2100BDC4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7349" t="43200" r="25903" b="49315"/>
          <a:stretch>
            <a:fillRect/>
          </a:stretch>
        </p:blipFill>
        <p:spPr>
          <a:xfrm>
            <a:off x="9853625" y="3530068"/>
            <a:ext cx="700337" cy="466236"/>
          </a:xfrm>
          <a:prstGeom prst="rect">
            <a:avLst/>
          </a:prstGeom>
        </p:spPr>
      </p:pic>
      <p:pic>
        <p:nvPicPr>
          <p:cNvPr id="22" name="Content Placeholder 8">
            <a:extLst>
              <a:ext uri="{FF2B5EF4-FFF2-40B4-BE49-F238E27FC236}">
                <a16:creationId xmlns:a16="http://schemas.microsoft.com/office/drawing/2014/main" id="{107A1347-E008-A04C-E95B-D04B7F08FA9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7349" t="37859" r="25903" b="53985"/>
          <a:stretch>
            <a:fillRect/>
          </a:stretch>
        </p:blipFill>
        <p:spPr>
          <a:xfrm>
            <a:off x="9853625" y="2983845"/>
            <a:ext cx="700337" cy="508056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8E5361D0-1933-C736-F379-E7FCD128D533}"/>
              </a:ext>
            </a:extLst>
          </p:cNvPr>
          <p:cNvSpPr txBox="1"/>
          <p:nvPr/>
        </p:nvSpPr>
        <p:spPr>
          <a:xfrm>
            <a:off x="10537317" y="3599247"/>
            <a:ext cx="18677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Other pathogens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26681FCD-7C4F-B683-9BE6-26269A7D7545}"/>
              </a:ext>
            </a:extLst>
          </p:cNvPr>
          <p:cNvSpPr/>
          <p:nvPr/>
        </p:nvSpPr>
        <p:spPr>
          <a:xfrm>
            <a:off x="9938522" y="3103433"/>
            <a:ext cx="533400" cy="280553"/>
          </a:xfrm>
          <a:prstGeom prst="rect">
            <a:avLst/>
          </a:prstGeom>
          <a:solidFill>
            <a:srgbClr val="DAD6A2">
              <a:alpha val="48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55482BF-0527-66FF-56BD-DB5FE4BC0131}"/>
              </a:ext>
            </a:extLst>
          </p:cNvPr>
          <p:cNvSpPr/>
          <p:nvPr/>
        </p:nvSpPr>
        <p:spPr>
          <a:xfrm>
            <a:off x="9928771" y="3612860"/>
            <a:ext cx="533400" cy="280553"/>
          </a:xfrm>
          <a:prstGeom prst="rect">
            <a:avLst/>
          </a:prstGeom>
          <a:solidFill>
            <a:srgbClr val="D7E8F1">
              <a:alpha val="47843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1707C4B2-E6BB-69D3-D6CC-CCFC23CB5D25}"/>
              </a:ext>
            </a:extLst>
          </p:cNvPr>
          <p:cNvCxnSpPr>
            <a:cxnSpLocks/>
          </p:cNvCxnSpPr>
          <p:nvPr/>
        </p:nvCxnSpPr>
        <p:spPr>
          <a:xfrm>
            <a:off x="-3101" y="4630185"/>
            <a:ext cx="121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4" name="Content Placeholder 8">
            <a:extLst>
              <a:ext uri="{FF2B5EF4-FFF2-40B4-BE49-F238E27FC236}">
                <a16:creationId xmlns:a16="http://schemas.microsoft.com/office/drawing/2014/main" id="{67B8E14E-29E4-FCE5-AED8-5B1F91348ED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7349" t="43200" r="25903" b="49315"/>
          <a:stretch>
            <a:fillRect/>
          </a:stretch>
        </p:blipFill>
        <p:spPr>
          <a:xfrm>
            <a:off x="9807610" y="1494523"/>
            <a:ext cx="700337" cy="466236"/>
          </a:xfrm>
          <a:prstGeom prst="rect">
            <a:avLst/>
          </a:prstGeom>
        </p:spPr>
      </p:pic>
      <p:pic>
        <p:nvPicPr>
          <p:cNvPr id="6" name="Content Placeholder 8">
            <a:extLst>
              <a:ext uri="{FF2B5EF4-FFF2-40B4-BE49-F238E27FC236}">
                <a16:creationId xmlns:a16="http://schemas.microsoft.com/office/drawing/2014/main" id="{92D908C0-CB01-F2B8-96BC-49052DA450C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7349" t="37859" r="25903" b="53985"/>
          <a:stretch>
            <a:fillRect/>
          </a:stretch>
        </p:blipFill>
        <p:spPr>
          <a:xfrm>
            <a:off x="9799199" y="1048803"/>
            <a:ext cx="700337" cy="50805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C5FE4D8-86AB-9C32-8424-8F22DDE1DACC}"/>
              </a:ext>
            </a:extLst>
          </p:cNvPr>
          <p:cNvSpPr txBox="1"/>
          <p:nvPr/>
        </p:nvSpPr>
        <p:spPr>
          <a:xfrm>
            <a:off x="10446128" y="1124001"/>
            <a:ext cx="1627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teroid exposur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FCC9937-D14E-476B-3A72-3324CFDD985B}"/>
              </a:ext>
            </a:extLst>
          </p:cNvPr>
          <p:cNvSpPr txBox="1"/>
          <p:nvPr/>
        </p:nvSpPr>
        <p:spPr>
          <a:xfrm>
            <a:off x="10430251" y="1569634"/>
            <a:ext cx="21657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o steroid exposure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50E9404B-93B6-1BD7-7C89-E0383743183E}"/>
              </a:ext>
            </a:extLst>
          </p:cNvPr>
          <p:cNvSpPr/>
          <p:nvPr/>
        </p:nvSpPr>
        <p:spPr>
          <a:xfrm>
            <a:off x="9884096" y="1168391"/>
            <a:ext cx="533400" cy="280553"/>
          </a:xfrm>
          <a:prstGeom prst="rect">
            <a:avLst/>
          </a:prstGeom>
          <a:solidFill>
            <a:srgbClr val="DAD6A2">
              <a:alpha val="48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E143A3E-93DB-E26E-FB37-9BF0764A419E}"/>
              </a:ext>
            </a:extLst>
          </p:cNvPr>
          <p:cNvSpPr/>
          <p:nvPr/>
        </p:nvSpPr>
        <p:spPr>
          <a:xfrm>
            <a:off x="9882756" y="1577315"/>
            <a:ext cx="533400" cy="280553"/>
          </a:xfrm>
          <a:prstGeom prst="rect">
            <a:avLst/>
          </a:prstGeom>
          <a:solidFill>
            <a:srgbClr val="D7E8F1">
              <a:alpha val="47843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4179FAC-8C69-BC53-8297-0382FAB0AA68}"/>
              </a:ext>
            </a:extLst>
          </p:cNvPr>
          <p:cNvSpPr txBox="1"/>
          <p:nvPr/>
        </p:nvSpPr>
        <p:spPr>
          <a:xfrm>
            <a:off x="-1" y="-28575"/>
            <a:ext cx="27908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-figure 3</a:t>
            </a:r>
          </a:p>
        </p:txBody>
      </p: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1A131E9C-664D-2C56-87EC-402133F17A66}"/>
              </a:ext>
            </a:extLst>
          </p:cNvPr>
          <p:cNvCxnSpPr>
            <a:cxnSpLocks/>
          </p:cNvCxnSpPr>
          <p:nvPr/>
        </p:nvCxnSpPr>
        <p:spPr>
          <a:xfrm>
            <a:off x="-3101" y="2370091"/>
            <a:ext cx="121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A4AA3CA0-EF3C-95ED-9CBD-6A8632230BE7}"/>
              </a:ext>
            </a:extLst>
          </p:cNvPr>
          <p:cNvSpPr txBox="1"/>
          <p:nvPr/>
        </p:nvSpPr>
        <p:spPr>
          <a:xfrm>
            <a:off x="10568499" y="2999055"/>
            <a:ext cx="131870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Mycoplasma </a:t>
            </a:r>
          </a:p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neumoniae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628E559B-8CFF-0F62-A1A1-9D2747FA7D86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8200" t="3527" r="29601" b="13263"/>
          <a:stretch>
            <a:fillRect/>
          </a:stretch>
        </p:blipFill>
        <p:spPr>
          <a:xfrm>
            <a:off x="7450339" y="4656102"/>
            <a:ext cx="2311495" cy="1858998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6FE08DA6-8A03-7027-C343-677D5B679B1C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8410" t="2682" r="23452" b="13113"/>
          <a:stretch>
            <a:fillRect/>
          </a:stretch>
        </p:blipFill>
        <p:spPr>
          <a:xfrm>
            <a:off x="3919399" y="4656101"/>
            <a:ext cx="2526264" cy="1876778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DF0C4562-C202-02D4-C9CB-9699F8BBE712}"/>
              </a:ext>
            </a:extLst>
          </p:cNvPr>
          <p:cNvSpPr txBox="1"/>
          <p:nvPr/>
        </p:nvSpPr>
        <p:spPr>
          <a:xfrm>
            <a:off x="3500299" y="4571949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84D39CC-86A7-7D45-A884-96CE6493C335}"/>
              </a:ext>
            </a:extLst>
          </p:cNvPr>
          <p:cNvSpPr txBox="1"/>
          <p:nvPr/>
        </p:nvSpPr>
        <p:spPr>
          <a:xfrm>
            <a:off x="7040764" y="4579234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pic>
        <p:nvPicPr>
          <p:cNvPr id="44" name="Content Placeholder 8">
            <a:extLst>
              <a:ext uri="{FF2B5EF4-FFF2-40B4-BE49-F238E27FC236}">
                <a16:creationId xmlns:a16="http://schemas.microsoft.com/office/drawing/2014/main" id="{FAE4E8B9-2F75-D847-C12D-E03F7ACAEA0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7349" t="37859" r="25903" b="53985"/>
          <a:stretch>
            <a:fillRect/>
          </a:stretch>
        </p:blipFill>
        <p:spPr>
          <a:xfrm>
            <a:off x="9853625" y="5169918"/>
            <a:ext cx="700337" cy="508056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8E7F6A3E-6086-BBC1-CC41-3C10926B1ED5}"/>
              </a:ext>
            </a:extLst>
          </p:cNvPr>
          <p:cNvSpPr txBox="1"/>
          <p:nvPr/>
        </p:nvSpPr>
        <p:spPr>
          <a:xfrm>
            <a:off x="10558747" y="5148963"/>
            <a:ext cx="152847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ge </a:t>
            </a:r>
            <a:r>
              <a:rPr lang="en-US" sz="1400" u="sng" dirty="0">
                <a:latin typeface="Arial" panose="020B0604020202020204" pitchFamily="34" charset="0"/>
                <a:cs typeface="Arial" panose="020B0604020202020204" pitchFamily="34" charset="0"/>
              </a:rPr>
              <a:t>&gt;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 years 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t infection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68C863D3-76AF-5619-FC19-4DE73C065DA5}"/>
              </a:ext>
            </a:extLst>
          </p:cNvPr>
          <p:cNvSpPr/>
          <p:nvPr/>
        </p:nvSpPr>
        <p:spPr>
          <a:xfrm>
            <a:off x="9938522" y="5289506"/>
            <a:ext cx="533400" cy="280553"/>
          </a:xfrm>
          <a:prstGeom prst="rect">
            <a:avLst/>
          </a:prstGeom>
          <a:solidFill>
            <a:srgbClr val="DAD6A2">
              <a:alpha val="48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Content Placeholder 8">
            <a:extLst>
              <a:ext uri="{FF2B5EF4-FFF2-40B4-BE49-F238E27FC236}">
                <a16:creationId xmlns:a16="http://schemas.microsoft.com/office/drawing/2014/main" id="{5C1C41D4-2440-3C46-D6DB-057559EE401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7349" t="43200" r="25903" b="49315"/>
          <a:stretch>
            <a:fillRect/>
          </a:stretch>
        </p:blipFill>
        <p:spPr>
          <a:xfrm>
            <a:off x="9853625" y="5654678"/>
            <a:ext cx="700337" cy="466236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7FCC902E-B0E8-3574-D0E6-9AAE4DA04776}"/>
              </a:ext>
            </a:extLst>
          </p:cNvPr>
          <p:cNvSpPr txBox="1"/>
          <p:nvPr/>
        </p:nvSpPr>
        <p:spPr>
          <a:xfrm>
            <a:off x="10583922" y="5640412"/>
            <a:ext cx="262298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ge &lt;5 years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t infection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3F55F5AC-F29D-089E-18D4-61D8CE5E1AAB}"/>
              </a:ext>
            </a:extLst>
          </p:cNvPr>
          <p:cNvSpPr/>
          <p:nvPr/>
        </p:nvSpPr>
        <p:spPr>
          <a:xfrm>
            <a:off x="9928771" y="5737470"/>
            <a:ext cx="533400" cy="280553"/>
          </a:xfrm>
          <a:prstGeom prst="rect">
            <a:avLst/>
          </a:prstGeom>
          <a:solidFill>
            <a:srgbClr val="D7E8F1">
              <a:alpha val="47843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8" name="Group 207">
            <a:extLst>
              <a:ext uri="{FF2B5EF4-FFF2-40B4-BE49-F238E27FC236}">
                <a16:creationId xmlns:a16="http://schemas.microsoft.com/office/drawing/2014/main" id="{500F98AD-C6B6-443C-575D-08DDB5F05D4A}"/>
              </a:ext>
            </a:extLst>
          </p:cNvPr>
          <p:cNvGrpSpPr/>
          <p:nvPr/>
        </p:nvGrpSpPr>
        <p:grpSpPr>
          <a:xfrm>
            <a:off x="3536621" y="205464"/>
            <a:ext cx="2838711" cy="2206639"/>
            <a:chOff x="3465440" y="200952"/>
            <a:chExt cx="2838711" cy="2206639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F9540C7-7009-599B-E806-CC90A6F103B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l="8225" t="2084" r="26261" b="13438"/>
            <a:stretch>
              <a:fillRect/>
            </a:stretch>
          </p:blipFill>
          <p:spPr>
            <a:xfrm>
              <a:off x="3850851" y="309023"/>
              <a:ext cx="2329121" cy="1805480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2637DD0-ED89-41D2-6BB0-A330D29EBC3C}"/>
                </a:ext>
              </a:extLst>
            </p:cNvPr>
            <p:cNvSpPr txBox="1"/>
            <p:nvPr/>
          </p:nvSpPr>
          <p:spPr>
            <a:xfrm>
              <a:off x="3465440" y="200952"/>
              <a:ext cx="381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4A4D2702-C009-16EF-EE45-73F3247C9A50}"/>
                </a:ext>
              </a:extLst>
            </p:cNvPr>
            <p:cNvSpPr txBox="1"/>
            <p:nvPr/>
          </p:nvSpPr>
          <p:spPr>
            <a:xfrm rot="16200000">
              <a:off x="3111954" y="1010092"/>
              <a:ext cx="10198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VC (z-score)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0DA307BF-EDB3-86EF-5D41-EE748CF473BD}"/>
                </a:ext>
              </a:extLst>
            </p:cNvPr>
            <p:cNvSpPr txBox="1"/>
            <p:nvPr/>
          </p:nvSpPr>
          <p:spPr>
            <a:xfrm>
              <a:off x="3818445" y="2052849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8CBD2BB8-3CF5-3480-0290-203778E6D694}"/>
                </a:ext>
              </a:extLst>
            </p:cNvPr>
            <p:cNvSpPr txBox="1"/>
            <p:nvPr/>
          </p:nvSpPr>
          <p:spPr>
            <a:xfrm>
              <a:off x="4054203" y="2052849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C00C3EA0-7446-D833-CF21-9B19ACF5E832}"/>
                </a:ext>
              </a:extLst>
            </p:cNvPr>
            <p:cNvSpPr txBox="1"/>
            <p:nvPr/>
          </p:nvSpPr>
          <p:spPr>
            <a:xfrm>
              <a:off x="4291367" y="2043192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0B2C9F7D-E145-B0B9-8B80-C46DD48ACDD0}"/>
                </a:ext>
              </a:extLst>
            </p:cNvPr>
            <p:cNvSpPr txBox="1"/>
            <p:nvPr/>
          </p:nvSpPr>
          <p:spPr>
            <a:xfrm>
              <a:off x="4527125" y="2043192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A71F4448-94FE-D953-E022-B09957804288}"/>
                </a:ext>
              </a:extLst>
            </p:cNvPr>
            <p:cNvSpPr txBox="1"/>
            <p:nvPr/>
          </p:nvSpPr>
          <p:spPr>
            <a:xfrm>
              <a:off x="4764289" y="2043192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C94E3471-7C6F-473E-464D-432F11A9A6A1}"/>
                </a:ext>
              </a:extLst>
            </p:cNvPr>
            <p:cNvSpPr txBox="1"/>
            <p:nvPr/>
          </p:nvSpPr>
          <p:spPr>
            <a:xfrm>
              <a:off x="4969567" y="2043192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360DAB5F-8D98-E005-0450-FD84816DA6B9}"/>
                </a:ext>
              </a:extLst>
            </p:cNvPr>
            <p:cNvSpPr txBox="1"/>
            <p:nvPr/>
          </p:nvSpPr>
          <p:spPr>
            <a:xfrm>
              <a:off x="5206075" y="2043991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1AA01CDB-0A44-31DB-2DB5-313077A58FE8}"/>
                </a:ext>
              </a:extLst>
            </p:cNvPr>
            <p:cNvSpPr txBox="1"/>
            <p:nvPr/>
          </p:nvSpPr>
          <p:spPr>
            <a:xfrm>
              <a:off x="5442583" y="2046654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C018737F-E56E-938A-691F-C63CFD3CC303}"/>
                </a:ext>
              </a:extLst>
            </p:cNvPr>
            <p:cNvSpPr txBox="1"/>
            <p:nvPr/>
          </p:nvSpPr>
          <p:spPr>
            <a:xfrm>
              <a:off x="5679091" y="2047453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3BFABF2E-4DD4-4DAB-8E67-B79C3D00FCAB}"/>
                </a:ext>
              </a:extLst>
            </p:cNvPr>
            <p:cNvSpPr txBox="1"/>
            <p:nvPr/>
          </p:nvSpPr>
          <p:spPr>
            <a:xfrm>
              <a:off x="5924111" y="2052849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35B7DB0B-3A2D-B3FE-F95F-D9E9FC8F9197}"/>
                </a:ext>
              </a:extLst>
            </p:cNvPr>
            <p:cNvSpPr txBox="1"/>
            <p:nvPr/>
          </p:nvSpPr>
          <p:spPr>
            <a:xfrm>
              <a:off x="4054203" y="2161370"/>
              <a:ext cx="19400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 since infection (years)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FE160870-F3AD-CF70-FE3D-1326B5F6A2EA}"/>
                </a:ext>
              </a:extLst>
            </p:cNvPr>
            <p:cNvSpPr txBox="1"/>
            <p:nvPr/>
          </p:nvSpPr>
          <p:spPr>
            <a:xfrm>
              <a:off x="3650437" y="263836"/>
              <a:ext cx="274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726338DC-C341-544F-B711-E0E696266452}"/>
                </a:ext>
              </a:extLst>
            </p:cNvPr>
            <p:cNvSpPr txBox="1"/>
            <p:nvPr/>
          </p:nvSpPr>
          <p:spPr>
            <a:xfrm>
              <a:off x="3656966" y="593432"/>
              <a:ext cx="274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A3F8246B-18F8-9D1B-BF3B-B00AA0D0E049}"/>
                </a:ext>
              </a:extLst>
            </p:cNvPr>
            <p:cNvSpPr txBox="1"/>
            <p:nvPr/>
          </p:nvSpPr>
          <p:spPr>
            <a:xfrm>
              <a:off x="3647718" y="921705"/>
              <a:ext cx="274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792C6D47-5B1B-C5CF-D0ED-F8A40527B1C3}"/>
                </a:ext>
              </a:extLst>
            </p:cNvPr>
            <p:cNvSpPr txBox="1"/>
            <p:nvPr/>
          </p:nvSpPr>
          <p:spPr>
            <a:xfrm>
              <a:off x="3612399" y="1251301"/>
              <a:ext cx="3161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D1AAD82D-F6CC-D07D-3AF4-2C7349007E24}"/>
                </a:ext>
              </a:extLst>
            </p:cNvPr>
            <p:cNvSpPr txBox="1"/>
            <p:nvPr/>
          </p:nvSpPr>
          <p:spPr>
            <a:xfrm>
              <a:off x="3614631" y="1587612"/>
              <a:ext cx="3096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D7AEB392-DA8F-C832-C5D6-2496D97545EE}"/>
                </a:ext>
              </a:extLst>
            </p:cNvPr>
            <p:cNvSpPr txBox="1"/>
            <p:nvPr/>
          </p:nvSpPr>
          <p:spPr>
            <a:xfrm>
              <a:off x="3614630" y="1917208"/>
              <a:ext cx="3161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6</a:t>
              </a:r>
            </a:p>
          </p:txBody>
        </p:sp>
      </p:grpSp>
      <p:grpSp>
        <p:nvGrpSpPr>
          <p:cNvPr id="210" name="Group 209">
            <a:extLst>
              <a:ext uri="{FF2B5EF4-FFF2-40B4-BE49-F238E27FC236}">
                <a16:creationId xmlns:a16="http://schemas.microsoft.com/office/drawing/2014/main" id="{59B5E0FE-ED11-4A01-29E6-513C9B8EF753}"/>
              </a:ext>
            </a:extLst>
          </p:cNvPr>
          <p:cNvGrpSpPr/>
          <p:nvPr/>
        </p:nvGrpSpPr>
        <p:grpSpPr>
          <a:xfrm>
            <a:off x="7018539" y="200952"/>
            <a:ext cx="2644510" cy="2199572"/>
            <a:chOff x="7018539" y="200952"/>
            <a:chExt cx="2644510" cy="2199572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AFDC2C2B-47FC-5430-28B2-BE72955F00E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l="8354" t="3055" r="32800" b="12754"/>
            <a:stretch>
              <a:fillRect/>
            </a:stretch>
          </p:blipFill>
          <p:spPr>
            <a:xfrm>
              <a:off x="7399539" y="350752"/>
              <a:ext cx="2119297" cy="1770429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621ED8A-104F-B683-F344-52DB15BEF614}"/>
                </a:ext>
              </a:extLst>
            </p:cNvPr>
            <p:cNvSpPr txBox="1"/>
            <p:nvPr/>
          </p:nvSpPr>
          <p:spPr>
            <a:xfrm>
              <a:off x="7018539" y="200952"/>
              <a:ext cx="381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D4B388F1-1111-ADA0-AA1F-FD0276C69BE9}"/>
                </a:ext>
              </a:extLst>
            </p:cNvPr>
            <p:cNvSpPr txBox="1"/>
            <p:nvPr/>
          </p:nvSpPr>
          <p:spPr>
            <a:xfrm>
              <a:off x="7348793" y="2048164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A450F918-9C86-EDCA-F316-D0FC08AA880C}"/>
                </a:ext>
              </a:extLst>
            </p:cNvPr>
            <p:cNvSpPr txBox="1"/>
            <p:nvPr/>
          </p:nvSpPr>
          <p:spPr>
            <a:xfrm>
              <a:off x="7569311" y="2048164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077504E0-8184-36B5-CB5F-5DFD82656B15}"/>
                </a:ext>
              </a:extLst>
            </p:cNvPr>
            <p:cNvSpPr txBox="1"/>
            <p:nvPr/>
          </p:nvSpPr>
          <p:spPr>
            <a:xfrm>
              <a:off x="7787425" y="2038507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12E27D34-48C7-5454-1AF0-E3681DEA82B4}"/>
                </a:ext>
              </a:extLst>
            </p:cNvPr>
            <p:cNvSpPr txBox="1"/>
            <p:nvPr/>
          </p:nvSpPr>
          <p:spPr>
            <a:xfrm>
              <a:off x="8007943" y="2038507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F70D9924-E910-F51A-4773-6999B27B6D51}"/>
                </a:ext>
              </a:extLst>
            </p:cNvPr>
            <p:cNvSpPr txBox="1"/>
            <p:nvPr/>
          </p:nvSpPr>
          <p:spPr>
            <a:xfrm>
              <a:off x="8224152" y="2038507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832DB14D-9C85-768C-A6E0-1FF3CED26636}"/>
                </a:ext>
              </a:extLst>
            </p:cNvPr>
            <p:cNvSpPr txBox="1"/>
            <p:nvPr/>
          </p:nvSpPr>
          <p:spPr>
            <a:xfrm>
              <a:off x="8412285" y="2038507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4B3538C5-4E99-9B6A-8264-4A29768C94B2}"/>
                </a:ext>
              </a:extLst>
            </p:cNvPr>
            <p:cNvSpPr txBox="1"/>
            <p:nvPr/>
          </p:nvSpPr>
          <p:spPr>
            <a:xfrm>
              <a:off x="8625933" y="2039306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B84BFDFD-954E-E75A-BCE9-E5667D2F371F}"/>
                </a:ext>
              </a:extLst>
            </p:cNvPr>
            <p:cNvSpPr txBox="1"/>
            <p:nvPr/>
          </p:nvSpPr>
          <p:spPr>
            <a:xfrm>
              <a:off x="8849106" y="2041969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2156250C-648A-72EA-D09E-47A1CB3E24E1}"/>
                </a:ext>
              </a:extLst>
            </p:cNvPr>
            <p:cNvSpPr txBox="1"/>
            <p:nvPr/>
          </p:nvSpPr>
          <p:spPr>
            <a:xfrm>
              <a:off x="9066564" y="2042768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28169ED9-50AC-E0C2-6AAA-0B6F826F5622}"/>
                </a:ext>
              </a:extLst>
            </p:cNvPr>
            <p:cNvSpPr txBox="1"/>
            <p:nvPr/>
          </p:nvSpPr>
          <p:spPr>
            <a:xfrm>
              <a:off x="9283009" y="2048164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A186ED3D-F4BF-AF25-2171-BAFF56B99F6E}"/>
                </a:ext>
              </a:extLst>
            </p:cNvPr>
            <p:cNvSpPr txBox="1"/>
            <p:nvPr/>
          </p:nvSpPr>
          <p:spPr>
            <a:xfrm>
              <a:off x="7584551" y="2154303"/>
              <a:ext cx="19400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 since infection (years)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C787D184-7B8A-F28C-3702-BB4180EDDB00}"/>
                </a:ext>
              </a:extLst>
            </p:cNvPr>
            <p:cNvSpPr txBox="1"/>
            <p:nvPr/>
          </p:nvSpPr>
          <p:spPr>
            <a:xfrm rot="16200000">
              <a:off x="6489905" y="1079792"/>
              <a:ext cx="137710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EV1/FVC (z-score)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52A05C08-9651-F7BD-5899-7668478FA214}"/>
                </a:ext>
              </a:extLst>
            </p:cNvPr>
            <p:cNvSpPr txBox="1"/>
            <p:nvPr/>
          </p:nvSpPr>
          <p:spPr>
            <a:xfrm>
              <a:off x="7205780" y="287340"/>
              <a:ext cx="274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CAD4190E-3153-AF89-33B3-C920C55059EE}"/>
                </a:ext>
              </a:extLst>
            </p:cNvPr>
            <p:cNvSpPr txBox="1"/>
            <p:nvPr/>
          </p:nvSpPr>
          <p:spPr>
            <a:xfrm>
              <a:off x="7170461" y="689326"/>
              <a:ext cx="3161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14F37D63-935B-1F03-6BD7-6EDAFC087991}"/>
                </a:ext>
              </a:extLst>
            </p:cNvPr>
            <p:cNvSpPr txBox="1"/>
            <p:nvPr/>
          </p:nvSpPr>
          <p:spPr>
            <a:xfrm>
              <a:off x="7172693" y="1098027"/>
              <a:ext cx="3096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394CCE4B-A244-09DD-30B9-80C5A6772296}"/>
                </a:ext>
              </a:extLst>
            </p:cNvPr>
            <p:cNvSpPr txBox="1"/>
            <p:nvPr/>
          </p:nvSpPr>
          <p:spPr>
            <a:xfrm>
              <a:off x="7172692" y="1503823"/>
              <a:ext cx="3161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6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0FE542C4-F779-3878-AA60-4CB5EA8872F5}"/>
                </a:ext>
              </a:extLst>
            </p:cNvPr>
            <p:cNvSpPr txBox="1"/>
            <p:nvPr/>
          </p:nvSpPr>
          <p:spPr>
            <a:xfrm>
              <a:off x="7170787" y="1909588"/>
              <a:ext cx="3161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8</a:t>
              </a:r>
            </a:p>
          </p:txBody>
        </p:sp>
      </p:grpSp>
      <p:grpSp>
        <p:nvGrpSpPr>
          <p:cNvPr id="209" name="Group 208">
            <a:extLst>
              <a:ext uri="{FF2B5EF4-FFF2-40B4-BE49-F238E27FC236}">
                <a16:creationId xmlns:a16="http://schemas.microsoft.com/office/drawing/2014/main" id="{D995959E-D684-521D-C002-2D820E519437}"/>
              </a:ext>
            </a:extLst>
          </p:cNvPr>
          <p:cNvGrpSpPr/>
          <p:nvPr/>
        </p:nvGrpSpPr>
        <p:grpSpPr>
          <a:xfrm>
            <a:off x="3006" y="200959"/>
            <a:ext cx="2794802" cy="2215369"/>
            <a:chOff x="75430" y="200952"/>
            <a:chExt cx="2794802" cy="221536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2D8E5928-A534-8193-EC9B-1D427F92797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rcRect l="8424" t="2495" r="27349" b="13195"/>
            <a:stretch>
              <a:fillRect/>
            </a:stretch>
          </p:blipFill>
          <p:spPr>
            <a:xfrm>
              <a:off x="431014" y="296857"/>
              <a:ext cx="2311803" cy="1824326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F488109-6B4C-279A-94B5-83E1C397635C}"/>
                </a:ext>
              </a:extLst>
            </p:cNvPr>
            <p:cNvSpPr txBox="1"/>
            <p:nvPr/>
          </p:nvSpPr>
          <p:spPr>
            <a:xfrm>
              <a:off x="75430" y="200952"/>
              <a:ext cx="381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5360FBAE-429F-4A02-A991-177BC5251BD4}"/>
                </a:ext>
              </a:extLst>
            </p:cNvPr>
            <p:cNvSpPr txBox="1"/>
            <p:nvPr/>
          </p:nvSpPr>
          <p:spPr>
            <a:xfrm rot="16200000">
              <a:off x="-344902" y="1038200"/>
              <a:ext cx="11224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EV1 (z-score)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D9FC6178-16B1-FFA0-EEF7-C4A598A5A08E}"/>
                </a:ext>
              </a:extLst>
            </p:cNvPr>
            <p:cNvSpPr txBox="1"/>
            <p:nvPr/>
          </p:nvSpPr>
          <p:spPr>
            <a:xfrm>
              <a:off x="225813" y="248257"/>
              <a:ext cx="2985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2D75DBC6-FE50-7621-B2C0-352B71C98F69}"/>
                </a:ext>
              </a:extLst>
            </p:cNvPr>
            <p:cNvSpPr txBox="1"/>
            <p:nvPr/>
          </p:nvSpPr>
          <p:spPr>
            <a:xfrm>
              <a:off x="225813" y="662983"/>
              <a:ext cx="2985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E6EC059A-3E36-F004-A4E2-BBD7A135099B}"/>
                </a:ext>
              </a:extLst>
            </p:cNvPr>
            <p:cNvSpPr txBox="1"/>
            <p:nvPr/>
          </p:nvSpPr>
          <p:spPr>
            <a:xfrm>
              <a:off x="225813" y="1069295"/>
              <a:ext cx="2985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3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F535263E-A876-B8C1-D860-86AE5197FA5E}"/>
                </a:ext>
              </a:extLst>
            </p:cNvPr>
            <p:cNvSpPr txBox="1"/>
            <p:nvPr/>
          </p:nvSpPr>
          <p:spPr>
            <a:xfrm>
              <a:off x="225813" y="1476443"/>
              <a:ext cx="2985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A2632503-AA40-D706-5255-627EA4559DA2}"/>
                </a:ext>
              </a:extLst>
            </p:cNvPr>
            <p:cNvSpPr txBox="1"/>
            <p:nvPr/>
          </p:nvSpPr>
          <p:spPr>
            <a:xfrm>
              <a:off x="225813" y="1872683"/>
              <a:ext cx="2985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A40AA4E6-8EA8-DDD2-482E-8359CC70B695}"/>
                </a:ext>
              </a:extLst>
            </p:cNvPr>
            <p:cNvSpPr txBox="1"/>
            <p:nvPr/>
          </p:nvSpPr>
          <p:spPr>
            <a:xfrm>
              <a:off x="384526" y="2051988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81838E8A-AD79-AF5B-B908-64985C3CF851}"/>
                </a:ext>
              </a:extLst>
            </p:cNvPr>
            <p:cNvSpPr txBox="1"/>
            <p:nvPr/>
          </p:nvSpPr>
          <p:spPr>
            <a:xfrm>
              <a:off x="620284" y="2051988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F66A931F-96D2-7DC4-13A0-ACBAF3C3CB6B}"/>
                </a:ext>
              </a:extLst>
            </p:cNvPr>
            <p:cNvSpPr txBox="1"/>
            <p:nvPr/>
          </p:nvSpPr>
          <p:spPr>
            <a:xfrm>
              <a:off x="857448" y="2051988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43EBDE2-E7BE-28C4-2790-97ED72E1A057}"/>
                </a:ext>
              </a:extLst>
            </p:cNvPr>
            <p:cNvSpPr txBox="1"/>
            <p:nvPr/>
          </p:nvSpPr>
          <p:spPr>
            <a:xfrm>
              <a:off x="1093206" y="2051988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67B56581-BBE0-7D4C-3D28-25CD9865AFCD}"/>
                </a:ext>
              </a:extLst>
            </p:cNvPr>
            <p:cNvSpPr txBox="1"/>
            <p:nvPr/>
          </p:nvSpPr>
          <p:spPr>
            <a:xfrm>
              <a:off x="1330370" y="2051988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AE0C89A0-4654-3C4F-0A59-C871DAA9A642}"/>
                </a:ext>
              </a:extLst>
            </p:cNvPr>
            <p:cNvSpPr txBox="1"/>
            <p:nvPr/>
          </p:nvSpPr>
          <p:spPr>
            <a:xfrm>
              <a:off x="1535648" y="2051988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96483C02-CB80-BCED-494C-66C62188F784}"/>
                </a:ext>
              </a:extLst>
            </p:cNvPr>
            <p:cNvSpPr txBox="1"/>
            <p:nvPr/>
          </p:nvSpPr>
          <p:spPr>
            <a:xfrm>
              <a:off x="1772156" y="2051988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6B9613D2-2EB0-5A74-BCA8-6E6B8F650DAC}"/>
                </a:ext>
              </a:extLst>
            </p:cNvPr>
            <p:cNvSpPr txBox="1"/>
            <p:nvPr/>
          </p:nvSpPr>
          <p:spPr>
            <a:xfrm>
              <a:off x="2008664" y="2051988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A064DAB4-1D6B-E073-4D85-41D1842168E6}"/>
                </a:ext>
              </a:extLst>
            </p:cNvPr>
            <p:cNvSpPr txBox="1"/>
            <p:nvPr/>
          </p:nvSpPr>
          <p:spPr>
            <a:xfrm>
              <a:off x="2245172" y="2051988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10045B03-71BA-5B64-38CD-44CF70B4CF19}"/>
                </a:ext>
              </a:extLst>
            </p:cNvPr>
            <p:cNvSpPr txBox="1"/>
            <p:nvPr/>
          </p:nvSpPr>
          <p:spPr>
            <a:xfrm>
              <a:off x="2490192" y="2051988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D84ED809-1338-575D-ECF2-314ED65BE3F1}"/>
                </a:ext>
              </a:extLst>
            </p:cNvPr>
            <p:cNvSpPr txBox="1"/>
            <p:nvPr/>
          </p:nvSpPr>
          <p:spPr>
            <a:xfrm>
              <a:off x="620284" y="2170100"/>
              <a:ext cx="19400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 since infection (years)</a:t>
              </a:r>
            </a:p>
          </p:txBody>
        </p:sp>
      </p:grpSp>
      <p:grpSp>
        <p:nvGrpSpPr>
          <p:cNvPr id="211" name="Group 210">
            <a:extLst>
              <a:ext uri="{FF2B5EF4-FFF2-40B4-BE49-F238E27FC236}">
                <a16:creationId xmlns:a16="http://schemas.microsoft.com/office/drawing/2014/main" id="{A94C5139-5C42-128A-5632-6E37FB5820A5}"/>
              </a:ext>
            </a:extLst>
          </p:cNvPr>
          <p:cNvGrpSpPr/>
          <p:nvPr/>
        </p:nvGrpSpPr>
        <p:grpSpPr>
          <a:xfrm>
            <a:off x="-14105" y="2332977"/>
            <a:ext cx="2851317" cy="2326321"/>
            <a:chOff x="-14105" y="2332977"/>
            <a:chExt cx="2851317" cy="2326321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BEEB7499-4CF7-F4AA-BBC7-70FEDE77606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rcRect l="8682" t="4107" r="32550" b="12622"/>
            <a:stretch>
              <a:fillRect/>
            </a:stretch>
          </p:blipFill>
          <p:spPr>
            <a:xfrm>
              <a:off x="384525" y="2409567"/>
              <a:ext cx="2315789" cy="1972606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2C4148C-8342-87B2-E045-BAEA16BBB889}"/>
                </a:ext>
              </a:extLst>
            </p:cNvPr>
            <p:cNvSpPr txBox="1"/>
            <p:nvPr/>
          </p:nvSpPr>
          <p:spPr>
            <a:xfrm>
              <a:off x="-14105" y="2332977"/>
              <a:ext cx="381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6C35DDC7-A23A-17C9-C042-0B8CFB81C571}"/>
                </a:ext>
              </a:extLst>
            </p:cNvPr>
            <p:cNvSpPr txBox="1"/>
            <p:nvPr/>
          </p:nvSpPr>
          <p:spPr>
            <a:xfrm>
              <a:off x="333726" y="4296078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673B598B-03A6-EEA4-9382-D868D9499AEC}"/>
                </a:ext>
              </a:extLst>
            </p:cNvPr>
            <p:cNvSpPr txBox="1"/>
            <p:nvPr/>
          </p:nvSpPr>
          <p:spPr>
            <a:xfrm>
              <a:off x="569484" y="4296078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9949F62A-810E-FB65-AD2D-20F694704DDB}"/>
                </a:ext>
              </a:extLst>
            </p:cNvPr>
            <p:cNvSpPr txBox="1"/>
            <p:nvPr/>
          </p:nvSpPr>
          <p:spPr>
            <a:xfrm>
              <a:off x="806648" y="4296078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4EA4D00F-3E38-7BC4-0B22-3E803F03DEBB}"/>
                </a:ext>
              </a:extLst>
            </p:cNvPr>
            <p:cNvSpPr txBox="1"/>
            <p:nvPr/>
          </p:nvSpPr>
          <p:spPr>
            <a:xfrm>
              <a:off x="1050026" y="4296078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F430DC61-27E4-CDAD-A52C-278C4860B01F}"/>
                </a:ext>
              </a:extLst>
            </p:cNvPr>
            <p:cNvSpPr txBox="1"/>
            <p:nvPr/>
          </p:nvSpPr>
          <p:spPr>
            <a:xfrm>
              <a:off x="1289730" y="4296078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68347097-B2A5-5D2A-D591-608F6C1393EE}"/>
                </a:ext>
              </a:extLst>
            </p:cNvPr>
            <p:cNvSpPr txBox="1"/>
            <p:nvPr/>
          </p:nvSpPr>
          <p:spPr>
            <a:xfrm>
              <a:off x="1497548" y="4296078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3576727A-8307-1635-1ACF-654BE0075FEB}"/>
                </a:ext>
              </a:extLst>
            </p:cNvPr>
            <p:cNvSpPr txBox="1"/>
            <p:nvPr/>
          </p:nvSpPr>
          <p:spPr>
            <a:xfrm>
              <a:off x="1736596" y="4296078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4D367CD0-F02F-4ED6-5F2E-B112EA948FC7}"/>
                </a:ext>
              </a:extLst>
            </p:cNvPr>
            <p:cNvSpPr txBox="1"/>
            <p:nvPr/>
          </p:nvSpPr>
          <p:spPr>
            <a:xfrm>
              <a:off x="1978184" y="4296078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B820E2A2-C550-C7D6-B1A3-825A810048ED}"/>
                </a:ext>
              </a:extLst>
            </p:cNvPr>
            <p:cNvSpPr txBox="1"/>
            <p:nvPr/>
          </p:nvSpPr>
          <p:spPr>
            <a:xfrm>
              <a:off x="2219772" y="4296078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35E440E0-C6A5-9457-00D3-1EBDD6D51637}"/>
                </a:ext>
              </a:extLst>
            </p:cNvPr>
            <p:cNvSpPr txBox="1"/>
            <p:nvPr/>
          </p:nvSpPr>
          <p:spPr>
            <a:xfrm>
              <a:off x="2457172" y="4296078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30CC0F76-1B56-F82D-CC99-5AE1F961A2A4}"/>
                </a:ext>
              </a:extLst>
            </p:cNvPr>
            <p:cNvSpPr txBox="1"/>
            <p:nvPr/>
          </p:nvSpPr>
          <p:spPr>
            <a:xfrm>
              <a:off x="569484" y="4413077"/>
              <a:ext cx="19400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 since infection (years)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9C8D2FD4-65A8-8E10-A33C-B7D67B9857FC}"/>
                </a:ext>
              </a:extLst>
            </p:cNvPr>
            <p:cNvSpPr txBox="1"/>
            <p:nvPr/>
          </p:nvSpPr>
          <p:spPr>
            <a:xfrm rot="16200000">
              <a:off x="-435214" y="3154195"/>
              <a:ext cx="11634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EV1 (z-score)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CE7622B3-ACF0-3FA4-8DE7-676D519D2788}"/>
                </a:ext>
              </a:extLst>
            </p:cNvPr>
            <p:cNvSpPr txBox="1"/>
            <p:nvPr/>
          </p:nvSpPr>
          <p:spPr>
            <a:xfrm>
              <a:off x="157007" y="2430978"/>
              <a:ext cx="2985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79CF793E-8676-A533-0504-C5EE4C46B504}"/>
                </a:ext>
              </a:extLst>
            </p:cNvPr>
            <p:cNvSpPr txBox="1"/>
            <p:nvPr/>
          </p:nvSpPr>
          <p:spPr>
            <a:xfrm>
              <a:off x="157007" y="2943903"/>
              <a:ext cx="2985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3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51876578-C797-B682-3F4E-E280A0E6FEE1}"/>
                </a:ext>
              </a:extLst>
            </p:cNvPr>
            <p:cNvSpPr txBox="1"/>
            <p:nvPr/>
          </p:nvSpPr>
          <p:spPr>
            <a:xfrm>
              <a:off x="157007" y="3455674"/>
              <a:ext cx="2985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F1281D25-F8A7-6F4E-64DC-A098E767BE1F}"/>
                </a:ext>
              </a:extLst>
            </p:cNvPr>
            <p:cNvSpPr txBox="1"/>
            <p:nvPr/>
          </p:nvSpPr>
          <p:spPr>
            <a:xfrm>
              <a:off x="157007" y="3971258"/>
              <a:ext cx="2985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</p:grpSp>
      <p:grpSp>
        <p:nvGrpSpPr>
          <p:cNvPr id="213" name="Group 212">
            <a:extLst>
              <a:ext uri="{FF2B5EF4-FFF2-40B4-BE49-F238E27FC236}">
                <a16:creationId xmlns:a16="http://schemas.microsoft.com/office/drawing/2014/main" id="{6ABFDC0E-51E4-8106-8E23-664E90F7EF3E}"/>
              </a:ext>
            </a:extLst>
          </p:cNvPr>
          <p:cNvGrpSpPr/>
          <p:nvPr/>
        </p:nvGrpSpPr>
        <p:grpSpPr>
          <a:xfrm>
            <a:off x="3560016" y="2340102"/>
            <a:ext cx="2839412" cy="2314293"/>
            <a:chOff x="3507919" y="2341515"/>
            <a:chExt cx="2839412" cy="2314293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AFA84984-1646-4936-27A4-E9D8F1DBDF3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rcRect l="7861" t="2500" r="31513" b="12925"/>
            <a:stretch>
              <a:fillRect/>
            </a:stretch>
          </p:blipFill>
          <p:spPr>
            <a:xfrm>
              <a:off x="3850851" y="2387863"/>
              <a:ext cx="2357679" cy="1977209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ECE3E2F-CD2A-0207-98F3-F2AE5D258FC8}"/>
                </a:ext>
              </a:extLst>
            </p:cNvPr>
            <p:cNvSpPr txBox="1"/>
            <p:nvPr/>
          </p:nvSpPr>
          <p:spPr>
            <a:xfrm>
              <a:off x="3507919" y="2341515"/>
              <a:ext cx="381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9F6B6F8A-FCAB-4F5C-7233-A7025013B95B}"/>
                </a:ext>
              </a:extLst>
            </p:cNvPr>
            <p:cNvSpPr txBox="1"/>
            <p:nvPr/>
          </p:nvSpPr>
          <p:spPr>
            <a:xfrm rot="16200000">
              <a:off x="3136416" y="3178364"/>
              <a:ext cx="10198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VC (z-score)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BFA338A3-AB97-6CE8-526A-6D419FD63FB4}"/>
                </a:ext>
              </a:extLst>
            </p:cNvPr>
            <p:cNvSpPr txBox="1"/>
            <p:nvPr/>
          </p:nvSpPr>
          <p:spPr>
            <a:xfrm>
              <a:off x="3831145" y="4291701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482420BB-6554-0335-6C4F-876508EF15C0}"/>
                </a:ext>
              </a:extLst>
            </p:cNvPr>
            <p:cNvSpPr txBox="1"/>
            <p:nvPr/>
          </p:nvSpPr>
          <p:spPr>
            <a:xfrm>
              <a:off x="4074523" y="4291701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8F3E812A-8CF6-BF3A-B7E5-000ADB4F4DF4}"/>
                </a:ext>
              </a:extLst>
            </p:cNvPr>
            <p:cNvSpPr txBox="1"/>
            <p:nvPr/>
          </p:nvSpPr>
          <p:spPr>
            <a:xfrm>
              <a:off x="4311687" y="4291701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138F4324-BF10-7E55-9851-3A58B0F5A340}"/>
                </a:ext>
              </a:extLst>
            </p:cNvPr>
            <p:cNvSpPr txBox="1"/>
            <p:nvPr/>
          </p:nvSpPr>
          <p:spPr>
            <a:xfrm>
              <a:off x="4555065" y="4291701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398D7AD1-602E-6AAA-5E44-6A929C8E9CB1}"/>
                </a:ext>
              </a:extLst>
            </p:cNvPr>
            <p:cNvSpPr txBox="1"/>
            <p:nvPr/>
          </p:nvSpPr>
          <p:spPr>
            <a:xfrm>
              <a:off x="4794769" y="4291701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D966B2CD-A2C1-94E2-449D-4150B1A515B8}"/>
                </a:ext>
              </a:extLst>
            </p:cNvPr>
            <p:cNvSpPr txBox="1"/>
            <p:nvPr/>
          </p:nvSpPr>
          <p:spPr>
            <a:xfrm>
              <a:off x="5002587" y="4291701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892C7EAE-CB81-877E-4476-89931A00C474}"/>
                </a:ext>
              </a:extLst>
            </p:cNvPr>
            <p:cNvSpPr txBox="1"/>
            <p:nvPr/>
          </p:nvSpPr>
          <p:spPr>
            <a:xfrm>
              <a:off x="5246715" y="4291701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A98971B0-C45D-3359-93E7-2CCCDD274AD4}"/>
                </a:ext>
              </a:extLst>
            </p:cNvPr>
            <p:cNvSpPr txBox="1"/>
            <p:nvPr/>
          </p:nvSpPr>
          <p:spPr>
            <a:xfrm>
              <a:off x="5485763" y="4291701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DE7EA903-648B-79E8-3B00-506C8D65471C}"/>
                </a:ext>
              </a:extLst>
            </p:cNvPr>
            <p:cNvSpPr txBox="1"/>
            <p:nvPr/>
          </p:nvSpPr>
          <p:spPr>
            <a:xfrm>
              <a:off x="5729891" y="4291701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6327AF38-FB9D-E1D6-A679-CDCAEB7FE8F5}"/>
                </a:ext>
              </a:extLst>
            </p:cNvPr>
            <p:cNvSpPr txBox="1"/>
            <p:nvPr/>
          </p:nvSpPr>
          <p:spPr>
            <a:xfrm>
              <a:off x="5967291" y="4291701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A7AB9651-2EC6-8013-8158-42F1D41AD39F}"/>
                </a:ext>
              </a:extLst>
            </p:cNvPr>
            <p:cNvSpPr txBox="1"/>
            <p:nvPr/>
          </p:nvSpPr>
          <p:spPr>
            <a:xfrm>
              <a:off x="4074523" y="4409587"/>
              <a:ext cx="19400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 since infection (years)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0E1B0C9B-D5DD-F352-70E9-DB79A2F630A6}"/>
                </a:ext>
              </a:extLst>
            </p:cNvPr>
            <p:cNvSpPr txBox="1"/>
            <p:nvPr/>
          </p:nvSpPr>
          <p:spPr>
            <a:xfrm>
              <a:off x="3670418" y="2430823"/>
              <a:ext cx="274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F844A77B-4C11-AFF5-E10C-35682FEA76F8}"/>
                </a:ext>
              </a:extLst>
            </p:cNvPr>
            <p:cNvSpPr txBox="1"/>
            <p:nvPr/>
          </p:nvSpPr>
          <p:spPr>
            <a:xfrm>
              <a:off x="3670418" y="2854397"/>
              <a:ext cx="274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E8F5D522-22D2-5558-7659-7F94332DE823}"/>
                </a:ext>
              </a:extLst>
            </p:cNvPr>
            <p:cNvSpPr txBox="1"/>
            <p:nvPr/>
          </p:nvSpPr>
          <p:spPr>
            <a:xfrm>
              <a:off x="3637588" y="3287464"/>
              <a:ext cx="3161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6AFD2C41-A9A1-A1CC-0B1B-A0B4B8B4A927}"/>
                </a:ext>
              </a:extLst>
            </p:cNvPr>
            <p:cNvSpPr txBox="1"/>
            <p:nvPr/>
          </p:nvSpPr>
          <p:spPr>
            <a:xfrm>
              <a:off x="3640853" y="3715826"/>
              <a:ext cx="3096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A065748A-9278-3CD3-A8D1-08195F700544}"/>
                </a:ext>
              </a:extLst>
            </p:cNvPr>
            <p:cNvSpPr txBox="1"/>
            <p:nvPr/>
          </p:nvSpPr>
          <p:spPr>
            <a:xfrm>
              <a:off x="3637588" y="4147362"/>
              <a:ext cx="3161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6</a:t>
              </a:r>
            </a:p>
          </p:txBody>
        </p:sp>
      </p:grpSp>
      <p:grpSp>
        <p:nvGrpSpPr>
          <p:cNvPr id="214" name="Group 213">
            <a:extLst>
              <a:ext uri="{FF2B5EF4-FFF2-40B4-BE49-F238E27FC236}">
                <a16:creationId xmlns:a16="http://schemas.microsoft.com/office/drawing/2014/main" id="{BC5C090F-6EDC-E20C-4B73-8C5C08B0E881}"/>
              </a:ext>
            </a:extLst>
          </p:cNvPr>
          <p:cNvGrpSpPr/>
          <p:nvPr/>
        </p:nvGrpSpPr>
        <p:grpSpPr>
          <a:xfrm>
            <a:off x="7048678" y="2329173"/>
            <a:ext cx="2682951" cy="2351158"/>
            <a:chOff x="7048678" y="2322030"/>
            <a:chExt cx="2682951" cy="2351158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72E4A571-BA6B-4706-0B1D-A961C8384F4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rcRect l="8184" t="4520" r="37560" b="13358"/>
            <a:stretch>
              <a:fillRect/>
            </a:stretch>
          </p:blipFill>
          <p:spPr>
            <a:xfrm>
              <a:off x="7423228" y="2397598"/>
              <a:ext cx="2169647" cy="1974152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E476B35-9165-6D5B-E150-D7B1F3B4049D}"/>
                </a:ext>
              </a:extLst>
            </p:cNvPr>
            <p:cNvSpPr txBox="1"/>
            <p:nvPr/>
          </p:nvSpPr>
          <p:spPr>
            <a:xfrm>
              <a:off x="7048678" y="2322030"/>
              <a:ext cx="381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2F7BC13A-A529-7294-79F6-D9258AA3BCEB}"/>
                </a:ext>
              </a:extLst>
            </p:cNvPr>
            <p:cNvSpPr txBox="1"/>
            <p:nvPr/>
          </p:nvSpPr>
          <p:spPr>
            <a:xfrm>
              <a:off x="7394513" y="4306476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60117727-E9C7-630D-23A3-053FAFDEE859}"/>
                </a:ext>
              </a:extLst>
            </p:cNvPr>
            <p:cNvSpPr txBox="1"/>
            <p:nvPr/>
          </p:nvSpPr>
          <p:spPr>
            <a:xfrm>
              <a:off x="7615031" y="4306476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7A83ECFB-9815-78F6-7F3D-B1871FB9B120}"/>
                </a:ext>
              </a:extLst>
            </p:cNvPr>
            <p:cNvSpPr txBox="1"/>
            <p:nvPr/>
          </p:nvSpPr>
          <p:spPr>
            <a:xfrm>
              <a:off x="7833145" y="4306476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62894091-9280-9A3B-F81D-53BE94B626EF}"/>
                </a:ext>
              </a:extLst>
            </p:cNvPr>
            <p:cNvSpPr txBox="1"/>
            <p:nvPr/>
          </p:nvSpPr>
          <p:spPr>
            <a:xfrm>
              <a:off x="8058743" y="4306476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0043ADC9-DC5D-4C4B-42E6-DC32724C92A9}"/>
                </a:ext>
              </a:extLst>
            </p:cNvPr>
            <p:cNvSpPr txBox="1"/>
            <p:nvPr/>
          </p:nvSpPr>
          <p:spPr>
            <a:xfrm>
              <a:off x="8277492" y="4306476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342D6870-46CB-8593-97F7-78406027628C}"/>
                </a:ext>
              </a:extLst>
            </p:cNvPr>
            <p:cNvSpPr txBox="1"/>
            <p:nvPr/>
          </p:nvSpPr>
          <p:spPr>
            <a:xfrm>
              <a:off x="8468165" y="4306476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AC20BBA0-4EED-99DE-78E2-E8BFF7FD67E6}"/>
                </a:ext>
              </a:extLst>
            </p:cNvPr>
            <p:cNvSpPr txBox="1"/>
            <p:nvPr/>
          </p:nvSpPr>
          <p:spPr>
            <a:xfrm>
              <a:off x="8686893" y="4306476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056CCB4A-3D26-CEB3-5EFA-2B12F6C18E85}"/>
                </a:ext>
              </a:extLst>
            </p:cNvPr>
            <p:cNvSpPr txBox="1"/>
            <p:nvPr/>
          </p:nvSpPr>
          <p:spPr>
            <a:xfrm>
              <a:off x="8907526" y="4306476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F8A927BE-306A-432C-5D35-8F7DB4E768E3}"/>
                </a:ext>
              </a:extLst>
            </p:cNvPr>
            <p:cNvSpPr txBox="1"/>
            <p:nvPr/>
          </p:nvSpPr>
          <p:spPr>
            <a:xfrm>
              <a:off x="9130064" y="4306476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6ED18100-2B18-FA9A-4FCD-CD1E0D72A52A}"/>
                </a:ext>
              </a:extLst>
            </p:cNvPr>
            <p:cNvSpPr txBox="1"/>
            <p:nvPr/>
          </p:nvSpPr>
          <p:spPr>
            <a:xfrm>
              <a:off x="9351589" y="4306476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55C92635-2439-CCCA-DAC5-1CAB236B1F41}"/>
                </a:ext>
              </a:extLst>
            </p:cNvPr>
            <p:cNvSpPr txBox="1"/>
            <p:nvPr/>
          </p:nvSpPr>
          <p:spPr>
            <a:xfrm>
              <a:off x="7630271" y="4426967"/>
              <a:ext cx="19400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 since infection (years)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CFC80826-8027-D07C-5B78-53D6D4B39281}"/>
                </a:ext>
              </a:extLst>
            </p:cNvPr>
            <p:cNvSpPr txBox="1"/>
            <p:nvPr/>
          </p:nvSpPr>
          <p:spPr>
            <a:xfrm rot="16200000">
              <a:off x="6508558" y="3199345"/>
              <a:ext cx="1382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EV1/FVC (z-score)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B3E0D001-06A8-9ABE-578C-5EADA364F448}"/>
                </a:ext>
              </a:extLst>
            </p:cNvPr>
            <p:cNvSpPr txBox="1"/>
            <p:nvPr/>
          </p:nvSpPr>
          <p:spPr>
            <a:xfrm>
              <a:off x="7198954" y="2370140"/>
              <a:ext cx="307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92C40B7D-72B2-A4FC-9478-EFB97E538530}"/>
                </a:ext>
              </a:extLst>
            </p:cNvPr>
            <p:cNvSpPr txBox="1"/>
            <p:nvPr/>
          </p:nvSpPr>
          <p:spPr>
            <a:xfrm>
              <a:off x="7189788" y="2714576"/>
              <a:ext cx="3161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5EB5DDCE-8076-2260-6382-361CE0DF5BC5}"/>
                </a:ext>
              </a:extLst>
            </p:cNvPr>
            <p:cNvSpPr txBox="1"/>
            <p:nvPr/>
          </p:nvSpPr>
          <p:spPr>
            <a:xfrm>
              <a:off x="7197815" y="3406319"/>
              <a:ext cx="3096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6ED0D496-CAC6-BD18-9450-CB1BA34EE2C9}"/>
                </a:ext>
              </a:extLst>
            </p:cNvPr>
            <p:cNvSpPr txBox="1"/>
            <p:nvPr/>
          </p:nvSpPr>
          <p:spPr>
            <a:xfrm>
              <a:off x="7194550" y="3750656"/>
              <a:ext cx="3161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52006938-3C9C-34FD-D045-1AFCA17DBB48}"/>
                </a:ext>
              </a:extLst>
            </p:cNvPr>
            <p:cNvSpPr txBox="1"/>
            <p:nvPr/>
          </p:nvSpPr>
          <p:spPr>
            <a:xfrm>
              <a:off x="7194550" y="4096058"/>
              <a:ext cx="3161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6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DA861CED-500C-21AB-423D-5D80D8AEA98C}"/>
                </a:ext>
              </a:extLst>
            </p:cNvPr>
            <p:cNvSpPr txBox="1"/>
            <p:nvPr/>
          </p:nvSpPr>
          <p:spPr>
            <a:xfrm>
              <a:off x="7197815" y="3061517"/>
              <a:ext cx="3096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3</a:t>
              </a:r>
            </a:p>
          </p:txBody>
        </p:sp>
      </p:grpSp>
      <p:sp>
        <p:nvSpPr>
          <p:cNvPr id="171" name="TextBox 170">
            <a:extLst>
              <a:ext uri="{FF2B5EF4-FFF2-40B4-BE49-F238E27FC236}">
                <a16:creationId xmlns:a16="http://schemas.microsoft.com/office/drawing/2014/main" id="{A8EF0E21-B4DC-F957-F9CA-4E40F8552E0A}"/>
              </a:ext>
            </a:extLst>
          </p:cNvPr>
          <p:cNvSpPr txBox="1"/>
          <p:nvPr/>
        </p:nvSpPr>
        <p:spPr>
          <a:xfrm rot="16200000">
            <a:off x="3183491" y="5386025"/>
            <a:ext cx="10198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VC (z-score)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BFE41159-12C9-2C90-F87F-C69658A35501}"/>
              </a:ext>
            </a:extLst>
          </p:cNvPr>
          <p:cNvSpPr txBox="1"/>
          <p:nvPr/>
        </p:nvSpPr>
        <p:spPr>
          <a:xfrm>
            <a:off x="3873613" y="6465707"/>
            <a:ext cx="218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EF08A900-B2E5-2D38-96A1-2CC6CD13EF1A}"/>
              </a:ext>
            </a:extLst>
          </p:cNvPr>
          <p:cNvSpPr txBox="1"/>
          <p:nvPr/>
        </p:nvSpPr>
        <p:spPr>
          <a:xfrm>
            <a:off x="4129691" y="6465707"/>
            <a:ext cx="218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A2540944-45EC-25A4-440E-D445B3232E69}"/>
              </a:ext>
            </a:extLst>
          </p:cNvPr>
          <p:cNvSpPr txBox="1"/>
          <p:nvPr/>
        </p:nvSpPr>
        <p:spPr>
          <a:xfrm>
            <a:off x="4392255" y="6465707"/>
            <a:ext cx="218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259081D1-C380-BBCE-CCEC-BE029A8C9565}"/>
              </a:ext>
            </a:extLst>
          </p:cNvPr>
          <p:cNvSpPr txBox="1"/>
          <p:nvPr/>
        </p:nvSpPr>
        <p:spPr>
          <a:xfrm>
            <a:off x="4650873" y="6465707"/>
            <a:ext cx="218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43848292-BFB4-3FEA-32FF-426862779DC2}"/>
              </a:ext>
            </a:extLst>
          </p:cNvPr>
          <p:cNvSpPr txBox="1"/>
          <p:nvPr/>
        </p:nvSpPr>
        <p:spPr>
          <a:xfrm>
            <a:off x="4910897" y="6465707"/>
            <a:ext cx="218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DBB6C452-32E6-F915-1C60-D3545B09012C}"/>
              </a:ext>
            </a:extLst>
          </p:cNvPr>
          <p:cNvSpPr txBox="1"/>
          <p:nvPr/>
        </p:nvSpPr>
        <p:spPr>
          <a:xfrm>
            <a:off x="5141575" y="6465707"/>
            <a:ext cx="38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436D8BC0-1D69-1944-FF0A-F4BE5D991C66}"/>
              </a:ext>
            </a:extLst>
          </p:cNvPr>
          <p:cNvSpPr txBox="1"/>
          <p:nvPr/>
        </p:nvSpPr>
        <p:spPr>
          <a:xfrm>
            <a:off x="5398403" y="6465707"/>
            <a:ext cx="38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991743A7-C256-C303-47A9-BAFF6B8E93F6}"/>
              </a:ext>
            </a:extLst>
          </p:cNvPr>
          <p:cNvSpPr txBox="1"/>
          <p:nvPr/>
        </p:nvSpPr>
        <p:spPr>
          <a:xfrm>
            <a:off x="5660311" y="6465707"/>
            <a:ext cx="38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C5B31479-7BF6-E090-8417-322D8205371B}"/>
              </a:ext>
            </a:extLst>
          </p:cNvPr>
          <p:cNvSpPr txBox="1"/>
          <p:nvPr/>
        </p:nvSpPr>
        <p:spPr>
          <a:xfrm>
            <a:off x="5919679" y="6465707"/>
            <a:ext cx="38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82577A83-9398-2051-2AF9-A4928FB07C4C}"/>
              </a:ext>
            </a:extLst>
          </p:cNvPr>
          <p:cNvSpPr txBox="1"/>
          <p:nvPr/>
        </p:nvSpPr>
        <p:spPr>
          <a:xfrm>
            <a:off x="6179939" y="6465707"/>
            <a:ext cx="38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BFCF3B3C-8A7F-22A9-937B-C8A9B0022CF4}"/>
              </a:ext>
            </a:extLst>
          </p:cNvPr>
          <p:cNvSpPr txBox="1"/>
          <p:nvPr/>
        </p:nvSpPr>
        <p:spPr>
          <a:xfrm>
            <a:off x="4129691" y="6582639"/>
            <a:ext cx="19400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ime since infection (years)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4837F4E5-57EE-C5A2-1987-B1A8C3291E19}"/>
              </a:ext>
            </a:extLst>
          </p:cNvPr>
          <p:cNvSpPr txBox="1"/>
          <p:nvPr/>
        </p:nvSpPr>
        <p:spPr>
          <a:xfrm>
            <a:off x="3719567" y="5015036"/>
            <a:ext cx="2743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C927A442-798D-EB3B-2DEB-3BCB2A198A5F}"/>
              </a:ext>
            </a:extLst>
          </p:cNvPr>
          <p:cNvSpPr txBox="1"/>
          <p:nvPr/>
        </p:nvSpPr>
        <p:spPr>
          <a:xfrm>
            <a:off x="3723523" y="5427183"/>
            <a:ext cx="2743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2BEF6518-2316-C641-86AD-BB42FC2A1E90}"/>
              </a:ext>
            </a:extLst>
          </p:cNvPr>
          <p:cNvSpPr txBox="1"/>
          <p:nvPr/>
        </p:nvSpPr>
        <p:spPr>
          <a:xfrm>
            <a:off x="3682596" y="5834850"/>
            <a:ext cx="3161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EA725EC4-4087-36F3-9DCC-B05AB186B546}"/>
              </a:ext>
            </a:extLst>
          </p:cNvPr>
          <p:cNvSpPr txBox="1"/>
          <p:nvPr/>
        </p:nvSpPr>
        <p:spPr>
          <a:xfrm>
            <a:off x="3693481" y="6242892"/>
            <a:ext cx="3096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DDD803DC-9145-CBC9-8473-967BABC5DC3B}"/>
              </a:ext>
            </a:extLst>
          </p:cNvPr>
          <p:cNvSpPr txBox="1"/>
          <p:nvPr/>
        </p:nvSpPr>
        <p:spPr>
          <a:xfrm>
            <a:off x="3683475" y="4606375"/>
            <a:ext cx="3161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66D85BB2-CB79-9D61-C208-C01BF2241959}"/>
              </a:ext>
            </a:extLst>
          </p:cNvPr>
          <p:cNvSpPr txBox="1"/>
          <p:nvPr/>
        </p:nvSpPr>
        <p:spPr>
          <a:xfrm>
            <a:off x="7413899" y="6450846"/>
            <a:ext cx="218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AE260CCE-9263-B9AA-4A06-8C08ADE2EDEE}"/>
              </a:ext>
            </a:extLst>
          </p:cNvPr>
          <p:cNvSpPr txBox="1"/>
          <p:nvPr/>
        </p:nvSpPr>
        <p:spPr>
          <a:xfrm>
            <a:off x="7644577" y="6450846"/>
            <a:ext cx="218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C15FE1AA-E094-BF22-A59D-717CF6D96DEB}"/>
              </a:ext>
            </a:extLst>
          </p:cNvPr>
          <p:cNvSpPr txBox="1"/>
          <p:nvPr/>
        </p:nvSpPr>
        <p:spPr>
          <a:xfrm>
            <a:off x="7880471" y="6450846"/>
            <a:ext cx="218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D0ECD194-4E41-2C1A-D2F4-576CCB6AB717}"/>
              </a:ext>
            </a:extLst>
          </p:cNvPr>
          <p:cNvSpPr txBox="1"/>
          <p:nvPr/>
        </p:nvSpPr>
        <p:spPr>
          <a:xfrm>
            <a:off x="8118769" y="6450846"/>
            <a:ext cx="218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28B91232-B582-69EE-2B4E-CE0531FC74F4}"/>
              </a:ext>
            </a:extLst>
          </p:cNvPr>
          <p:cNvSpPr txBox="1"/>
          <p:nvPr/>
        </p:nvSpPr>
        <p:spPr>
          <a:xfrm>
            <a:off x="8352758" y="6450846"/>
            <a:ext cx="2180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9DD3A014-79DE-1F35-42B9-0D8943FC794A}"/>
              </a:ext>
            </a:extLst>
          </p:cNvPr>
          <p:cNvSpPr txBox="1"/>
          <p:nvPr/>
        </p:nvSpPr>
        <p:spPr>
          <a:xfrm>
            <a:off x="8558671" y="6450846"/>
            <a:ext cx="38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A5E49622-4075-5ACE-C330-D30A432E6785}"/>
              </a:ext>
            </a:extLst>
          </p:cNvPr>
          <p:cNvSpPr txBox="1"/>
          <p:nvPr/>
        </p:nvSpPr>
        <p:spPr>
          <a:xfrm>
            <a:off x="8790099" y="6450846"/>
            <a:ext cx="38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CA4156F6-7336-8213-15F7-26C362F42A0B}"/>
              </a:ext>
            </a:extLst>
          </p:cNvPr>
          <p:cNvSpPr txBox="1"/>
          <p:nvPr/>
        </p:nvSpPr>
        <p:spPr>
          <a:xfrm>
            <a:off x="9028512" y="6450846"/>
            <a:ext cx="38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D82F52EE-48BA-FD71-054B-6CC080BC7898}"/>
              </a:ext>
            </a:extLst>
          </p:cNvPr>
          <p:cNvSpPr txBox="1"/>
          <p:nvPr/>
        </p:nvSpPr>
        <p:spPr>
          <a:xfrm>
            <a:off x="9261210" y="6450846"/>
            <a:ext cx="38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5BB31700-12ED-5C6E-041E-E609D4ACF6C9}"/>
              </a:ext>
            </a:extLst>
          </p:cNvPr>
          <p:cNvSpPr txBox="1"/>
          <p:nvPr/>
        </p:nvSpPr>
        <p:spPr>
          <a:xfrm>
            <a:off x="9495435" y="6450846"/>
            <a:ext cx="38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3443934B-12B5-031F-631D-C32BABA3FB34}"/>
              </a:ext>
            </a:extLst>
          </p:cNvPr>
          <p:cNvSpPr txBox="1"/>
          <p:nvPr/>
        </p:nvSpPr>
        <p:spPr>
          <a:xfrm>
            <a:off x="7649657" y="6567529"/>
            <a:ext cx="19400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ime since infection (years)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CCFA4E5D-4D23-35DA-57CC-89831CECFDD0}"/>
              </a:ext>
            </a:extLst>
          </p:cNvPr>
          <p:cNvSpPr txBox="1"/>
          <p:nvPr/>
        </p:nvSpPr>
        <p:spPr>
          <a:xfrm rot="16200000">
            <a:off x="6550964" y="5415717"/>
            <a:ext cx="13724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EV1/FVC (z-score)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65D4FF0A-85B9-E241-32C7-EB060FB28500}"/>
              </a:ext>
            </a:extLst>
          </p:cNvPr>
          <p:cNvSpPr txBox="1"/>
          <p:nvPr/>
        </p:nvSpPr>
        <p:spPr>
          <a:xfrm>
            <a:off x="7231040" y="4590710"/>
            <a:ext cx="3073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B43F5D88-A89F-BF08-396E-7B2C16F075C6}"/>
              </a:ext>
            </a:extLst>
          </p:cNvPr>
          <p:cNvSpPr txBox="1"/>
          <p:nvPr/>
        </p:nvSpPr>
        <p:spPr>
          <a:xfrm>
            <a:off x="7226636" y="5013886"/>
            <a:ext cx="3161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5F3FC992-ED84-684F-6295-AFC0E265759C}"/>
              </a:ext>
            </a:extLst>
          </p:cNvPr>
          <p:cNvSpPr txBox="1"/>
          <p:nvPr/>
        </p:nvSpPr>
        <p:spPr>
          <a:xfrm>
            <a:off x="7229901" y="5878349"/>
            <a:ext cx="3096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1105D851-626E-38B4-77D9-3E7071EB556A}"/>
              </a:ext>
            </a:extLst>
          </p:cNvPr>
          <p:cNvSpPr txBox="1"/>
          <p:nvPr/>
        </p:nvSpPr>
        <p:spPr>
          <a:xfrm>
            <a:off x="7226636" y="6309008"/>
            <a:ext cx="3161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8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930339D9-DA8E-8571-BAAD-17C04B9371E9}"/>
              </a:ext>
            </a:extLst>
          </p:cNvPr>
          <p:cNvSpPr txBox="1"/>
          <p:nvPr/>
        </p:nvSpPr>
        <p:spPr>
          <a:xfrm>
            <a:off x="7229901" y="5442107"/>
            <a:ext cx="3096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</a:p>
        </p:txBody>
      </p:sp>
      <p:grpSp>
        <p:nvGrpSpPr>
          <p:cNvPr id="212" name="Group 211">
            <a:extLst>
              <a:ext uri="{FF2B5EF4-FFF2-40B4-BE49-F238E27FC236}">
                <a16:creationId xmlns:a16="http://schemas.microsoft.com/office/drawing/2014/main" id="{704E02CD-ED94-0DC6-863B-6524D891AFE0}"/>
              </a:ext>
            </a:extLst>
          </p:cNvPr>
          <p:cNvGrpSpPr/>
          <p:nvPr/>
        </p:nvGrpSpPr>
        <p:grpSpPr>
          <a:xfrm>
            <a:off x="8755" y="4578856"/>
            <a:ext cx="3068488" cy="2242498"/>
            <a:chOff x="8755" y="4578856"/>
            <a:chExt cx="3068488" cy="2242498"/>
          </a:xfrm>
        </p:grpSpPr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657E7163-64D0-3E71-90EC-9B4912BFE18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rcRect l="8179" t="3653" r="25063" b="12640"/>
            <a:stretch>
              <a:fillRect/>
            </a:stretch>
          </p:blipFill>
          <p:spPr>
            <a:xfrm>
              <a:off x="457200" y="4656100"/>
              <a:ext cx="2489818" cy="1876779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6D6256D-1DD0-95E7-6BC5-E3FB83CC0136}"/>
                </a:ext>
              </a:extLst>
            </p:cNvPr>
            <p:cNvSpPr txBox="1"/>
            <p:nvPr/>
          </p:nvSpPr>
          <p:spPr>
            <a:xfrm>
              <a:off x="8755" y="4578856"/>
              <a:ext cx="381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BF11CD73-F9C5-8404-6158-1E1B2DB0B2AC}"/>
                </a:ext>
              </a:extLst>
            </p:cNvPr>
            <p:cNvSpPr txBox="1"/>
            <p:nvPr/>
          </p:nvSpPr>
          <p:spPr>
            <a:xfrm>
              <a:off x="421357" y="6457657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3A94F232-91EB-F48B-A2B6-3CC905C0BB3D}"/>
                </a:ext>
              </a:extLst>
            </p:cNvPr>
            <p:cNvSpPr txBox="1"/>
            <p:nvPr/>
          </p:nvSpPr>
          <p:spPr>
            <a:xfrm>
              <a:off x="674895" y="6457657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1B1DFF10-2267-DE6C-AB3E-8F47D44FCACE}"/>
                </a:ext>
              </a:extLst>
            </p:cNvPr>
            <p:cNvSpPr txBox="1"/>
            <p:nvPr/>
          </p:nvSpPr>
          <p:spPr>
            <a:xfrm>
              <a:off x="932379" y="6457657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77808B72-D8C4-556D-284B-6197DA744AE4}"/>
                </a:ext>
              </a:extLst>
            </p:cNvPr>
            <p:cNvSpPr txBox="1"/>
            <p:nvPr/>
          </p:nvSpPr>
          <p:spPr>
            <a:xfrm>
              <a:off x="1190997" y="6457657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FBA9AE28-66BE-5863-2191-4E237F31A7D2}"/>
                </a:ext>
              </a:extLst>
            </p:cNvPr>
            <p:cNvSpPr txBox="1"/>
            <p:nvPr/>
          </p:nvSpPr>
          <p:spPr>
            <a:xfrm>
              <a:off x="1445941" y="6457657"/>
              <a:ext cx="2180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0C32DDE4-781C-3EE3-5F87-08E7C4B13909}"/>
                </a:ext>
              </a:extLst>
            </p:cNvPr>
            <p:cNvSpPr txBox="1"/>
            <p:nvPr/>
          </p:nvSpPr>
          <p:spPr>
            <a:xfrm>
              <a:off x="1671539" y="6457657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649501D7-74ED-FCC0-2E89-96828C208726}"/>
                </a:ext>
              </a:extLst>
            </p:cNvPr>
            <p:cNvSpPr txBox="1"/>
            <p:nvPr/>
          </p:nvSpPr>
          <p:spPr>
            <a:xfrm>
              <a:off x="1930907" y="6457657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1E657FFE-872C-E97B-4B45-B7EE04DDAA87}"/>
                </a:ext>
              </a:extLst>
            </p:cNvPr>
            <p:cNvSpPr txBox="1"/>
            <p:nvPr/>
          </p:nvSpPr>
          <p:spPr>
            <a:xfrm>
              <a:off x="2182655" y="6457657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172FE532-4AC7-9F97-F1E6-B289DE1E39D4}"/>
                </a:ext>
              </a:extLst>
            </p:cNvPr>
            <p:cNvSpPr txBox="1"/>
            <p:nvPr/>
          </p:nvSpPr>
          <p:spPr>
            <a:xfrm>
              <a:off x="2442023" y="6457657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2FD60880-0AA0-D877-DAA2-8800F25B6A67}"/>
                </a:ext>
              </a:extLst>
            </p:cNvPr>
            <p:cNvSpPr txBox="1"/>
            <p:nvPr/>
          </p:nvSpPr>
          <p:spPr>
            <a:xfrm>
              <a:off x="2697203" y="6457657"/>
              <a:ext cx="38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696C5491-09B3-D179-7BF2-358BA5FD454B}"/>
                </a:ext>
              </a:extLst>
            </p:cNvPr>
            <p:cNvSpPr txBox="1"/>
            <p:nvPr/>
          </p:nvSpPr>
          <p:spPr>
            <a:xfrm>
              <a:off x="669815" y="6575133"/>
              <a:ext cx="19400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 since infection (years)</a:t>
              </a: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876060DA-45E8-2A9F-83C7-C69E793C3058}"/>
                </a:ext>
              </a:extLst>
            </p:cNvPr>
            <p:cNvSpPr txBox="1"/>
            <p:nvPr/>
          </p:nvSpPr>
          <p:spPr>
            <a:xfrm rot="16200000">
              <a:off x="-300439" y="5455945"/>
              <a:ext cx="10850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EV1 (z-score)</a:t>
              </a: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B27518C8-672A-3218-9BAA-F68B8C89AC90}"/>
                </a:ext>
              </a:extLst>
            </p:cNvPr>
            <p:cNvSpPr txBox="1"/>
            <p:nvPr/>
          </p:nvSpPr>
          <p:spPr>
            <a:xfrm>
              <a:off x="252258" y="4656057"/>
              <a:ext cx="2985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DF9E8076-BBCB-9433-5138-A936C48342AA}"/>
                </a:ext>
              </a:extLst>
            </p:cNvPr>
            <p:cNvSpPr txBox="1"/>
            <p:nvPr/>
          </p:nvSpPr>
          <p:spPr>
            <a:xfrm>
              <a:off x="252258" y="5069922"/>
              <a:ext cx="2985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3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BA524481-26E3-391E-71FC-ACF7524B7CEF}"/>
                </a:ext>
              </a:extLst>
            </p:cNvPr>
            <p:cNvSpPr txBox="1"/>
            <p:nvPr/>
          </p:nvSpPr>
          <p:spPr>
            <a:xfrm>
              <a:off x="253802" y="5483992"/>
              <a:ext cx="2985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CB6C45FC-CB68-6614-5E67-6F79473A7F12}"/>
                </a:ext>
              </a:extLst>
            </p:cNvPr>
            <p:cNvSpPr txBox="1"/>
            <p:nvPr/>
          </p:nvSpPr>
          <p:spPr>
            <a:xfrm>
              <a:off x="252258" y="5896617"/>
              <a:ext cx="2985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F0392901-89BE-8E1B-5C05-647B3E8EDFAF}"/>
                </a:ext>
              </a:extLst>
            </p:cNvPr>
            <p:cNvSpPr txBox="1"/>
            <p:nvPr/>
          </p:nvSpPr>
          <p:spPr>
            <a:xfrm>
              <a:off x="248722" y="6312242"/>
              <a:ext cx="2985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6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349456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E63D78E-0903-8928-A7E4-8BF4E0D20B0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Content Placeholder 8">
            <a:extLst>
              <a:ext uri="{FF2B5EF4-FFF2-40B4-BE49-F238E27FC236}">
                <a16:creationId xmlns:a16="http://schemas.microsoft.com/office/drawing/2014/main" id="{938D2CDF-6E4A-7664-3163-7FFC6100135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7349" t="43200" r="25903" b="49315"/>
          <a:stretch>
            <a:fillRect/>
          </a:stretch>
        </p:blipFill>
        <p:spPr>
          <a:xfrm>
            <a:off x="8775152" y="5692832"/>
            <a:ext cx="700337" cy="466236"/>
          </a:xfrm>
          <a:prstGeom prst="rect">
            <a:avLst/>
          </a:prstGeom>
        </p:spPr>
      </p:pic>
      <p:pic>
        <p:nvPicPr>
          <p:cNvPr id="6" name="Content Placeholder 8">
            <a:extLst>
              <a:ext uri="{FF2B5EF4-FFF2-40B4-BE49-F238E27FC236}">
                <a16:creationId xmlns:a16="http://schemas.microsoft.com/office/drawing/2014/main" id="{2B3E3073-B7CC-783B-3843-05B11C90D67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7349" t="37859" r="25903" b="53985"/>
          <a:stretch>
            <a:fillRect/>
          </a:stretch>
        </p:blipFill>
        <p:spPr>
          <a:xfrm>
            <a:off x="8769728" y="5250395"/>
            <a:ext cx="700337" cy="50805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01DE327-6B5A-8B25-F399-FEDD1B587E5D}"/>
              </a:ext>
            </a:extLst>
          </p:cNvPr>
          <p:cNvSpPr txBox="1"/>
          <p:nvPr/>
        </p:nvSpPr>
        <p:spPr>
          <a:xfrm>
            <a:off x="9484602" y="5325593"/>
            <a:ext cx="137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denoviru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E05A4FB-44E2-F65E-89FD-9229BDB6437A}"/>
              </a:ext>
            </a:extLst>
          </p:cNvPr>
          <p:cNvSpPr txBox="1"/>
          <p:nvPr/>
        </p:nvSpPr>
        <p:spPr>
          <a:xfrm>
            <a:off x="9465737" y="5715178"/>
            <a:ext cx="2214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ther pathogen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1710248-5659-D1E0-9D2A-85591705F9A6}"/>
              </a:ext>
            </a:extLst>
          </p:cNvPr>
          <p:cNvSpPr txBox="1"/>
          <p:nvPr/>
        </p:nvSpPr>
        <p:spPr>
          <a:xfrm>
            <a:off x="144276" y="894479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655B915-2FC3-243F-BADE-0D09C487ED1E}"/>
              </a:ext>
            </a:extLst>
          </p:cNvPr>
          <p:cNvSpPr txBox="1"/>
          <p:nvPr/>
        </p:nvSpPr>
        <p:spPr>
          <a:xfrm>
            <a:off x="7104380" y="908313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D87B06B-2949-4946-2FE1-1D21E4899834}"/>
              </a:ext>
            </a:extLst>
          </p:cNvPr>
          <p:cNvSpPr/>
          <p:nvPr/>
        </p:nvSpPr>
        <p:spPr>
          <a:xfrm>
            <a:off x="8854625" y="5369983"/>
            <a:ext cx="533400" cy="280553"/>
          </a:xfrm>
          <a:prstGeom prst="rect">
            <a:avLst/>
          </a:prstGeom>
          <a:solidFill>
            <a:srgbClr val="DAD6A2">
              <a:alpha val="48000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43E2F4A-C68C-0EFE-307F-F863BECAAD9A}"/>
              </a:ext>
            </a:extLst>
          </p:cNvPr>
          <p:cNvSpPr/>
          <p:nvPr/>
        </p:nvSpPr>
        <p:spPr>
          <a:xfrm>
            <a:off x="8850298" y="5775624"/>
            <a:ext cx="533400" cy="280553"/>
          </a:xfrm>
          <a:prstGeom prst="rect">
            <a:avLst/>
          </a:prstGeom>
          <a:solidFill>
            <a:srgbClr val="D7E8F1">
              <a:alpha val="47843"/>
            </a:srgb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B2A91AC-F2BD-96E8-6348-51DA08454A85}"/>
              </a:ext>
            </a:extLst>
          </p:cNvPr>
          <p:cNvSpPr txBox="1"/>
          <p:nvPr/>
        </p:nvSpPr>
        <p:spPr>
          <a:xfrm>
            <a:off x="-1" y="0"/>
            <a:ext cx="72863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-figure 4</a:t>
            </a: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D2BEF034-4E95-B5AB-7ECA-6BCF2371D0E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58" r="32894" b="12196"/>
          <a:stretch>
            <a:fillRect/>
          </a:stretch>
        </p:blipFill>
        <p:spPr bwMode="auto">
          <a:xfrm>
            <a:off x="7805508" y="908313"/>
            <a:ext cx="4264571" cy="37966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790A17E-BB9D-5596-DAB0-6E63D60250EA}"/>
              </a:ext>
            </a:extLst>
          </p:cNvPr>
          <p:cNvSpPr txBox="1"/>
          <p:nvPr/>
        </p:nvSpPr>
        <p:spPr>
          <a:xfrm>
            <a:off x="7457440" y="4848820"/>
            <a:ext cx="4531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ime since infection (years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E0BE9C9-CC99-3BAC-231F-04A136DE3E18}"/>
              </a:ext>
            </a:extLst>
          </p:cNvPr>
          <p:cNvSpPr txBox="1"/>
          <p:nvPr/>
        </p:nvSpPr>
        <p:spPr>
          <a:xfrm rot="16200000">
            <a:off x="5378401" y="2843076"/>
            <a:ext cx="39015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eight-for-age (z-score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F38C62A-8EF7-FE19-689C-1F1172A1477C}"/>
              </a:ext>
            </a:extLst>
          </p:cNvPr>
          <p:cNvSpPr txBox="1"/>
          <p:nvPr/>
        </p:nvSpPr>
        <p:spPr>
          <a:xfrm>
            <a:off x="7461432" y="3478320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2AA504C-5BA2-9E54-D4F5-949BD80353CA}"/>
              </a:ext>
            </a:extLst>
          </p:cNvPr>
          <p:cNvSpPr txBox="1"/>
          <p:nvPr/>
        </p:nvSpPr>
        <p:spPr>
          <a:xfrm>
            <a:off x="7461433" y="1821071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B6D8103-FBF0-B8DE-A6CE-B83DFCA917D0}"/>
              </a:ext>
            </a:extLst>
          </p:cNvPr>
          <p:cNvSpPr txBox="1"/>
          <p:nvPr/>
        </p:nvSpPr>
        <p:spPr>
          <a:xfrm>
            <a:off x="7461434" y="994038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2A9D620-28AD-EE63-541D-3684F4E7164D}"/>
              </a:ext>
            </a:extLst>
          </p:cNvPr>
          <p:cNvSpPr txBox="1"/>
          <p:nvPr/>
        </p:nvSpPr>
        <p:spPr>
          <a:xfrm>
            <a:off x="7461434" y="2660646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16DD2B0-D671-89F0-6AD3-09942E7D2AE7}"/>
              </a:ext>
            </a:extLst>
          </p:cNvPr>
          <p:cNvSpPr txBox="1"/>
          <p:nvPr/>
        </p:nvSpPr>
        <p:spPr>
          <a:xfrm>
            <a:off x="7461432" y="4304597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F9CF2812-BA26-3ADF-F771-A192A5BDFE53}"/>
              </a:ext>
            </a:extLst>
          </p:cNvPr>
          <p:cNvSpPr txBox="1"/>
          <p:nvPr/>
        </p:nvSpPr>
        <p:spPr>
          <a:xfrm>
            <a:off x="9080121" y="4583699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6DA267A8-8C4C-DC80-B6F8-5C54C30F4F52}"/>
              </a:ext>
            </a:extLst>
          </p:cNvPr>
          <p:cNvSpPr txBox="1"/>
          <p:nvPr/>
        </p:nvSpPr>
        <p:spPr>
          <a:xfrm>
            <a:off x="8645742" y="4582285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DC94C01E-C648-6098-BED3-25469B6CE250}"/>
              </a:ext>
            </a:extLst>
          </p:cNvPr>
          <p:cNvSpPr txBox="1"/>
          <p:nvPr/>
        </p:nvSpPr>
        <p:spPr>
          <a:xfrm>
            <a:off x="8236291" y="4585352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389DAEC0-8740-B6BF-8E2A-9F80CE06C78F}"/>
              </a:ext>
            </a:extLst>
          </p:cNvPr>
          <p:cNvSpPr txBox="1"/>
          <p:nvPr/>
        </p:nvSpPr>
        <p:spPr>
          <a:xfrm>
            <a:off x="7793122" y="4582285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12E5E06D-56FC-A72D-B1BA-8C7FB730F31B}"/>
              </a:ext>
            </a:extLst>
          </p:cNvPr>
          <p:cNvSpPr txBox="1"/>
          <p:nvPr/>
        </p:nvSpPr>
        <p:spPr>
          <a:xfrm>
            <a:off x="9520052" y="4582285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96A63343-698D-EC17-18DA-5F2DDA288C76}"/>
              </a:ext>
            </a:extLst>
          </p:cNvPr>
          <p:cNvSpPr txBox="1"/>
          <p:nvPr/>
        </p:nvSpPr>
        <p:spPr>
          <a:xfrm>
            <a:off x="9913351" y="4583298"/>
            <a:ext cx="4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2BAAB201-BF10-9C1A-DAB2-E3AA89FA34D5}"/>
              </a:ext>
            </a:extLst>
          </p:cNvPr>
          <p:cNvSpPr txBox="1"/>
          <p:nvPr/>
        </p:nvSpPr>
        <p:spPr>
          <a:xfrm>
            <a:off x="10337494" y="4584249"/>
            <a:ext cx="4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2EAE4E16-8231-A1FF-2071-192FC7D0E1CF}"/>
              </a:ext>
            </a:extLst>
          </p:cNvPr>
          <p:cNvSpPr txBox="1"/>
          <p:nvPr/>
        </p:nvSpPr>
        <p:spPr>
          <a:xfrm>
            <a:off x="10777501" y="4585663"/>
            <a:ext cx="4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0837C147-C55E-1A4D-65CA-E7B854A6188A}"/>
              </a:ext>
            </a:extLst>
          </p:cNvPr>
          <p:cNvSpPr txBox="1"/>
          <p:nvPr/>
        </p:nvSpPr>
        <p:spPr>
          <a:xfrm>
            <a:off x="11211804" y="4584249"/>
            <a:ext cx="4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FEBF178F-CD56-B770-48AE-4FC4C73BE40F}"/>
              </a:ext>
            </a:extLst>
          </p:cNvPr>
          <p:cNvSpPr txBox="1"/>
          <p:nvPr/>
        </p:nvSpPr>
        <p:spPr>
          <a:xfrm>
            <a:off x="11635947" y="4584249"/>
            <a:ext cx="4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pic>
        <p:nvPicPr>
          <p:cNvPr id="2052" name="Picture 4">
            <a:extLst>
              <a:ext uri="{FF2B5EF4-FFF2-40B4-BE49-F238E27FC236}">
                <a16:creationId xmlns:a16="http://schemas.microsoft.com/office/drawing/2014/main" id="{D244895D-D94C-60FC-C619-A04B30DEB54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07" r="1783" b="21720"/>
          <a:stretch>
            <a:fillRect/>
          </a:stretch>
        </p:blipFill>
        <p:spPr bwMode="auto">
          <a:xfrm>
            <a:off x="723900" y="1363371"/>
            <a:ext cx="6251133" cy="3273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5" name="TextBox 184">
            <a:extLst>
              <a:ext uri="{FF2B5EF4-FFF2-40B4-BE49-F238E27FC236}">
                <a16:creationId xmlns:a16="http://schemas.microsoft.com/office/drawing/2014/main" id="{E08ADBE8-7A3C-24C1-149A-35E379E28EEC}"/>
              </a:ext>
            </a:extLst>
          </p:cNvPr>
          <p:cNvSpPr txBox="1"/>
          <p:nvPr/>
        </p:nvSpPr>
        <p:spPr>
          <a:xfrm>
            <a:off x="771763" y="4807976"/>
            <a:ext cx="62023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ime since infection (years)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77878BBA-31B5-4A94-4527-60958A769783}"/>
              </a:ext>
            </a:extLst>
          </p:cNvPr>
          <p:cNvSpPr txBox="1"/>
          <p:nvPr/>
        </p:nvSpPr>
        <p:spPr>
          <a:xfrm rot="16200000">
            <a:off x="-1621839" y="2995476"/>
            <a:ext cx="39015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eight-for-age (z-score)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DE94B021-946F-BBB1-87BE-4D16B9F5CD50}"/>
              </a:ext>
            </a:extLst>
          </p:cNvPr>
          <p:cNvSpPr txBox="1"/>
          <p:nvPr/>
        </p:nvSpPr>
        <p:spPr>
          <a:xfrm>
            <a:off x="400232" y="3376720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0697D314-0BB2-3FA8-4AB7-8200C2F777B6}"/>
              </a:ext>
            </a:extLst>
          </p:cNvPr>
          <p:cNvSpPr txBox="1"/>
          <p:nvPr/>
        </p:nvSpPr>
        <p:spPr>
          <a:xfrm>
            <a:off x="400233" y="2054751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9EC58114-761E-4148-0CAC-8D7AC1A7E94E}"/>
              </a:ext>
            </a:extLst>
          </p:cNvPr>
          <p:cNvSpPr txBox="1"/>
          <p:nvPr/>
        </p:nvSpPr>
        <p:spPr>
          <a:xfrm>
            <a:off x="400234" y="1410598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B035DAE1-3487-87DB-6B86-AC83804DBE8A}"/>
              </a:ext>
            </a:extLst>
          </p:cNvPr>
          <p:cNvSpPr txBox="1"/>
          <p:nvPr/>
        </p:nvSpPr>
        <p:spPr>
          <a:xfrm>
            <a:off x="400234" y="2731766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C905CA7B-D513-7505-A48B-FC31468C5648}"/>
              </a:ext>
            </a:extLst>
          </p:cNvPr>
          <p:cNvSpPr txBox="1"/>
          <p:nvPr/>
        </p:nvSpPr>
        <p:spPr>
          <a:xfrm>
            <a:off x="400232" y="4030277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891C4931-EEBD-7E96-D038-CE621D30CA9B}"/>
              </a:ext>
            </a:extLst>
          </p:cNvPr>
          <p:cNvSpPr txBox="1"/>
          <p:nvPr/>
        </p:nvSpPr>
        <p:spPr>
          <a:xfrm>
            <a:off x="2679321" y="4563379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C7742AA2-DE88-A969-83B9-94F81CB2317F}"/>
              </a:ext>
            </a:extLst>
          </p:cNvPr>
          <p:cNvSpPr txBox="1"/>
          <p:nvPr/>
        </p:nvSpPr>
        <p:spPr>
          <a:xfrm>
            <a:off x="2021422" y="4561965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62" name="TextBox 261">
            <a:extLst>
              <a:ext uri="{FF2B5EF4-FFF2-40B4-BE49-F238E27FC236}">
                <a16:creationId xmlns:a16="http://schemas.microsoft.com/office/drawing/2014/main" id="{D41DA35F-BC0A-E1F7-B8CC-BACAF9D58A13}"/>
              </a:ext>
            </a:extLst>
          </p:cNvPr>
          <p:cNvSpPr txBox="1"/>
          <p:nvPr/>
        </p:nvSpPr>
        <p:spPr>
          <a:xfrm>
            <a:off x="1337651" y="4565032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CB8CCFBC-B234-1908-119C-945143BB818B}"/>
              </a:ext>
            </a:extLst>
          </p:cNvPr>
          <p:cNvSpPr txBox="1"/>
          <p:nvPr/>
        </p:nvSpPr>
        <p:spPr>
          <a:xfrm>
            <a:off x="681122" y="4561965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64" name="TextBox 263">
            <a:extLst>
              <a:ext uri="{FF2B5EF4-FFF2-40B4-BE49-F238E27FC236}">
                <a16:creationId xmlns:a16="http://schemas.microsoft.com/office/drawing/2014/main" id="{1315E5B2-2780-53CB-F030-3D4B36A5BFD2}"/>
              </a:ext>
            </a:extLst>
          </p:cNvPr>
          <p:cNvSpPr txBox="1"/>
          <p:nvPr/>
        </p:nvSpPr>
        <p:spPr>
          <a:xfrm>
            <a:off x="3332612" y="4561965"/>
            <a:ext cx="419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265" name="TextBox 264">
            <a:extLst>
              <a:ext uri="{FF2B5EF4-FFF2-40B4-BE49-F238E27FC236}">
                <a16:creationId xmlns:a16="http://schemas.microsoft.com/office/drawing/2014/main" id="{252F1DB1-69E6-2484-B0ED-F2A85D9F73D7}"/>
              </a:ext>
            </a:extLst>
          </p:cNvPr>
          <p:cNvSpPr txBox="1"/>
          <p:nvPr/>
        </p:nvSpPr>
        <p:spPr>
          <a:xfrm>
            <a:off x="3959591" y="4562978"/>
            <a:ext cx="4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66" name="TextBox 265">
            <a:extLst>
              <a:ext uri="{FF2B5EF4-FFF2-40B4-BE49-F238E27FC236}">
                <a16:creationId xmlns:a16="http://schemas.microsoft.com/office/drawing/2014/main" id="{5902F331-1131-DCB1-441A-33F6DA825829}"/>
              </a:ext>
            </a:extLst>
          </p:cNvPr>
          <p:cNvSpPr txBox="1"/>
          <p:nvPr/>
        </p:nvSpPr>
        <p:spPr>
          <a:xfrm>
            <a:off x="4627574" y="4563929"/>
            <a:ext cx="4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FC54893F-47A5-B7F8-9209-F3024F908B40}"/>
              </a:ext>
            </a:extLst>
          </p:cNvPr>
          <p:cNvSpPr txBox="1"/>
          <p:nvPr/>
        </p:nvSpPr>
        <p:spPr>
          <a:xfrm>
            <a:off x="5291101" y="4565343"/>
            <a:ext cx="4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id="{3F2A03C6-13BB-775A-6052-4236601E1196}"/>
              </a:ext>
            </a:extLst>
          </p:cNvPr>
          <p:cNvSpPr txBox="1"/>
          <p:nvPr/>
        </p:nvSpPr>
        <p:spPr>
          <a:xfrm>
            <a:off x="5969244" y="4563929"/>
            <a:ext cx="4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A4503728-B2E4-D218-4E2B-D3385C245B32}"/>
              </a:ext>
            </a:extLst>
          </p:cNvPr>
          <p:cNvSpPr txBox="1"/>
          <p:nvPr/>
        </p:nvSpPr>
        <p:spPr>
          <a:xfrm>
            <a:off x="6616907" y="4563929"/>
            <a:ext cx="485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</p:spTree>
    <p:extLst>
      <p:ext uri="{BB962C8B-B14F-4D97-AF65-F5344CB8AC3E}">
        <p14:creationId xmlns:p14="http://schemas.microsoft.com/office/powerpoint/2010/main" val="3623320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551</Words>
  <Application>Microsoft Office PowerPoint</Application>
  <PresentationFormat>Widescreen</PresentationFormat>
  <Paragraphs>332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VU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legg, James M</dc:creator>
  <cp:lastModifiedBy>Clegg, James M</cp:lastModifiedBy>
  <cp:revision>1</cp:revision>
  <dcterms:created xsi:type="dcterms:W3CDTF">2026-06-04T03:24:46Z</dcterms:created>
  <dcterms:modified xsi:type="dcterms:W3CDTF">2026-06-05T20:14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792c8cef-6f2b-4af1-b4ac-d815ff795cd6_Enabled">
    <vt:lpwstr>true</vt:lpwstr>
  </property>
  <property fmtid="{D5CDD505-2E9C-101B-9397-08002B2CF9AE}" pid="3" name="MSIP_Label_792c8cef-6f2b-4af1-b4ac-d815ff795cd6_SetDate">
    <vt:lpwstr>2026-06-04T03:24:53Z</vt:lpwstr>
  </property>
  <property fmtid="{D5CDD505-2E9C-101B-9397-08002B2CF9AE}" pid="4" name="MSIP_Label_792c8cef-6f2b-4af1-b4ac-d815ff795cd6_Method">
    <vt:lpwstr>Standard</vt:lpwstr>
  </property>
  <property fmtid="{D5CDD505-2E9C-101B-9397-08002B2CF9AE}" pid="5" name="MSIP_Label_792c8cef-6f2b-4af1-b4ac-d815ff795cd6_Name">
    <vt:lpwstr>VUMC General</vt:lpwstr>
  </property>
  <property fmtid="{D5CDD505-2E9C-101B-9397-08002B2CF9AE}" pid="6" name="MSIP_Label_792c8cef-6f2b-4af1-b4ac-d815ff795cd6_SiteId">
    <vt:lpwstr>ef575030-1424-4ed8-b83c-12c533d879ab</vt:lpwstr>
  </property>
  <property fmtid="{D5CDD505-2E9C-101B-9397-08002B2CF9AE}" pid="7" name="MSIP_Label_792c8cef-6f2b-4af1-b4ac-d815ff795cd6_ActionId">
    <vt:lpwstr>42133649-c80c-4ec9-b302-9f303a987ed2</vt:lpwstr>
  </property>
  <property fmtid="{D5CDD505-2E9C-101B-9397-08002B2CF9AE}" pid="8" name="MSIP_Label_792c8cef-6f2b-4af1-b4ac-d815ff795cd6_ContentBits">
    <vt:lpwstr>0</vt:lpwstr>
  </property>
  <property fmtid="{D5CDD505-2E9C-101B-9397-08002B2CF9AE}" pid="9" name="MSIP_Label_792c8cef-6f2b-4af1-b4ac-d815ff795cd6_Tag">
    <vt:lpwstr>10, 3, 0, 1</vt:lpwstr>
  </property>
</Properties>
</file>